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3"/>
  </p:notesMasterIdLst>
  <p:sldIdLst>
    <p:sldId id="365" r:id="rId2"/>
    <p:sldId id="366" r:id="rId3"/>
    <p:sldId id="367" r:id="rId4"/>
    <p:sldId id="368" r:id="rId5"/>
    <p:sldId id="369" r:id="rId6"/>
    <p:sldId id="370" r:id="rId7"/>
    <p:sldId id="371" r:id="rId8"/>
    <p:sldId id="372" r:id="rId9"/>
    <p:sldId id="373" r:id="rId10"/>
    <p:sldId id="374" r:id="rId11"/>
    <p:sldId id="375" r:id="rId12"/>
    <p:sldId id="376" r:id="rId13"/>
    <p:sldId id="377" r:id="rId14"/>
    <p:sldId id="412" r:id="rId15"/>
    <p:sldId id="379" r:id="rId16"/>
    <p:sldId id="380" r:id="rId17"/>
    <p:sldId id="381" r:id="rId18"/>
    <p:sldId id="382" r:id="rId19"/>
    <p:sldId id="383" r:id="rId20"/>
    <p:sldId id="384" r:id="rId21"/>
    <p:sldId id="385" r:id="rId22"/>
    <p:sldId id="386" r:id="rId23"/>
    <p:sldId id="387" r:id="rId24"/>
    <p:sldId id="388" r:id="rId25"/>
    <p:sldId id="389" r:id="rId26"/>
    <p:sldId id="390" r:id="rId27"/>
    <p:sldId id="391" r:id="rId28"/>
    <p:sldId id="431" r:id="rId29"/>
    <p:sldId id="392" r:id="rId30"/>
    <p:sldId id="393" r:id="rId31"/>
    <p:sldId id="394" r:id="rId32"/>
    <p:sldId id="395" r:id="rId33"/>
    <p:sldId id="396" r:id="rId34"/>
    <p:sldId id="397" r:id="rId35"/>
    <p:sldId id="428" r:id="rId36"/>
    <p:sldId id="429" r:id="rId37"/>
    <p:sldId id="430" r:id="rId38"/>
    <p:sldId id="400" r:id="rId39"/>
    <p:sldId id="401" r:id="rId40"/>
    <p:sldId id="402" r:id="rId41"/>
    <p:sldId id="419" r:id="rId42"/>
    <p:sldId id="270" r:id="rId43"/>
    <p:sldId id="271" r:id="rId44"/>
    <p:sldId id="272" r:id="rId45"/>
    <p:sldId id="407" r:id="rId46"/>
    <p:sldId id="408" r:id="rId47"/>
    <p:sldId id="409" r:id="rId48"/>
    <p:sldId id="410" r:id="rId49"/>
    <p:sldId id="411" r:id="rId50"/>
    <p:sldId id="404" r:id="rId51"/>
    <p:sldId id="403" r:id="rId52"/>
    <p:sldId id="281" r:id="rId53"/>
    <p:sldId id="405" r:id="rId54"/>
    <p:sldId id="406" r:id="rId55"/>
    <p:sldId id="427" r:id="rId56"/>
    <p:sldId id="413" r:id="rId57"/>
    <p:sldId id="415" r:id="rId58"/>
    <p:sldId id="416" r:id="rId59"/>
    <p:sldId id="414" r:id="rId60"/>
    <p:sldId id="282" r:id="rId61"/>
    <p:sldId id="426" r:id="rId62"/>
    <p:sldId id="425" r:id="rId63"/>
    <p:sldId id="321" r:id="rId64"/>
    <p:sldId id="322" r:id="rId65"/>
    <p:sldId id="320" r:id="rId66"/>
    <p:sldId id="422" r:id="rId67"/>
    <p:sldId id="423" r:id="rId68"/>
    <p:sldId id="424" r:id="rId69"/>
    <p:sldId id="332" r:id="rId70"/>
    <p:sldId id="420" r:id="rId71"/>
    <p:sldId id="421" r:id="rId72"/>
    <p:sldId id="334" r:id="rId73"/>
    <p:sldId id="331" r:id="rId74"/>
    <p:sldId id="337" r:id="rId75"/>
    <p:sldId id="338" r:id="rId76"/>
    <p:sldId id="339" r:id="rId77"/>
    <p:sldId id="293" r:id="rId78"/>
    <p:sldId id="340" r:id="rId79"/>
    <p:sldId id="336" r:id="rId80"/>
    <p:sldId id="349" r:id="rId81"/>
    <p:sldId id="351" r:id="rId8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238" autoAdjust="0"/>
  </p:normalViewPr>
  <p:slideViewPr>
    <p:cSldViewPr snapToGrid="0" snapToObjects="1">
      <p:cViewPr>
        <p:scale>
          <a:sx n="100" d="100"/>
          <a:sy n="100" d="100"/>
        </p:scale>
        <p:origin x="-640" y="-4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slide" Target="slides/slide35.xml"/><Relationship Id="rId37" Type="http://schemas.openxmlformats.org/officeDocument/2006/relationships/slide" Target="slides/slide36.xml"/><Relationship Id="rId38" Type="http://schemas.openxmlformats.org/officeDocument/2006/relationships/slide" Target="slides/slide37.xml"/><Relationship Id="rId39" Type="http://schemas.openxmlformats.org/officeDocument/2006/relationships/slide" Target="slides/slide38.xml"/><Relationship Id="rId50" Type="http://schemas.openxmlformats.org/officeDocument/2006/relationships/slide" Target="slides/slide49.xml"/><Relationship Id="rId51" Type="http://schemas.openxmlformats.org/officeDocument/2006/relationships/slide" Target="slides/slide50.xml"/><Relationship Id="rId52" Type="http://schemas.openxmlformats.org/officeDocument/2006/relationships/slide" Target="slides/slide51.xml"/><Relationship Id="rId53" Type="http://schemas.openxmlformats.org/officeDocument/2006/relationships/slide" Target="slides/slide52.xml"/><Relationship Id="rId54" Type="http://schemas.openxmlformats.org/officeDocument/2006/relationships/slide" Target="slides/slide53.xml"/><Relationship Id="rId55" Type="http://schemas.openxmlformats.org/officeDocument/2006/relationships/slide" Target="slides/slide54.xml"/><Relationship Id="rId56" Type="http://schemas.openxmlformats.org/officeDocument/2006/relationships/slide" Target="slides/slide55.xml"/><Relationship Id="rId57" Type="http://schemas.openxmlformats.org/officeDocument/2006/relationships/slide" Target="slides/slide56.xml"/><Relationship Id="rId58" Type="http://schemas.openxmlformats.org/officeDocument/2006/relationships/slide" Target="slides/slide57.xml"/><Relationship Id="rId59" Type="http://schemas.openxmlformats.org/officeDocument/2006/relationships/slide" Target="slides/slide58.xml"/><Relationship Id="rId70" Type="http://schemas.openxmlformats.org/officeDocument/2006/relationships/slide" Target="slides/slide69.xml"/><Relationship Id="rId71" Type="http://schemas.openxmlformats.org/officeDocument/2006/relationships/slide" Target="slides/slide70.xml"/><Relationship Id="rId72" Type="http://schemas.openxmlformats.org/officeDocument/2006/relationships/slide" Target="slides/slide71.xml"/><Relationship Id="rId73" Type="http://schemas.openxmlformats.org/officeDocument/2006/relationships/slide" Target="slides/slide72.xml"/><Relationship Id="rId74" Type="http://schemas.openxmlformats.org/officeDocument/2006/relationships/slide" Target="slides/slide73.xml"/><Relationship Id="rId75" Type="http://schemas.openxmlformats.org/officeDocument/2006/relationships/slide" Target="slides/slide74.xml"/><Relationship Id="rId76" Type="http://schemas.openxmlformats.org/officeDocument/2006/relationships/slide" Target="slides/slide75.xml"/><Relationship Id="rId77" Type="http://schemas.openxmlformats.org/officeDocument/2006/relationships/slide" Target="slides/slide76.xml"/><Relationship Id="rId78" Type="http://schemas.openxmlformats.org/officeDocument/2006/relationships/slide" Target="slides/slide77.xml"/><Relationship Id="rId79" Type="http://schemas.openxmlformats.org/officeDocument/2006/relationships/slide" Target="slides/slide7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40" Type="http://schemas.openxmlformats.org/officeDocument/2006/relationships/slide" Target="slides/slide39.xml"/><Relationship Id="rId41" Type="http://schemas.openxmlformats.org/officeDocument/2006/relationships/slide" Target="slides/slide40.xml"/><Relationship Id="rId42" Type="http://schemas.openxmlformats.org/officeDocument/2006/relationships/slide" Target="slides/slide41.xml"/><Relationship Id="rId43" Type="http://schemas.openxmlformats.org/officeDocument/2006/relationships/slide" Target="slides/slide42.xml"/><Relationship Id="rId44" Type="http://schemas.openxmlformats.org/officeDocument/2006/relationships/slide" Target="slides/slide43.xml"/><Relationship Id="rId45" Type="http://schemas.openxmlformats.org/officeDocument/2006/relationships/slide" Target="slides/slide44.xml"/><Relationship Id="rId46" Type="http://schemas.openxmlformats.org/officeDocument/2006/relationships/slide" Target="slides/slide45.xml"/><Relationship Id="rId47" Type="http://schemas.openxmlformats.org/officeDocument/2006/relationships/slide" Target="slides/slide46.xml"/><Relationship Id="rId48" Type="http://schemas.openxmlformats.org/officeDocument/2006/relationships/slide" Target="slides/slide47.xml"/><Relationship Id="rId49" Type="http://schemas.openxmlformats.org/officeDocument/2006/relationships/slide" Target="slides/slide48.xml"/><Relationship Id="rId60" Type="http://schemas.openxmlformats.org/officeDocument/2006/relationships/slide" Target="slides/slide59.xml"/><Relationship Id="rId61" Type="http://schemas.openxmlformats.org/officeDocument/2006/relationships/slide" Target="slides/slide60.xml"/><Relationship Id="rId62" Type="http://schemas.openxmlformats.org/officeDocument/2006/relationships/slide" Target="slides/slide61.xml"/><Relationship Id="rId63" Type="http://schemas.openxmlformats.org/officeDocument/2006/relationships/slide" Target="slides/slide62.xml"/><Relationship Id="rId64" Type="http://schemas.openxmlformats.org/officeDocument/2006/relationships/slide" Target="slides/slide63.xml"/><Relationship Id="rId65" Type="http://schemas.openxmlformats.org/officeDocument/2006/relationships/slide" Target="slides/slide64.xml"/><Relationship Id="rId66" Type="http://schemas.openxmlformats.org/officeDocument/2006/relationships/slide" Target="slides/slide65.xml"/><Relationship Id="rId67" Type="http://schemas.openxmlformats.org/officeDocument/2006/relationships/slide" Target="slides/slide66.xml"/><Relationship Id="rId68" Type="http://schemas.openxmlformats.org/officeDocument/2006/relationships/slide" Target="slides/slide67.xml"/><Relationship Id="rId69" Type="http://schemas.openxmlformats.org/officeDocument/2006/relationships/slide" Target="slides/slide68.xml"/><Relationship Id="rId80" Type="http://schemas.openxmlformats.org/officeDocument/2006/relationships/slide" Target="slides/slide79.xml"/><Relationship Id="rId81" Type="http://schemas.openxmlformats.org/officeDocument/2006/relationships/slide" Target="slides/slide80.xml"/><Relationship Id="rId82" Type="http://schemas.openxmlformats.org/officeDocument/2006/relationships/slide" Target="slides/slide81.xml"/><Relationship Id="rId83" Type="http://schemas.openxmlformats.org/officeDocument/2006/relationships/notesMaster" Target="notesMasters/notesMaster1.xml"/><Relationship Id="rId84" Type="http://schemas.openxmlformats.org/officeDocument/2006/relationships/printerSettings" Target="printerSettings/printerSettings1.bin"/><Relationship Id="rId85" Type="http://schemas.openxmlformats.org/officeDocument/2006/relationships/presProps" Target="presProps.xml"/><Relationship Id="rId86" Type="http://schemas.openxmlformats.org/officeDocument/2006/relationships/viewProps" Target="viewProps.xml"/><Relationship Id="rId87" Type="http://schemas.openxmlformats.org/officeDocument/2006/relationships/theme" Target="theme/theme1.xml"/><Relationship Id="rId8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E740A9-2DCD-0B40-97A5-1847C03E1C99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C89DD2-D6F7-C348-90C0-57B3312BA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8044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6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7E506-CEAD-8243-9C74-FD6AD27C2445}" type="slidenum">
              <a:rPr lang="en-US" smtClean="0"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6811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Ventral</a:t>
            </a:r>
            <a:r>
              <a:rPr lang="en-US" baseline="0" dirty="0" smtClean="0"/>
              <a:t> </a:t>
            </a:r>
            <a:r>
              <a:rPr lang="en-US" baseline="0" dirty="0" err="1" smtClean="0"/>
              <a:t>Hb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C89DD2-D6F7-C348-90C0-57B3312BAA5D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2842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7E506-CEAD-8243-9C74-FD6AD27C2445}" type="slidenum">
              <a:rPr lang="en-US" smtClean="0"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6811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140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601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639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133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771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367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088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43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736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017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714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4924DC-D925-1841-9087-12E6638EEF2A}" type="datetimeFigureOut">
              <a:rPr lang="en-US" smtClean="0"/>
              <a:t>03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CAD80-B01C-2F43-BD5C-48637CDD4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215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2242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106182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dog              TGATT-GATGCAAATGGCCCTATGTTCTTTC--CTATCATTAGCGGCC------------ 4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TT-GATGCAAATGGCCCTA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T-GATGCAAATGGCCCTATGTTCTTTT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TT-GATGCAAATGGCCCTGTGTTCTTTC--CTGTCATTAGCA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T-GATGCAAATGGCCCTGTGTTCTTTC--CTGTCATTAGCA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ATT-GATGCAAATGGCCCTG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T-GATGCAAATGGTCCTCTGTTCTTTC--CTATCATTAGCGGC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TT-GATGCAAATGGCCCTGTGTGCTTTC--CTATCATTAGTGGCC------------ 4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TT-GATGCAAATGGCCGTCTGTCCTTTT--CTATCATTAACTGGG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TT-GATGCAAATGGCCCTCTGTTCTTTT--CTATCATTAACGGGC------------ 4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TT-GATGTAAATGGCCCTCTGTTCTTTTTTCTATCATTAACTGGC------------ 4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ATT-GATGCAAATGGCTCTCTGTTCTTTT--CTACCATTAACAGGC------------ 4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TA-GATGCAAATGGCTCTC--TTCTCTT--CTATCATTAACAGCCTTCTCTTCACTC 55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ATT-GATGCAAATGGCTCTCTGTTCTTTT--GTATCATTAATGGTC------------ 45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ATTTGATGCAAATGCTTTTCTGTTCATTT---TATCACTAATGGCTT----------- 4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  **** *****    *   * *  *    *  ** **   *            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dog              --------TCTTTCAGTGGCCAGAGGCAGTGATTAAAGCTGTCATTTGG-AGCTGCTCAT 9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--------TCTTTCAGTG-CCAGAGGCAGTGATTAAAGCTGTCATTTG--AGCTGCTCAT 9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--------TCTTTCAGTGGCCAGAGGCAA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----TCTT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--------TCTCTCAGTGGCCAGAGGCAGTGATTAAAGCTGTCATTTGG-AGCTGCTCAT 9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-------CTTTGC-TGTGGCCACAGGCACTGATTAAAGCCATCATTTTT-AGCTACTTGT 9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-----CCTTCCCTGTGGCCACAGGCGGTGATTAAAGCTGTCATTTCC-AGCTACTCAT 9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----CCTTTGCCGTGGCCACAGGCAGTGATTAAAGCTGTCATTTCC-AGCGACTCAT 9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------CCCTACCG--GGCCACAGGCAATGATTGAAGCTGTCTTTTTTTACCTACTCAT 9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CTTTCTCTCTCTCGACGGCCACAGGCAGTGATTAAAGCTGTCATCTAC-AGCTACTCAT 11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-------TCTCTCAGTGGCCAGAGGCAGTGATTAAAGCTGTCATTTGG-AGCTGCTCAT 9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CTCTCTCTGTGGCCAGAGGCGGGGATTAAGGCTGGC--TTCAGGGCGGCTCAT 9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*      * *** ****   **** * **   *   *     *  ** 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898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AUTS2.8975</a:t>
            </a:r>
          </a:p>
        </p:txBody>
      </p:sp>
      <p:sp>
        <p:nvSpPr>
          <p:cNvPr id="7" name="Rectangle 6"/>
          <p:cNvSpPr/>
          <p:nvPr/>
        </p:nvSpPr>
        <p:spPr>
          <a:xfrm>
            <a:off x="2032000" y="872066"/>
            <a:ext cx="1041400" cy="479703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5504646" y="6561666"/>
            <a:ext cx="558800" cy="479703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2120900" y="61183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19641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>
            <a:off x="5504646" y="118180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1279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TTTTTAATTTGTTGTGATGAATGAGTGACACCTCTGACAGCCGATTCGCG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TTTTAATTTGTTGTGATGAATGAGTGACACCTCTGACAGCCGATTCGCG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TTTTAATTTGTCGTGATGAATGAGTGACACCTCTGACAGCCGATTCGCG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TTTTAATTTGTTGTGATGAATGAGTGACACCTCTGACAGCCGATTCGCG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TTTTAATTTGTTGTGATGAATGAGTGACACCTCTGACAGCCGATTCGCG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TTTTAATTTGTTGTGATGAATGAGTGACACCTCTGACAGCTGATTCGTG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--------GTTGTGATGAATGAGTGACATCTCTGACAGCCGATTCGCAGAGATTAATA 5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TTTTAATTTGTTGTGATGAATGAGTGACACCTCTGACAGCCGATTCGCA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TTTTAATTTGTTGTGATGAATGAGTGACACCTCTGACAGCCGATTCGCA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TTTTAATTTGTTGTGATGAATGAGTGGCACCTCTGACAGCCGATTCGCA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TTTTAATTTGTTGTGATGAATGAGTGGCACCCCTGACAGCCGATTCGAA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TTTAATTTGTTGTGATGAATGAGTGACACCTCTGACAGCCGATTCGCGGAGATTAA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TTTTAATTTGTTGTGATGAATGAGTGACACCTCTGACAGCCGATTCACG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TTAAAATTTGTTTTGATGAATGAGTGACAACTCTGACACCCGATTCGCTGAGATTAAT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TTTAATTTGTTTTGATGAATGAGTGACAAGCCTGACACCCGATTCGCTGAGATTAATA </a:t>
            </a:r>
            <a:r>
              <a:rPr lang="en-US" sz="1200" dirty="0" smtClean="0">
                <a:latin typeface="Courier New"/>
                <a:cs typeface="Courier New"/>
              </a:rPr>
              <a:t>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TTTTAATTTGAGCTGATGAATGAGTGACAGATGTGACAGGC-ACCACCACAGATTAATA </a:t>
            </a:r>
            <a:r>
              <a:rPr lang="en-US" sz="1200" dirty="0" smtClean="0">
                <a:latin typeface="Courier New"/>
                <a:cs typeface="Courier New"/>
              </a:rPr>
              <a:t>58</a:t>
            </a:r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CCTAACTCGGGTTGACGAATGAGTGACAGCT-TGACACCTCATTCGGCAAGATTAATC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CCTAACTCGGGTTGACGAATGAGTGACAGCT-TGACACCTCATTCGGCAAGATTAATC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TCCTTCTGCGGTTTGACGAATGAGTGACAGCT-TGACACCTCATTCGGCAAGATTAATA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CCTAATTCGGTTTGACGAATGAGTGACAGCT-TGACACTTCATTCGGCAAGATTAAT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CCTAATTCAGTTTGACGAATGAGTGGCAGCT-TGACACTTCATTCAGCAAGATTAATA 5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---TGATAAACGAGTGACAGGC-TGACAGCTCATTCTG-AGGATTAATA 4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						 ***  ** ***** **    *****    *        ******* 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7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ESRRB.9024</a:t>
            </a:r>
          </a:p>
        </p:txBody>
      </p:sp>
      <p:sp>
        <p:nvSpPr>
          <p:cNvPr id="7" name="Rectangle 6"/>
          <p:cNvSpPr/>
          <p:nvPr/>
        </p:nvSpPr>
        <p:spPr>
          <a:xfrm>
            <a:off x="3301706" y="879147"/>
            <a:ext cx="952500" cy="299435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5136346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3301706" y="61183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5136346" y="61183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6679906" y="879147"/>
            <a:ext cx="952500" cy="433256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3247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05156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8956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GCTCCCTGACAGCAG---GAA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CTCCCTGACAGCAG---GAA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CTCCCTGACAGCAG---GAA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CTCCCTGACAGCAG---GAAAAA-TTCATAGCCATTGATTTTGTAATTAACAGTTTATC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CTCCCTGACAGCAG---AAA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CTCCCTGACAGCAC---AAC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CTCCTTGACAGCAG---AAA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CTCCTTGACAGCAG---AAAAAAATTCATAGCCATTGATTTTGTAATTAACAGTTTATC 5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CTCGCTGACAGCAG---AGAAAA-TTT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CTCCCTGACAGCAG---AAA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CTCCCTGACAGCAG---AAAAAA-TTCATAGCCATTGATTTTGTAATTAACAGTTTATC 5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CTCTCTGACAGCAGGGGAAAAAA-TTCATAGCCATTGATTTTGTAATTAACAGTTTATC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CTCTCTGACAGCAGAAAAAAAAAATTCATAGCCATTGATTTTGTAATTAACAGTTTATC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-TCCCTGACAGCAG---TAAAAA-TTCATAGTCATTGATTTTGTAATTAACAGTTTATC 5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-CTGACAGCTG---TATAAA-TTCATAGATATTGATTTTGTAATTAACGGTTTATC 5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CCGTCTGACAGCTG---TGAAAA-TTCATAGCGATTGATTTTGTAATTAGCAGTTTATC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----CTGACAGCTG---TGAAAA-TTCATAGCGATTGATTTTGTAATTAGCAGTTTATC 51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--TCCGACAGCCG---TGAAAA-TTCATAGCGATTGATTTTGTAATTAGCAGTTTATC 5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GTCTGACAACTG---TGAAAA-TTCATAGCGATTGATTTTGTAATTAGCAGTTTATC 5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GTCTGACAGCCC---TGAAAA-TTCATAGCCATTGATTTTGTAATTAGCAGTTTATC 53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**** *        *** ** ****  **************** * *****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AATGCCATCGATACAGACCGGCTGATGGATTGCAAAGAAATTAATCTTGCA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TGCCATCGATACAGACCGGCTGATGGACTGCAAAGAAATTAATCTTGCA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TGCCATCAATACAGACCTGCTGATGGATTGCAAAGAAATTAATCTTGCA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TGCCATTGATACAGACCTGCTGATGGATTGCAAAGAAATTAATCTTGCAATGTTATTT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ATGCCATCGATACAGACCTGCTGATGGATTGCAAAGAAATTAATCTTGCA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ATGCCATCGATACCGCCTTGCGGATGGATTGCAAAGAAATTAATCTTGCA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ATGCCATCGATACAGACTCACTGATGGATTGCAGAGAAATTAATCTTGCA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ATGCCATCAATACAGACTCGCTGATAGATTGCAAAGAAATTAATCTTGCAATGTTATTT 11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TGCCATCGATACAGACTCACTGATGGATTGCAAAGAAATTAATCTTGCA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TGCCATCGATACAGACTCACTGATGGATTGCAAAGAAATTAATCTTGCGA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ATGCCATCGATACAGACTCGCTGATGGATTGCAAAGAAATTAATCTTGCAGTGTTATTT 11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TGCCATCGATACAGACTTGCTGATGGATTGCAAAGAAATTGATCTTGCAATGTTATTT 11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TGCCATTGATACAGACTTGCTGATGGATTGCAAAGAAATTGATCTTGCAATGTTATTT 12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ATGCCATCAATACAGACTTGCTGATGGATTGCAAAGAAATTAATCCTGCAAAGTTTTTT 11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TGCCATTGACACCAGCTCATGGATGGATTGAAAAGAAATTAATCCTGCAGTGTTATTT 11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TCGGATCGACGCGGGCTCACTGATGGATTGGGAGGAAATTGTTTCTTCAAAGTTGTGT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ATCGGATCGACGCAGGCTCACTGATGGATTGTGAGGAAATTGTTTCTTTAAAGTTGTGT 111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ATCGGATCGACGTGGGCTCGCTGATGGATTGCGGGGAAATTGTTCCTTTAAAGTTGTTT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ATTGGATCGACGTGAACTCACTGATGGATTGCAAGGAAATTGTTTCTTCAAAGTT---- 10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TCGTATCGACAGGCTCCTTCTGATGGATTGCAAGGAAATTGTTTCTTCAGACGTGTTT 113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   **  *      *     *** ** **    ******  *  *      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7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ESRRB.9032</a:t>
            </a:r>
          </a:p>
        </p:txBody>
      </p:sp>
      <p:sp>
        <p:nvSpPr>
          <p:cNvPr id="7" name="Rectangle 6"/>
          <p:cNvSpPr/>
          <p:nvPr/>
        </p:nvSpPr>
        <p:spPr>
          <a:xfrm>
            <a:off x="4012906" y="5669105"/>
            <a:ext cx="952500" cy="386859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24012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2570946" y="872067"/>
            <a:ext cx="558800" cy="38721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2570946" y="5095889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04072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ight Arrow 9"/>
          <p:cNvSpPr/>
          <p:nvPr/>
        </p:nvSpPr>
        <p:spPr>
          <a:xfrm>
            <a:off x="4012906" y="9897219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8049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3157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325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AGTCGCTTTTGCTCTAAAGCACTGTC-----------------------ACAAAAA--G 20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AGTCGCTTTTGCTCTAAAGCACTGTC-----------------------ACAAAAA--G 20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GTCGCTTTTGCTCTTAAGCACTGTC-----------------------ACAAAAA--G 204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GTCGGTTTTGCTCTAAAGTACC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GTCGGTTTTGCTCTAAAGTACC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GTCGGTTTTGCTCTAAAGTACC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GTCGGTTTTGCTCTAAAGTACCGTC-----------------------ACAAAAA--G 20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GTCGGTTTTGCTCTAAAGTACTGTC-----------------------ACAAA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AGTCGCTTTTGCTCTCAAGTACTGTC-----------------------ACAAAAG--G 3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AGTCGGTTTTGCTCTAAAGTACTGTC-----------------------ACAAAAA--G 20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GTCGGTTTTGCTCTAAAGTACTGTC-----------------------ACAAG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GTCGGTTTTGCTCTAAAGTACTGTC-----------------------ACAAGAA--G 20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AGTCGGTTTTACTCTAAAGTACTGTC-----------------------AAAAAAAA-G 20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</a:t>
            </a:r>
            <a:r>
              <a:rPr lang="en-US" sz="1200" dirty="0" smtClean="0">
                <a:latin typeface="Courier New"/>
                <a:cs typeface="Courier New"/>
              </a:rPr>
              <a:t>TTTTCGCTCTGGCTCTATAGCAGCGTCTGCACGCACACACATACGCGCGAACAAAAAAAG </a:t>
            </a:r>
            <a:r>
              <a:rPr lang="en-US" sz="1200" dirty="0">
                <a:latin typeface="Courier New"/>
                <a:cs typeface="Courier New"/>
              </a:rPr>
              <a:t>231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*** * *  ****  ** *  ***                       * ** *   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AATTACCATTCACTTGGAATGATGCCATTCATCTTTGTCA-----GAGCGC------ 254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AATTACCATTCGCTTGGAATGATGCCATTCATCTTTGTCA-----CAGCGC------ 25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AATTACCATTTGCTTGGAATGATGCCATTCATCTTTGTCA-----GAGCCC------ 25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AATTACCATTTGCTTGGAATGATGCCATTCATCATTGTCA-----GAAT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AATTACCATTTGCTTGGAATGATGCCATTCATCATTGTCA-----GAAT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AATTACCATTTGCTTGGAATGATGCCATTCATCATTGTCA-----GAAT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AATTACCATTTGCTTGGAATGATGCCATTCATCATTGTCA-----GAATAC------ 2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AATTACCATTCGCTTGGAATGATGCCATTCATCATTGTCA-----GAAT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AAATTACCATTTGCTTGGAATGATGCCATTCATCATTGTCA-----GAAT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AAATTACCATTTGCTTGGAATGATGCCATTCATCATTGTCA-----GAAC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AATTACCATTTGCTTGGAATGATGCCATTCATCATTGTCA-----GAAC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AATTACCATTTGCTTGGAATGATGCCATTCATCATTGTCA-----GAAC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AATTACCATTTGCTTGGAATGATGCCATTCATCATTGTCA-----GAAC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AAATTACCATTTGCTTGGAATGATGCCATTCATCATTGTCA-----GAACG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AATTACCATTTGCTTGGAATGATGCCATTCATCATTGTCA-----GAAT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AATTACCATTTGCTTGGAATGATGCCATTCATCATTGTCA-----GAATT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AATTACCATTTGCTTGGAGGGATGCCATTCATCATTGTCA-----GAACCC------ 85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AAATTACCATTTGCTTGGAATGATGCCATTCATCATTGTCA-----GAATAC------ 24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AATTACCATTTGCTTGGAACGATGCCATTCATCATTGTCA-----GAATG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AATTACCATTTGCTTGGAACTATGCCATTCATCATTGTCA-----GAATAC------ 25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AAATTACCATTTTCTTCGAACGATGCCATTCATCATTGTCA-----GAACAC------ 2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AATTACTATTCAGTTGGAATGGTGCCATTCATCTTTGTCAAGTGCGGACGCGGTCCC 291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 ***   ** **    *********** ******          * </a:t>
            </a:r>
          </a:p>
        </p:txBody>
      </p:sp>
      <p:sp>
        <p:nvSpPr>
          <p:cNvPr id="7" name="Rectangle 6"/>
          <p:cNvSpPr/>
          <p:nvPr/>
        </p:nvSpPr>
        <p:spPr>
          <a:xfrm>
            <a:off x="4470400" y="5829300"/>
            <a:ext cx="952500" cy="428446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44700" y="548959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5422900" y="5829300"/>
            <a:ext cx="558800" cy="4284465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44476" y="1074876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8748" y="138668"/>
            <a:ext cx="2408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EVI1.10711</a:t>
            </a:r>
          </a:p>
        </p:txBody>
      </p:sp>
      <p:sp>
        <p:nvSpPr>
          <p:cNvPr id="18" name="Left Arrow 17"/>
          <p:cNvSpPr/>
          <p:nvPr/>
        </p:nvSpPr>
        <p:spPr>
          <a:xfrm>
            <a:off x="4483100" y="10599554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4038600" y="872066"/>
            <a:ext cx="558800" cy="423152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ight Arrow 19"/>
          <p:cNvSpPr/>
          <p:nvPr/>
        </p:nvSpPr>
        <p:spPr>
          <a:xfrm>
            <a:off x="4038600" y="534099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Arrow 23"/>
          <p:cNvSpPr/>
          <p:nvPr/>
        </p:nvSpPr>
        <p:spPr>
          <a:xfrm>
            <a:off x="5435600" y="1060271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60317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stickleback      ACACAATGCATCATAAAA-CAAATCCCTCATCCTGACAGGGAGAAAATAGAACAGCT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CACAATACATCAAAAAAATGAATCCCTCATTCTGACAGGAAGAAAATGGAACAGCTC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CACAATGCATCATAAAA-CAAATCCCTCATCCTGACAGGAAGAAAATAGAACAGCT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CACAATGCATCATAAAC-CAAATCCCTCATCCTGACAGGG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CACAATGCATCATAAAA-CAAATCCCTCT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CACAATGCATCATAAAA-CAAATCC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CACAATGCATCATAAAA-CAAATCCCTCATCCTGACAGGAAGAAAATAGAAG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CACAATGCATCATAAAA-CAAATCT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CACAATGCATCATAAAA-CAAATCTCTCATCCTGACAGGAAGAAAATAGAACAGCTCAT 59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CACAATGCTTCATAAAA-GAAATCGTTCATCCTGACAGGAAGAAAATAGCACAGCTCAC 5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CACAATGTACCATAAAA-CAAACCCCTCATCCTGACAGGAAGAACTCAGCGCAGCTCCG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    ** ***    ** *  ** * ******** ****    *   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08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EVI1.11239 </a:t>
            </a:r>
          </a:p>
        </p:txBody>
      </p:sp>
      <p:sp>
        <p:nvSpPr>
          <p:cNvPr id="7" name="Rectangle 6"/>
          <p:cNvSpPr/>
          <p:nvPr/>
        </p:nvSpPr>
        <p:spPr>
          <a:xfrm>
            <a:off x="2292056" y="887176"/>
            <a:ext cx="952500" cy="395520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2292056" y="61157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060146" y="872066"/>
            <a:ext cx="558800" cy="3970317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5060146" y="612086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36392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orangutan        -------GAGTGCAGAGGGGATTCAGCAAGG-CCTAATCAATCACTGACAGATTACAGCT 5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-------GAGTGC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-------GAGTGC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-------GAGTGC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-------GAGTGC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-------GAGTGGAA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-------GAGTGG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-----GAGTGG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------GAGCGG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------GAGTGG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-----GAGTGG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-------GAGTGGAGAGGGGATTCAGCAAA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------GAGTGGAGAGGGGATTCAGCAAGG-CCTAATCAATCACTGACAGATTACAGCT 52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---------------GGGGATTCAGTAAGG-CCTAATCAATCACTGACAGATTACAGCG 4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---GAGTGCGGACGGGATCCAGGAAGGGCCTAATCAATCACTGACAGATTACAGCT 53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------GAGTAGAAACGGGATTCGGCGAGGGCC-AATCAATCACTGACAGATTACAGCC 5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------GGGATTGAGGCCGA-CCTAATCAATCAATGACAGATTACAGCT 4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-------------------------A-CCTAATCAATCAATGCCAGATTACAGCT 2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AGAGGAGAGGAGAGGAGGGATTGGGCCGCA-CCTAATCAATCACTGACAGATTACTGC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------------------GATTGGGCCGCA-CCAAATCAATCACTGACAGATTACTGCT 4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GAGCAGAACGGAGAAGGGATTTGGCCACA-CCTAATCAATCACTGACAGATTACCGCT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--------------------------------AATCAATCACTGACAGATTACGGCT 25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    ********* ** ******** 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31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</a:t>
            </a:r>
            <a:r>
              <a:rPr lang="en-US" dirty="0"/>
              <a:t>: FIGN</a:t>
            </a:r>
            <a:r>
              <a:rPr lang="en-US" dirty="0" smtClean="0"/>
              <a:t>.5161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5105106" y="872066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5105106" y="56966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6139646" y="569668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139646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43286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7983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694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CACACCTGGAGTCT----CAGCTGCAGCATAGCTGTCATTTAC-GCTATCCATGGCCCAG 55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ACACCTGGGGTCT----CAGCTGCAGCATAGCTGTCATTTAC-GCTATCCATGGCCCAG 55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CACCTGGGGTCT----CAGCTGCAGCATAGCTGTCATTTAC-GCTATCCATGGCCCAG 5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ACACCTGGGGTCT----CAGCTGCAGCATAGCTGTCATTTAC-GCTATCCATGGCCCAG 5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CACCTGGGGTCT----CAGCTGCAGCATAGCTGTCATTTAC-GCTATCCATGGCCCAG 5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CACCTGGGGTCT----CAGCTGCAGCATAGCTGTCATTTAC-GCTATCCATGGCCCAG 5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ACACCTGGGGTCT----CAGCTGCAGCGTAGCTGTCATTTAC-GCTACCCATGGCCCAC 5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ACACCTGGGGTCT----CAGCTGCAGCGTAGCTGTCATTTAC-GCTACCCATGGCCCAC 55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ACACCTGGGGTCT----CAGCTGCAGCGTAGCTGTCATTTAC-GCTACCCATGGCCCAG 5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CACCTGGGGTCT----CAGCTGCAGCATAGCTGTCATTTAC-GCTACCCATGGCCCAC 55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ACACCTGGGGTCT----CAGCTGCAGCGTAGCTGTCATTTAC-GCTATCCATGGCCCAC 5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ACACCTGGGGTCT----CAGCTGCGGCAGAGCTGTCATTTAC-GCTATCCATGGCCCAC 5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CACCTGGGGTCT----CAGCTGCAGCATAGCTGTCATTTAC-GCTATCTGTGGCCCAC 5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ACACCTGGGGTCT----CAGCTGCACTGTAGCTGTCATTTAC-GCTATCCATGGCACAG 5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ACACCTGG-GCCT----CAGCTGCAGCATAGCTGTCATTTAC-GCTATCCATGGCACAG 5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ACACCTGGGGCCT----CGACTGCAGTGGAACTGTCATTTAT-GCTATCCATAGCACTA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ACACCTGGGGCCT---GTGGCTGGTGTGCGGCTGTCACCGGCCATCGCC-ATGCCATGC 5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ACACCTGGGGCCCCCCGGGGCTGGCGTGTGGCTGTCACCAGCCATCGCC-ACGCCACGC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ACACCTGGGGCCC---ACTGCTGGCGTGTGGCTGTCAGCCGCCATCGCC-GCGCCACGC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ACACCTGGGGCCC---GCTGCTGGCGTGTGGCTGTCAGCCGCCATCGCC-GCGCCACGC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----------------------TGCTGCTGTCAGAAAGGACGGCCCGAGCTCTG- 3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TCT----CTGCTCCAGTGTAGCTGTCACTGGT-GTTAGACTCAGAGCTG 4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 ******                    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ATTGATGACAGTCATTCGCTGATGAAGCTGTATACATCATTTCTGTCCGA-GCTGCACT 11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ATTGATGACAGTCATTCGCTGATGAAGCTGTATACATCATTTCTGTCCAG-GCTGCACT 113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ATTGATGACAGTCATTCGCTGATGAAGCTGTATACATCATTTCTGTCCAG-GCTGCATT 11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ATTGATGACAGCTATTCACTGATGAAGCTGTATTCATCATTCCTGTCCAGGGCTGCACT 11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ATTGATGACAGCTATTCACTGATGAAGCTGTATTCATCATTCCTGTCCAGGGCTGCGCT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ATTGATGACAGCTATTCACTGATGAAGCTGTATTCATCATTCCTGTCCAGGGCTGCACT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ATTGATGACAGCTATTCACTGATGAAGCTGTATTCATCATTCCTGTCCAGGGCTGCACT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ATTGATGACAGTCATTCAGTGATGAAGCTGTATTCATCATGCCTGTCCAGAGCTGCACT 9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ATTGATGACAGTCATTCAGTGATGAAGAAGTA--CATGGTGTCTGTGCGGGTCTGTACT 10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**********  ****  ********  ***  ***  *  **** *    ***  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90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FIGN.5158</a:t>
            </a:r>
          </a:p>
        </p:txBody>
      </p:sp>
      <p:sp>
        <p:nvSpPr>
          <p:cNvPr id="7" name="Rectangle 6"/>
          <p:cNvSpPr/>
          <p:nvPr/>
        </p:nvSpPr>
        <p:spPr>
          <a:xfrm>
            <a:off x="4749506" y="6227383"/>
            <a:ext cx="952500" cy="423741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4945846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4945846" y="5697947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9354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4724106" y="107893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79695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TGACACCGGCAGAGGGGCTGATTTATAGTTTAATTTGCTGTG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TGACACCGGCAGAGGGGGTGATTTATAGTTTAATTTGCTGTGGTAATGGACAGAGGA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TGACACCGGCAGAAGGGGTGATTTATAGTTTAATTTGCTGTTGTAATGGACAGAGGA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TGACACCGGCGGAGGGGGTGATTTATAGTTTAATTTGCTGTGGTAATGGACAGAGGA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TGACACCAGCGCAGGGGGTGATTTATAGTTTAATTTGCTGTG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TGACAT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TGACATAGGCAGAAGGTGTGATTTATAGTTTAATTTGCTGTCGTAATGGACAGAGGA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TGACAC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TGACACAGGCAGAAGGTGTGATTTATAGTTTAATTTGCTGTCGTAATGGACA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TGACTCCCGCAAAGGGTGCGATCCCTCCATTAATTTGCTGCCGAAATGTACAGAAGATC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    **  * **   ***   *   ***********  * **** ***** 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933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FOXD3.330</a:t>
            </a:r>
          </a:p>
        </p:txBody>
      </p:sp>
      <p:sp>
        <p:nvSpPr>
          <p:cNvPr id="7" name="Rectangle 6"/>
          <p:cNvSpPr/>
          <p:nvPr/>
        </p:nvSpPr>
        <p:spPr>
          <a:xfrm>
            <a:off x="3733506" y="872066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579337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2101556" y="872066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Arrow 23"/>
          <p:cNvSpPr/>
          <p:nvPr/>
        </p:nvSpPr>
        <p:spPr>
          <a:xfrm>
            <a:off x="5498806" y="564732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5498806" y="872066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3733506" y="5647325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Left Arrow 18"/>
          <p:cNvSpPr/>
          <p:nvPr/>
        </p:nvSpPr>
        <p:spPr>
          <a:xfrm>
            <a:off x="2101556" y="5649865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85327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50783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macaque          TGGTTTGATGCGCCCATAAATCAACATGACAGGCCTGTTTCACAGTCTCAGACAGTGCTT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GTTA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GTTTGATGCGCCCATAAATCAACATGACAGC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GTTTGATGCGCCCATAAATCAACATGACAGGCCCGTTTCACAGC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TGGTTTGATGCGCCCATAAATCAACATGACAGGCCTGTTTCACT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GTTTGATGCGCCCATAAATCAACATGACAGGTCTGTTTCACAGTCTCAGACAGCGCTT 11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GTTTGATGCGCCCATAAATCAACATGACAGGCCTGTTTCACAGTCTCAGACAGTGCTT 11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GTTTGATGCGCCCATAAATCAACATGACAGGCCTGTTTCACAGCCTCAGCCAGTGCTT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GCGTGATGCTCCCATAAATCACCCTGACAGCGGAGCTCCTCGGCCTCAGATAGGGCCT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GTGCGTCGCCTCCATAAATCAATGCGACAG---------------------------- 9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GTGTGATGCTCCCATAAATCAATGTGACAGCCGAGCTCCGCGGCCTCAGACAGGCCTT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GCGTGATGCTCCCATAAATCAACGTGACAGC-------------CTCAGATAGGACCT 104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GTGTGATGCTCCCATAAATCAAGGTGACAG---------------------------- 8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GTTTGATGCGCTCATAAATCAACATGACAGTTGCGTTTCGCAGCCTCAGACACCGCTT 11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AGTTTGATGCACTCATAAATCAACATGACAGGCTTGCTTCTCCTGCTCAGACAGCACTT 11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GTTTGATATGCTCATAAATCAAACTGACAAGCTGGCTTCTCAGGCCTAGCTTGCACTT 6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   *       *********    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70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FOXP1.892</a:t>
            </a:r>
          </a:p>
        </p:txBody>
      </p:sp>
      <p:sp>
        <p:nvSpPr>
          <p:cNvPr id="7" name="Rectangle 6"/>
          <p:cNvSpPr/>
          <p:nvPr/>
        </p:nvSpPr>
        <p:spPr>
          <a:xfrm>
            <a:off x="3193756" y="872066"/>
            <a:ext cx="952500" cy="5078312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22480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4406606" y="872066"/>
            <a:ext cx="558800" cy="507831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Arrow 19"/>
          <p:cNvSpPr/>
          <p:nvPr/>
        </p:nvSpPr>
        <p:spPr>
          <a:xfrm>
            <a:off x="4406606" y="6077487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Arrow 20"/>
          <p:cNvSpPr/>
          <p:nvPr/>
        </p:nvSpPr>
        <p:spPr>
          <a:xfrm>
            <a:off x="3193756" y="6077487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17394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56548" y="898978"/>
            <a:ext cx="7664854" cy="50783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bat              GTGACAGTGACCTACATGGTCACTGCAGATGTGATG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TGACAGTGACCTACATGGTCACTGG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TGACAGTGACCTACATGGTCAG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TGACAGTGACCC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TGACAGTGACCTACATGGTCACTGAAGATGTGATATAATTTATGATATATATAATAT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TGACAGTGACCTACATGGTCACTG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TGACAGTGACCTACATGGTCATTGAAGATC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TGACAGTGACCTACATGGTCAGTGAAGATGTGATATAATTTATGATATATATAATAT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TGACAGTGACCTACATGGTCAGCGGAGATGCGATATAATTTATGATATATATAATAT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TGACAGTGACCTACATGGTCACCACAGATGTGATATAATTTATGATATATT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TGACAGTGACCTACATGGTCACCGAAGATGTGATATAATTTATGATATATATAATAT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TGACAGTGACCTACATGGTCACCGAAGATGTGATATAATTTATGATATATATAATAT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TGACAGTGACCTACATGGTCACCCAAGATGTGATATAATTTATGATATATATA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 *********    ****  *** *************** 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70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FOXP1.906</a:t>
            </a:r>
          </a:p>
        </p:txBody>
      </p:sp>
      <p:sp>
        <p:nvSpPr>
          <p:cNvPr id="7" name="Rectangle 6"/>
          <p:cNvSpPr/>
          <p:nvPr/>
        </p:nvSpPr>
        <p:spPr>
          <a:xfrm>
            <a:off x="6114756" y="898978"/>
            <a:ext cx="952500" cy="479703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247900" y="625172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2291840" y="904724"/>
            <a:ext cx="558800" cy="479129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Arrow 19"/>
          <p:cNvSpPr/>
          <p:nvPr/>
        </p:nvSpPr>
        <p:spPr>
          <a:xfrm>
            <a:off x="2291840" y="6104399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Arrow 14"/>
          <p:cNvSpPr/>
          <p:nvPr/>
        </p:nvSpPr>
        <p:spPr>
          <a:xfrm>
            <a:off x="6114756" y="61160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45012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at              AGAATCCAGATACATAAATCAGCTGTCATTTATTAGCATGTTACTGGCATATCTGCCAGA 34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AATCCAGATACATAAATCAGCTGTCATC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AATCCAGATACATAAATCAGCTGTCATTTATTAGCATGTTACTGGCATATCTGCCAGA 34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AATCCAGATACATAAATCAGCTGTCATTTATTAGCATGTTACTGGCATATCTGCCAGA 35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AATCCAGATACATAAATCAGCTGTCATTTATTAGCATGTTACTGGCATATCTGCCAGA 35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AATCCAGATACATAAATCAGCTGTCATTTATTAGCATGTTACTGGCATATCTGCCAGA 352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GAATCCAGATACATAAATCAACTGTCATTTATTAGCATGTAACCAGCATATCTCCTAGA 34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GAATTCAGCTACATAAATCAACTGTCATTTATTAGCATGTTACTGACATATCTGGCAGA 35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AATACAGACGCATAAATCAGCTGTCATTTATTAGCGCGGCCCTGGCATATCCGCCAGA 3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AATACAGACGCATAAATCAGCTGTCATTTATTAGCGCGGCCCTGGCATATCCGCCAGA 35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AATACAGACGCATAAATCAGCTGTCATTTATTAGCATGGCCCTGGCATATCCGCCAGA 3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AATACAGACGCATAAATCAGCTGTCCTTTATTAGCATGGCCGTGGCATATCTGCCAGA 34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AATACAGATGCATAAATCAGCTGTCATTTATTAGCATGACGCTGGCA----------- 33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 ***   ********* ***** * *******  *       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87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FOXP2.3531</a:t>
            </a:r>
          </a:p>
        </p:txBody>
      </p:sp>
      <p:sp>
        <p:nvSpPr>
          <p:cNvPr id="7" name="Rectangle 6"/>
          <p:cNvSpPr/>
          <p:nvPr/>
        </p:nvSpPr>
        <p:spPr>
          <a:xfrm>
            <a:off x="2996906" y="872066"/>
            <a:ext cx="952500" cy="46317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4043852" y="872066"/>
            <a:ext cx="558800" cy="46317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4043852" y="5697947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2996906" y="56966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368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TATAATGAAGATCAGAGACTA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TAATGAAGATCAGAGACTA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TAATGAAGATCAGAGACTA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ATAATGAAGATCAGAGACTA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TAATGAAGATCAGAGACTAGAGATG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TAATGAAGATCAGAGACTA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TAATGAAGATCAGAGACTAGAGAG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TAATGAAGATCAGAGACTGGAGAG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TAATGAAGATCAGGGACTTGAGGCCGTGACAGCTCTGGCAGCTGATGTATTA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TAATGAAGATCAGAGGCTCGAGGC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TAATGAAGATCAGAGACTT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TAATGAAGATCAGAGACTAGAGATTGTGACAGCTCTGGCAGCTGATGTATTGGGTC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ATAATGAAGATCAGAGACTA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TAATGAAGATCAGAGTCTAGAGATTGTGACAGCTCTGGCAGCTGATGT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ATAATGAAGATCAGAGAATGGGGATTGTGACAGCTCCGACAGCTGATGCATT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TATAATGAAGATCAGGGAATGGGGATGGTGACAGTTCTGGCAGCTGATGTAGAGGGGCC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TAATGAAGAACATAGACTCGAGATTCTGACAGTTTTGGCAGGCGATGCATTGGGCCCA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ATAATGAAGTGCAGTGGATGGGAATTCTGACAGCTGTGGCAGGTGATGCATTGAGCC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ATAATGAAGCGCGGGAGACAGCAGGCCTGACAGCTCTGGCAGGTGATGCATAGGGTCC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ATAATGAAGCGCGGCAGACAGCAGGCCTGACAGCTCTGGCAGGTGATGCATGGGGCC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ATAATGAAGCACACTAGACAGCAGGCCTGACAGCTCTGGCAGGTGATGCATGGGGCC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ATAATGAAGCACACTAGACAGCAGGCCTGACAGCTCTGGCAGGTGATGCATGGGGCC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-----------------------TGACAGCTCTGGCAGCTGATGCATGAGCTCCA 3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****** *  * ***  **** *      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614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BARHL2.3939</a:t>
            </a:r>
          </a:p>
        </p:txBody>
      </p:sp>
      <p:sp>
        <p:nvSpPr>
          <p:cNvPr id="7" name="Rectangle 6"/>
          <p:cNvSpPr/>
          <p:nvPr/>
        </p:nvSpPr>
        <p:spPr>
          <a:xfrm>
            <a:off x="6032206" y="872068"/>
            <a:ext cx="952500" cy="450738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6032206" y="56992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590246" y="872067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4590246" y="569995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27493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08839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1409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himp            AAAAAA-------CTGTCAGAGC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AAAAA-------CTGTCAG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AAAA-------CTGTCAG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AAAA-------CTGTCAG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AAAA-------CTGTCAG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AAAAA-------CTGTCAG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AAAA-------CTGTCAGAGGTAC--ACCACGTGTGTGAAACTAGTCGATTTCCTTAA 5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AAAAA-------CTGTCAGAGGTAT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AAAAA-------CTGTCAG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AAAAA-------CTGTCAGAGGTAC--ACCACGTGTGTGAAACTAGTCA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AAAA-------CTGTCAG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AAAA-------CTGTCAAAGGTAC--ACCACGTGTGTGAAACTAGTCG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AAAA-------CTGTCAGAGGTAC--ACCACGTGTGTGAAACTAGTCAATTTCCTTAA 51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AAAAA-------CCGGCAGCGGCAC--CCCACGTGTGGGAGAGGAGTCGATTTCCTTAA 5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-AAAA-------CTGTCAGAGGTAC--ACCACGTGTGCGAAACTAGTCGATTTCCTTAA 4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AAAAC-------CTGTCAGAGGTGC--ACCACGTGTGTGAAACTAGTCGATTTCCTTAA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AAAAAGTGGGCTCTGTCAGAAGTGGTGGGGAAGAGTGTGAAAGTAGCCGATTTTCTTA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AAGG-----TCCTGGCAATAGTGCC-AGTGCCCGTGTGAAAGTAACCGGTTTTCTTAA 52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AAGG-----TCCTGTCAAAAGCGCC-AGTGCCTGTGTGAAAGTACCCGGTTTTCTTAA 5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--AAGC-----TCCTGTCAAAAGTGGC-AGCGCCTGTGTGAAAGTAGCCGGTTTTCTTAA 5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-AAGC-----TCCTGTCAAAAGTGGC-AGCGCCTGTGTGAAAGTAGCCAGTTTTCTTAA 5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*         * * **                *** ** *  *  *  *** ***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chimp   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TCATCCCTGGAGAATGGATAAGTCTATCAATCTATTAAATTGGAAAGCCATTAGGAGGC 11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TCATCCCA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TCATCCCT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TCATCCCAGGAGAATGGATAAGTCTATCAATCTATTAAATTGGAAAGCCATTAGGAGGC 111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TCATCCCTGGAGAATGGATAAGTCTATCAATCTATTAAATTGGAAAGCCATTAGGAGGC 11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TCATCCCTGGAGAATGGATAAGTCTATCAATCTATTAAATTGGAAAGCCATTAGGAGGC 10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CATCCCTTGAGAATGGATAAGTCTATCAATCTATTAAATTGGAAAGCCATTAGGAGGC 11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CATCCCCTGGGAGCAGATAAGTCTATCAATCTGTTAGATTGGAAAGCCATTAGGTGC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TCATCCCTCAGGACCGGATAAGTCTATCAATCTGTTAAATTGGAAAGCCATTAGGTGCC 112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CATCCCTTAGGACCGGATAAGTCTATCAATCTGTTAAATTGGAAAGCCATTAGGTGCC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CATCCCCCAGGACCGGATAAGTCTATCAATCTGTTAGATTGGAAAGCCATTAGGTGCC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CATCCCCCAGGACCGGATAAGTCTATCAATCTGTTAAATTGGAAAGCCATTAGGCGCC 11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******    **   ***************** *** ***************** *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50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MX2.9711</a:t>
            </a:r>
          </a:p>
        </p:txBody>
      </p:sp>
      <p:sp>
        <p:nvSpPr>
          <p:cNvPr id="7" name="Rectangle 6"/>
          <p:cNvSpPr/>
          <p:nvPr/>
        </p:nvSpPr>
        <p:spPr>
          <a:xfrm>
            <a:off x="4216106" y="5830679"/>
            <a:ext cx="952500" cy="418235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5379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>
            <a:off x="3218646" y="53918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218646" y="872067"/>
            <a:ext cx="558800" cy="4080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4782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4216106" y="103321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18042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709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9862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378748" y="872066"/>
            <a:ext cx="7664854" cy="9879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CTTGAATTTTTCAATACTGTTAAAAATGGGGCTCTGACAGCTTA----GCGCCAGTTCA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CTTGAATTTTTCAATACTGTTAAAAATGGGGCTCTGACAGCTTA----CCGCCAGTTCA 112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CTTGAATTTTTCAATACTGTTAAAAATGGGGCTCTGACAGCTCG----CCGCCAGTGCA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CTTGAATTTTTCAATACTGTTAAAAATGGGGCTCTGACAGCTCA----CCGCCAGTGGA 112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CTTGAATTTTTCAATACTGTTAAAAATGGGGC--TGACAGATTG----CCGACAATAGG 10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CTTGAATTTTTCAATACTGTTAAAAATGGGGC--TGACAGATTG----CCGACAATAGG 11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CTTGAATTTTTCAATACTGTTAAAAATGGGGC--TGACAGATTG----CCGACAATAGG 111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CTTGAATTTTTCAATACTGTTAAAAATGGT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CTTGAATTTTTCAATACTGTTAAAAATGGGGC--TGACAGATTG----CCGACAATAGG 11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CTTGAATTTTTCAATACCGTTAAAAATGGGGC--TGACAGATTG----CCGACAATANN 11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CTTGAATTTTTCAATACAGTTAAAAATGAGTC--TGACAGATTA----CTGACAATAGC 11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CTTGAATTTTTCAATACTGTTAAAAATGAGGC--TGACAGATTGTTTGCTGGCAAAAGG 11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CCTGAATTTTTCAATACGGTTAAAAATGGGTCCGTGACAGGCGA---GCTGG-AGAGCA 11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 *************** **********   *   *****          *  *   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GGACAGGCACCGACAACGCATGGTGAGCCACCAAATTAGCAATA----CCATACATCA 16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GGACAGGCGCCGACAACGCATGGTGAGCCACCAAATTAGCAATA----CCATACATCA 16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GGACAGGCGCCGACAACGCATGGTGAGCCACCGAATTAGCAATG----CCATACATCA 16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GGACAGGCGCCGTCAACGCATGGTGAGCCACCAAATTAGCAATA----CCATACATCA 16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CAACGGGCCCAGACGCTGCGTCCGGAGCCGCTGAATTAGCAATA----CCATATATCA 16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CAACGGGCCCAGACGCGGCGTCCGGAGCCGCTGAATTAGCCATA----CCATATATCA 16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CAACGGGCCCAGACGCTGCGTCCGGAGCCGCTGAATTAGCAATA----CCATATATCA 16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CAACGGGCCCAGACGCTGCGTCCGGAGCCGCTGAATTAGCAATA----CCATATATCA 16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CAACGGGCCCAGACGCTGCGTCCGGAGCCACTGAATTAGCAATA----CCATATATCA 16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CAACGGGCCCAGAC--TGCGTCCGGAGCCGCTGAATTAGCAATA----CCATATATCA 16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CAACGGGCCCAGAC--TGCGTCCGGAGCTGCTGGATTAGCAATA----CCATATATCA 16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-AAGGGGCCAAGTC--TGCGTCCGGAGCCGCTGAATTAGCAATA----CCATATATCA 164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GCACCGGGCCCAGGCACTGCGTTCGGAGCCGCTGAATTAGCAATC----CCATATATCA 16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-TAACGGGCCCAGGCACTCCGTCCGGAGCCGCTGAATTAGCAGTA----CCATATATCA 16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GCAACGGGCTCAGGCACTGCGTCCGGAGCCGCTGAATTAGCAATA----CCATATATCA 16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ACAACGGGCCCAGGCAAGGCGTCCGGAGTCGCTGAATTAGCAATACCATCCATATATCA 17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ACCACGGGCCC-------GCGTCCGGAGCTGCCGAATTAGCACTA----CCATATATCA 1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CCGCGG-CCTAGACACTGCGTATGAAGCCGCTGAATTAGCAATA----CCATATATCA 16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CAGCGG-CCTAGACACTGCAAAGAGAGCCACTGAATTAGCAATA----CCATATATCA 165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NNNNNNNNNNNNNNNN--NNNNNNNNNNNNNNNNNAACCAGCAACG----CCATCTATCA 16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GTTCTAG-CTGAGACACAGGGAGCAGAAGCACT--ATTAACCATA----TCATATATCA 165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GGA--AGGCTCA-------TAAACAGGAACTTGGAATTAGTGGTA----GCATACATCA 16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GGGCCGCCGTAGACAGCGCACAGAGGGCCACCGAATTAGCAATA----CCATACATCA 17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     *  *           ***  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50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MX2.9741</a:t>
            </a:r>
          </a:p>
        </p:txBody>
      </p:sp>
      <p:sp>
        <p:nvSpPr>
          <p:cNvPr id="7" name="Rectangle 6"/>
          <p:cNvSpPr/>
          <p:nvPr/>
        </p:nvSpPr>
        <p:spPr>
          <a:xfrm>
            <a:off x="6565606" y="6189192"/>
            <a:ext cx="952500" cy="4562506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9316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6553200" y="108401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237946" y="872067"/>
            <a:ext cx="558800" cy="451273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5237946" y="57881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50597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20"/>
          <p:cNvSpPr/>
          <p:nvPr/>
        </p:nvSpPr>
        <p:spPr>
          <a:xfrm>
            <a:off x="0" y="0"/>
            <a:ext cx="9144000" cy="106426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8956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AGATCAATTAGCA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ATCAATTAGCA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ATCAATTAGCC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ATCAATTAGCG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ATCAATTAGCG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ATCAATTAGCG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ATCAATTAGCG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ATCAATTAGCG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ATCAATTAGCG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ATCAATTAGCGGTCTTAAGTTTATCTGATTTTTATCAAAGAA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ATCAATTAGTGGTCTTAAGTTTATCTGATTTTTATCAAAGAA---GACAGAGCTTTGG 5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ATCAATTAGCGGTCTTAAGTTTATCTGATTTTTATCAAAGAC---GACAGAGCTGTGG 5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GATCAATTAGCGGTCTTAAGTTTATCTGATTTTTATCAAAGAA---GACAGAGCTGCGG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ATCAATTAGCGGTCTTAAGTTTATCTGATTTTTATCAAAGAA---GACAGAGCTGCAG 5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ATCAATTAGTGGCCTTGGGTTTATCTGATTTTTATCAAAGAA---GACAGAGCGGCCG 57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GATCAATTAGTGGTCTTAGGTTTATCTGATTTTTATCAAAGGA---GACAGAACTGCGG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GATCAATAAGTGGTCTTAAGTTTATCTGATTTTTATCAGCGGAGTCGACAGGGGGGCA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GATCAATAAGTGGTCTTAAGTTTATCTGATTTTTATCAGCGGAGCCGACAGGGGGGCAG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GGTCGATAAGTGGTCTTAAGTTTATCTGATTTTTATCAGCGGGGCCGACAGCGGGGCA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TCGATAAGTGGTCTTAAGTTTATCTGATTTTTATCAGCGCACCCGACAGGGGGGTA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GATCGATGAGTGGTCTTAAGTTTATCTGATTTTC--CACTGG--CCGAACAGGGGACAG 5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 ** ** **  * ***  **************   **  *     **          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GTCGAC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TCGATTGTCAG-AGCCTGTGTCAAGTTGACCTTTTCAGAGATGTCTAC--ATTGCTAGT 11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TCGATTGTCAG-AGCCTGTGTCAAGTTGACCTTTTCAGAGATGTCTAC--ATTGCCAGT 11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TCGATTGTCAG-AGCCTGTGTCAAGTTGACCTTTTCAGAGATGTCTAC--ATTGCCAGT 114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TCGATCGTCAG-AGCCTGTGTCAAGCTGACCTTTTCAGAGACGTCTAC--ATCGGCCGT 11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TCGATTGGCAG-AGCCTGTGTCAAGTTGACCTTTTCAGAGACGTCTAC--ATTGCCAGT 11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TCGATGGGCTG-TGCCCGCGTCAAGTTGACCTTTTCAGGGACGACGG--GGAGAGCTCT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TCGATGGGCCG-TGCCCGCGTCAAGTTGACCTTTTCAGGGACGACGG--GGAGAGCTCT 11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TCGATGGGCTG-TGCCCGCGTCAAGTTGACCTTTTCAGGGACGCCGGCGTGAGAGCTC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TCAATGTGCTG-TGCCCGCGTCAAGTTGACCTTTTCAGGGACGTTGGTGAGAGAGCCC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TCGATGGGACGCTGCCTGTGTCAAGTTGACCTTTTCAGGG-CATAGGC-GGCCAGTTGT 11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 *      *  *** * ****** ************ * 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2126894" y="1013442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2116793" y="528302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2004001" y="872066"/>
            <a:ext cx="952500" cy="4081867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3653717" y="5691033"/>
            <a:ext cx="558800" cy="403538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378748" y="138668"/>
            <a:ext cx="2539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OXA.12003</a:t>
            </a:r>
          </a:p>
        </p:txBody>
      </p:sp>
      <p:sp>
        <p:nvSpPr>
          <p:cNvPr id="16" name="Right Arrow 15"/>
          <p:cNvSpPr/>
          <p:nvPr/>
        </p:nvSpPr>
        <p:spPr>
          <a:xfrm>
            <a:off x="2004001" y="5139511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653717" y="9988371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2073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0" name="Straight Connector 19"/>
          <p:cNvCxnSpPr/>
          <p:nvPr/>
        </p:nvCxnSpPr>
        <p:spPr>
          <a:xfrm>
            <a:off x="1913593" y="560052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378748" y="872066"/>
            <a:ext cx="7572506" cy="4154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TGGGCGCGATCAATCTTGCTCACCAAAAGCCTTGACAGCTTCTA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GGCGCGATCAATCTTGCTCACCAAAAGCCTTGACAGCTTCTA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GGCGCGATCAATCTTGCTCACCAAAAGCCTTGACAGCTTCTA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GGTGCGATCAATCTTGCTCACCAAAAGCCTTGACAGCTTCTA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GGCGCGATCAATCTTGCTCACCAAAAGCCT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GGCGCGATCAATCTTGCTCACCAAAAGCCT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GGCACGATCAATCTTGCTCACCAAAAGCCT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GGCACGATCAATCTTGCTCACCAAAAGCCTTGACAGCTTCTGGCCCTTAAGAACAC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GGCACGATCAATCTTGCTCACCAAAAGCCTTGACAGCTTCTA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GGTGTGATCAATCTTGCTCACCAAAAGCCC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GGTGCGATCAATCTTGCTCACCAAAAGCCT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GGTGCGATCAATCTTGCTCACCAAAAGCCT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GGCGCGATCAATCTTGCTCACCAAATGCCT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CGCGCGATCAATCTTGGCCGCCAAAAGGTTTGACAGCTTCTGGCCCTTAAG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CGTGTGATCAATCTTGCTTGCCAAATGGCTTGACAGCTACTGGCCCTAAAGATCAC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TGCGCGATCAATCTTACTCGCCAAAAGGTCTGACAGCTCGGTGCCCTCG-CAACA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TGCGCGATCAATCTTACTCGCCAAAAGGTCTGACAGCTCGGTGCCCTCG-CAACA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TGCGCGATCAATCTTACTCGCCAAAAGGTCTGACAGCTCGGTGCCCTCG-CAACACAT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TGCGCGATCAATCTTACTCGCCAAAAGGTCTGACAGCTCGGTGCCCTCA-CAACA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</a:t>
            </a:r>
            <a:r>
              <a:rPr lang="en-US" sz="1200" dirty="0" smtClean="0">
                <a:latin typeface="Courier New"/>
                <a:cs typeface="Courier New"/>
              </a:rPr>
              <a:t>TGCACATGATCAATCTTACTTGCCAAAAGGTCTGACCG----ACTCCCCCG</a:t>
            </a:r>
            <a:r>
              <a:rPr lang="en-US" sz="1200" dirty="0">
                <a:latin typeface="Courier New"/>
                <a:cs typeface="Courier New"/>
              </a:rPr>
              <a:t>-CAACCCAT 5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GGCGCGATCAATCTTATTCGCCAAAAGGTCTGACAGCTCCTGGCCCTTGACAACACAT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    **********     ***** *   **** </a:t>
            </a:r>
            <a:r>
              <a:rPr lang="en-US" sz="1200" dirty="0" smtClean="0">
                <a:latin typeface="Courier New"/>
                <a:cs typeface="Courier New"/>
              </a:rPr>
              <a:t>*       </a:t>
            </a:r>
            <a:r>
              <a:rPr lang="en-US" sz="1200" dirty="0">
                <a:latin typeface="Courier New"/>
                <a:cs typeface="Courier New"/>
              </a:rPr>
              <a:t>***     * * ***</a:t>
            </a:r>
          </a:p>
        </p:txBody>
      </p:sp>
      <p:sp>
        <p:nvSpPr>
          <p:cNvPr id="7" name="Rectangle 6"/>
          <p:cNvSpPr/>
          <p:nvPr/>
        </p:nvSpPr>
        <p:spPr>
          <a:xfrm>
            <a:off x="2561517" y="872066"/>
            <a:ext cx="952500" cy="415498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378748" y="138668"/>
            <a:ext cx="2539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OXA.12006</a:t>
            </a:r>
          </a:p>
        </p:txBody>
      </p:sp>
      <p:sp>
        <p:nvSpPr>
          <p:cNvPr id="12" name="Left Arrow 11"/>
          <p:cNvSpPr/>
          <p:nvPr/>
        </p:nvSpPr>
        <p:spPr>
          <a:xfrm>
            <a:off x="2561517" y="545193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Arrow 16"/>
          <p:cNvSpPr/>
          <p:nvPr/>
        </p:nvSpPr>
        <p:spPr>
          <a:xfrm>
            <a:off x="4949117" y="545701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949117" y="872067"/>
            <a:ext cx="558800" cy="415480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08403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TGAATGTCTGAATAGTCCATCGTCCGCCCCCCCATTTCTCCTAACCTTTTCTGACA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ATGAATGTCTGAATAGTCCATC-TTCTTCCCCTCGTTTCTCCTAACCCTTCCTGACA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TGAATGTCGGAATGGTCCATC-TTCTTTTGCTCATTTCTCCTAACCTTTCC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TGAATGTCTGAATAGTCCATC-TTCTTCCTCTCATTTCTC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GAATTGCTGAATGGTTGATT-TCCTGACACTCCTTTT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GAATTGCTGAATGGTTGATT-TCCTGACACTCCTTTT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TGAATTGCTGAATGGTTGATT-TCTTCACACTCCTTTT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TGAATTGCTGAATGGTTGATT-TCCTCACACTCCTTTT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ATGAATTGCTGAATGGTTGATT-TCCTCACATTCCTTTTTGCTAACCTTTCTTGGCAG 5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TGAATTGCTGAATGGTTGGTT-TCCTCACGCTCCTTTTTGCTAACCTTTCC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ATGCATTGCCGAATGGTTGATT-TCCTCACACCCCTGTT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TGAATTGCTGAATGGTTGATT-TCCTCACACCCCTTTT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GAATTGCTGAATGGCTGATT-TCCTGACACTCTTTCT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GAATTGCTGAATGGTTGATT-TCCTGACACTCTTTCTTACTAACCTTTCC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TGAATTGCTGAATGGCTGATT-TCCTCACACTCTTTCTTGT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ATGAATTGCTGAGTGGTTGATT-CCCTCACATTCCTTTTTGCTAACCTTTCG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TGAATTGCTGAATGGTTGATT-TCCTCACACT--TTCTTGCTAAGCTTTCTTGACAG 5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TGAATGGCTGCATGGTTGATT-TCTTCACACTCCTTTCTGCTAACCTTTCT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GAATTGCTGAATGGTTGATT-TCTTCACACTCCTTTTTGCTAACCTTTCTTGACA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TGAACGGCTGAGCGCCTCGTT-TCCTTAAACCATCCCGTCTTAACCTCTCCTGACAG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 *   * *         *                  *  *** *  *  ** 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48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OXD.10470</a:t>
            </a:r>
          </a:p>
        </p:txBody>
      </p:sp>
      <p:sp>
        <p:nvSpPr>
          <p:cNvPr id="6" name="Rectangle 5"/>
          <p:cNvSpPr/>
          <p:nvPr/>
        </p:nvSpPr>
        <p:spPr>
          <a:xfrm>
            <a:off x="6961114" y="872066"/>
            <a:ext cx="558800" cy="3970317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008114" y="880534"/>
            <a:ext cx="952500" cy="39618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>
            <a:endCxn id="13" idx="3"/>
          </p:cNvCxnSpPr>
          <p:nvPr/>
        </p:nvCxnSpPr>
        <p:spPr>
          <a:xfrm flipV="1">
            <a:off x="2070100" y="6189891"/>
            <a:ext cx="5449814" cy="7621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2008114" y="6051286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6961114" y="604638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44236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--------------AGTTGAAATGATTCATAGGTCTGACAGATGTCTGGTACAGCTGGAT 4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---------GAGTCAGTTGAAATGATTCATGGGTCTGACAGATGTCTGGTACAGCTGGAT 51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-----TGTCGAGCC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-----TGTCGAGCC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CTATTGTCGAACCAGTTGAAATGATTCATGGGTCTGACAGATGTCTGGTACAGCTGGAT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----TGTCGAGCC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----TGTCGAGCC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---TGTGGAGCC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CTATTGTCGAGTCAGTTGAAATGATTCATGGGTCTGACAGATGTCTGGTACAGCTGGAT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-----TGTTGAGTC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CTATTGTCGAGTCAGTTGAAATGATTCATGGGTCTGACAGATGTCTGGTACAGCTGGAT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CTATTGTCGAGCCAGTTGAGATGATTCACGGGTCTGACAGATGTCTCGTACAGCTGGAT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---TGTCGAGCCAGTTGAG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-----TGTCGAGCCAGTGGAAATGATTCATGGGTCTGACAGATGTCTGGTACAGCTGGAT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-----TGTCGAGTCCA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-----TGTCGAGCT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----TGTAAAGCTAGTTGAAATGATTCATGGGTCTGACAGATGTCTGGTACAGCTGGAT 5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-----GAGCTACTTGAAATGATTCATGGGTCTGACAGATGTCTGGTACAGCTGGAT 51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---AGTTGAAATGATTCATGGCCCTGACAGATGTCTGGTACAGCTGGAT 4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-----GCTGCTGGCTGGAGGAGTGATTCATGGGCCTGACAGATGCCTGGTGCAGCTGGAT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------TGCTGGCTGGAGGAGTGATTCATGGGCCTGACAGATGCCTGGTGCAGCTGGAT 53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---GCTGCTGGCTGGAGGAGTGATTCATGGGCCTGACAGATGCCTGGTGCAGCTGGAT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----TGCTGGCTGAAGGAGTGATTCATGGGCCTGACAGATGCCTGGTGCAGCTGGAT 5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-----------------TGATTCATTGTCCTGACAGATGCCGGGTGCAGCTGGCT 3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*******  *  ********** *  ** *******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48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OXD.10483</a:t>
            </a:r>
          </a:p>
        </p:txBody>
      </p:sp>
      <p:sp>
        <p:nvSpPr>
          <p:cNvPr id="6" name="Rectangle 5"/>
          <p:cNvSpPr/>
          <p:nvPr/>
        </p:nvSpPr>
        <p:spPr>
          <a:xfrm>
            <a:off x="5233914" y="872066"/>
            <a:ext cx="558800" cy="470897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027414" y="872066"/>
            <a:ext cx="952500" cy="470898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1975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4027414" y="6051462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5233914" y="6051462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22128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bat              TAATTCCTAG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ATTCCTAG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ATTCCTAGGTGCAGTCT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ATTCCTAG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AATTCCTAT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ATTCCTAT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ATTCCTATGTGCAGTT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ATTCCTATGTGCAGTCCAAAGTTATGATTCATTTATACT-GGAGTGACAGCATAATA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AATTCCTAT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ATTCCTAG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ATTCCTGGGTGCCA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ATTCCTGGGTGCC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ATTCCTAG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AATTCCTTGGTGCA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AATTTCTTGGTGCCGTCC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ATTCCTTGGCGCAGTCTAAAGTTATGATTCATTTATACT-GGAGTGACAGCATAATAC 11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ATTCCTTTGTGTAGCACAGAGTTATGTTTCATTTATAGC-CGAGTGACAGTATAATGC 7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AATTCCTTGGTGCAGAGCAAAGTTATGATTCATTTATACA-GGAGTGACAGCATAATGC 11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AATTCCTTGGTGCAGAGCAAAGTTATGATTCATTTACACCCGGAGTGACAGCATAATG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AATTCCTCGGTGCAGAGCAAAGTTATGATTCATTTCTAGT-GGAGTGACAGCATAATG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AATTCCTCGGTGCAGAGCAAAGTTATGATTCATTTCTACT-GGAGTGACAGCATAATG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ACTCGTTGATGCAGAGCGAAGTTATGATTCATTTATACT-GCTGTGACAGAATAATAC 61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---------AAATCATGATTCCGAAATGCA-AGAGTGCCTGCAAAATTC 3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* * *** ***             *** * * * ***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48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OXD.10498</a:t>
            </a:r>
          </a:p>
        </p:txBody>
      </p:sp>
      <p:sp>
        <p:nvSpPr>
          <p:cNvPr id="6" name="Rectangle 5"/>
          <p:cNvSpPr/>
          <p:nvPr/>
        </p:nvSpPr>
        <p:spPr>
          <a:xfrm>
            <a:off x="6224514" y="858247"/>
            <a:ext cx="558800" cy="453813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370314" y="872066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1975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4370314" y="6051462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6224514" y="6051462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42109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CCGCTGATTTATAGAGGTCTTTATGACAGAGAGGAAAATGATCTGCTGCAGGTATAA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CCGCTGATTTATAGGGGTCTTTATGACAGAGAGGAAAATGATCTG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CCACTGATTTATAGAGGTCTTTATGACAGAAAGGAAAATGATCTGCTGCAGGTATAA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CCACTGATTTATAGAGGTCTTTATGACAGAAAGGAAAATGATCTGCTGCAGA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CTC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CTGCTGATTTATAGGGCTGTTTATGACAGAAAGGAAAATTATCTTCTGCAGGTATAA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CTGCTGATTTATG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CTGCTGATTTATAGGGCTGTTTATGACAGAAAGGAAAATTATCTTCTGCAGGTATAAAT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CAGCTGATTTATAGAGTTCTTTATGACAGAAAGGAAAATTATCTTCTGCAGGTATAAA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CCTCTGATTTATTGCTCTCTTTATGACAGAGAGGAAAATGATGTGCTGCAGGTATATAT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 ********* *   * *********** ******** ** * ****** **** 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48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OXD.10521</a:t>
            </a:r>
          </a:p>
        </p:txBody>
      </p:sp>
      <p:sp>
        <p:nvSpPr>
          <p:cNvPr id="6" name="Rectangle 5"/>
          <p:cNvSpPr/>
          <p:nvPr/>
        </p:nvSpPr>
        <p:spPr>
          <a:xfrm>
            <a:off x="4211564" y="858246"/>
            <a:ext cx="558800" cy="472279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476004" y="858246"/>
            <a:ext cx="952500" cy="472279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1975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2476004" y="6038674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4211564" y="6038674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59045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114427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510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macaque          TGTCATTCATCAAAAAGTAGC--GCCCGCTCGTCATTAAG---GTACGAATGACGCTGTT 5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TCATTCATCAAAAAGTAGC--GCCCGCTCGTCATTAAG---GTACGAATGACGCTTTT 5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TCATTCATCAAAAAGTAGC--GCCCGCTCGTCATTAAG---GTACGAATGACGCTGTT 5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TCATTCATCAAAAAGTAGC--GCCCGCTCGTCATTAAG---GTACGAATGACGCTGTT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TCATTCATCAAAAAGTAGC--GCC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TCATTCATCAAAAAGTAGC--GCT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TCATTCATCAAAAAGTAGC--GCT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TCATTCATCAAAAAGTAGC--GCC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TCATTCATCAAAAAGTAGC--GCT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TCATTCATCAAAAAGTAGC--GCT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TCATTCATCAAAAAGTAGC--GCTCGCTCGTCATTAAG---GTACGAATGACGCTGTT 5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TCATTCATCAAAAAGTAGC--GCC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TCATTCATCAAAAAGTAGC--GCC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TCATTCATCAAAAAGTAGC--GCCCGCTCGTCATTAAG---GTACGAATGACGCCGTT 5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TCATTCATCAAAAAGTAGC--GC----TCGTCATTAAG---GTACGAATGACGCCGTT 51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TCATTCATCAAAAAGTAGC--GC----TCGTCATTAAG---GTAGGAATGACGCTGTT 51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TCATTCATCAAAAACTGGG--GC----TCGTCATTAAG---GTCTGAATGACGCTGTT 5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TCATTCATCAGAA-GTGCTC-GC-CGCTCGTTGTTAAAA-TGCTCG-CTGACGTCGCT 5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TCATTCATCAAAA-GTGGCT-GC-TGGTCGTTGTTAAAA-TGCTCGGCTGACGCTGCT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CATTCATCAAAA-GTGCCG-GC-GCTTCGCTGGTAAAA-CGCAGG-CTGACGTTGCT 52</a:t>
            </a:r>
          </a:p>
          <a:p>
            <a:r>
              <a:rPr lang="en-US" sz="1200" dirty="0">
                <a:latin typeface="Courier New"/>
                <a:cs typeface="Courier New"/>
              </a:rPr>
              <a:t>fugu             TGTCATTCATCAAAA-TTGGTT-GC-TATTCGTTGTTAAGA-TGCTCGGCTGACGCTGCT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GTCATTCATCAAAAAGTGGTTTGCGCCTTCGTCGTTAAAGGTGCGCG--TGACGCGGCT 5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********* **  *     **    ***    ***    *   *  *****    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macaque 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GAATAATCATTTATTGTAACAGGTTTATAAGCAAATAAATACACCCTC--CTGTCAGTG 11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GAATAATCATTTATTGTACCAGGTTTATAAGCAAATAAATACACA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GAATG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GAATAATCATTTATTGTAACAGGTTTATAAGCAAATAAATACACGT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GAATAATCATTTATTGTAACAGGTTTATAAGCAAATAAATACACGA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GAATAATCATTTATTGTAACAGGTTTATAAGCAAATAAATACACGCTC--CTGTCAGTG 11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GAATAATCATTTATTGTAACAGGTTTATAAGCAAATAAATACAAGCTC--CTGTCAGTG 10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GAATAATCATTTATTGTAACAGGTTTATAAGCAAATAAATACGAGCTC--TTGTCAGTG 10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AATAATCATTTATTGTAACAGTTTTATAAGCAAATAAATAGAGGCTC--CTGTCAGTG 10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CAATGATCATTTATTGTAACAGGTTTATCAGCAAATAAATAGGAGAGGG-CTGTCACTT 114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CAATGATCATTTATTGTAACAGGTTTATAAGCAAATAAATAGGAGAGGG-CTGTCACTT 11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CAATGATCATTTATTGTAACAGGTTTATAAGCAAATAAATAGGAGAGGG-CTGTCACTT 111</a:t>
            </a:r>
          </a:p>
          <a:p>
            <a:r>
              <a:rPr lang="en-US" sz="1200" dirty="0">
                <a:latin typeface="Courier New"/>
                <a:cs typeface="Courier New"/>
              </a:rPr>
              <a:t>fugu             CCAATGATCATTTATTGTAACAGGTTTATAAGCAAATAAATAGGAGAGGG-CTGTCACTT 11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GAATGATCATTTATTGTAACAGGTTTATAAGCAAATAAATAGGAGAGAGACTGTCATCG 11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** ************* *** ***** ************          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48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HOXD.10534</a:t>
            </a:r>
          </a:p>
        </p:txBody>
      </p:sp>
      <p:sp>
        <p:nvSpPr>
          <p:cNvPr id="6" name="Rectangle 5"/>
          <p:cNvSpPr/>
          <p:nvPr/>
        </p:nvSpPr>
        <p:spPr>
          <a:xfrm>
            <a:off x="6675364" y="6038674"/>
            <a:ext cx="558800" cy="437255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196604" y="858246"/>
            <a:ext cx="952500" cy="437255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3514" y="56895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 rot="10800000">
            <a:off x="2196604" y="5546002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33514" y="108838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Left Arrow 12"/>
          <p:cNvSpPr/>
          <p:nvPr/>
        </p:nvSpPr>
        <p:spPr>
          <a:xfrm rot="10800000">
            <a:off x="6675364" y="10740302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3839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01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opossum          GAAGGCAAAAGCCGTCTGTCAGCGATGG---TGATTGATGACACTCT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AAGGCAAAAGCCGTCTGTCAGCGATGT---TGATTGATGACACTCT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AAGGCAAAAGCCGTCTGTCAGCAATGG---TGATTGATGACACTCT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GAAGGCAAAAGCCGTCTGTCAGCGATGG---TGATTGATGACACGCG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AAGGCAAAAGCCGTCTGTCATGAC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AAGGCAAAAGCCGTCTGTCACGACTGG---TGATTGATGACAT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AAGGCAAAAGCCGTCTGTCAAGGC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AAGGCAAAAGCCGTCTGTCAAGGC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AAGGCAAAAGCCGTCTGTCAAGGC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AAGGCAAAAGCCGTCTGTCAAGGCTGG---TGATTGATGACACTCCGGGAGACTTT-AT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AAGGCAAAAGCCGTCTGTCAGGCCTGG---TGATTGATGACACTCCGGGAGACTTTTAT 5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AAGGCAAAAGCCGTCTGTCAGGGG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AAGGCAAAAGCCGTCTGTCAAGGT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AAGGCAAAAGCCGTCTGTCAAGGT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AAGGCAAAAGCCGTCTGTCAAGGTTGG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AAGGCAAAGGCCGTCTGTCAATGCTGC---TGATTGATGACACTCCGGGAGACTTT-AT 5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AAGGCAAAAGC-GTGTGTCAGGACGCG---TGATTGATGACACTCCGGGAGACTTT-AT 5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AAGGCAAAAGCCGTCTGTCAAGGCTGG---TGATTGATGACACTCCGGGAGACTTT-AT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AAGGCGAAAACCGTCTGTCATCCTGGGCCATGATTGATGACACACTGGGAGAC-TTTAT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AAGGCGAAAGCCGTCTGTCAGCCCGGGCCATGATTGATGACACTCCGGGAGAC-TTT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AAGGCGAAAGCCGTCTGTCAGCATGGGCCATGATTGATGACACTCCGCGAGAC-TTT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AAGGCAAAAGCCGTCTGTCAGCCCAGGCCATGATTGATGACACTCTGGGAGAC-TTT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AAGGCGAGAGCCGTCTGTCAGGCC-GCCTGTGATTGATGACGC-CGGCCCGCCGTTTAT 5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AAGGCAAAA-CCGACTGTCAGCAGCGG---TGATTGATGACACTCCTGGAGACTTT-AT 55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 *   * *  *****          ***********   *     * * ** 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7052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IRX1/2/4.6677 </a:t>
            </a:r>
          </a:p>
        </p:txBody>
      </p:sp>
      <p:sp>
        <p:nvSpPr>
          <p:cNvPr id="7" name="Rectangle 6"/>
          <p:cNvSpPr/>
          <p:nvPr/>
        </p:nvSpPr>
        <p:spPr>
          <a:xfrm>
            <a:off x="4603456" y="902181"/>
            <a:ext cx="952500" cy="460163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8034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4603456" y="5697217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167846" y="872066"/>
            <a:ext cx="558800" cy="46317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167846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3548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rat  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GGATGATAAATTATTAGT-AAGAAGATTTTGTTCACATTTTATT--------------- 150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G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GGATGATAAATTATTAGC-AAGAAGATTTTGTTCACA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GGATGATAAATTATTAGC-AAGAAGATTTTGTTCACATTTTATTAAATTGGCCTGTCAA 16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GGATGATAAATTATTAGC-AGGTAGATTTTGTTCACATTTTATTAAATTGGCCTGCCAA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GATGATAAATTATTAGTGAGGAAGATTTTGTTCATGTTTTATTAAATTGGCCTGTCAA 16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GGATGATAAATTATTAGTGAGGAAGATTTTGTTCATGTTTTATTAAATTGGCCTGTCAA 16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GGATGATAAATTATTAGTGAGGAAGATTTTGTTCATGTTTTATTAAATTGGCCTGTCAA 16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GGATGATAAATTATTAGTGAGGAAGATTTTGTTCATGTTTTATTAAATTGGCCTGTCAA 16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****************  * * ************  **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87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BNC2.8570 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2374606" y="872067"/>
            <a:ext cx="952500" cy="452431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>
            <a:off x="6850846" y="61157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850846" y="872067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2374606" y="6120861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3315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775459"/>
            <a:ext cx="7572506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opossum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AAGAAACCTGACAGAAAAATGTCAATGCTCA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AGAAACCTGACAGAAAAATGTCAATGCTA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AGAAACCTGACAGAAAAATGTCAATGCTA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AGAAACCTGACAGAAAAATGTCAATGCTCGAATATTTCTTCATGCATCATTAAAA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AAGAAACCTGACAGAAAAATGTCAATGCTG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AGAAACCTGACAGAAAAATGTCAATGCTC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AAGAATCCTGACAGAAATATGTCAATGCATGAATATTTCTTCATGCATCATTAAAA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AAGAAACCTCACAGTGAAACGTCAATGCTTGAATATTTCTTCATGCATCATTAAAACA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AAGAAACCTGACAGTGAAATGTCAATGCTTGAATATTTCTTCATGCATCATTAAAA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AGAAACCTGACAGTGAAATGTCAATGCTTGAATATTTCTTCATGCATCATTAAAA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AAGAAACCTGACAGTGAAATGTCAATGCTTGAATATTTCTTCATGCATCATTAAAA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AGGAACCTGACAGCCAAATGTCAATGCTGGAATATTTCTTCATGCATCATTAAAAGC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 * *** ****  * * ********   ************************* 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7052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IRX1/2/4.6679 </a:t>
            </a:r>
          </a:p>
        </p:txBody>
      </p:sp>
      <p:sp>
        <p:nvSpPr>
          <p:cNvPr id="7" name="Rectangle 6"/>
          <p:cNvSpPr/>
          <p:nvPr/>
        </p:nvSpPr>
        <p:spPr>
          <a:xfrm>
            <a:off x="5759156" y="775459"/>
            <a:ext cx="952500" cy="482007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5759156" y="56966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2837646" y="570176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837646" y="775460"/>
            <a:ext cx="558800" cy="4820070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764746" y="775460"/>
            <a:ext cx="558800" cy="4820070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764746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97459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GAGAGCCC--ACCACTGT-TGAGAAGTAATTAATCACTGTGGAGTGGGAGCTGTCAA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AATGGCCC--ACCACAGT-TGAAAAGTAATTAATCACTGTGGAGTGGGAGCTGTCAA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AATGGCCC--ACCACGGT-TGAGAAGTAATTAATCACCGTGGAGTGGGAG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AAAGGCCT--ACCACAGT-GGAGAAGTAATTAATCACCATGGAGTGGGAG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AAAAGTCC--AATGAAGC-TGAGAAGTAATTAATCATCATACAGTGGA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AAAAGTCC--AATGAAGC-TGAGAAGTAATTAATCATCATACAGTGGA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AAAAGTCC--AATGAAGC-TGAGAAGTAATTAATCATCATACAGTGGA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AAAAGTCC--AATGAAGC-TGAGAAGTAATTAATCATCATACAGTGGA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AAAAGTCC--AATGAAGC-TGAGAAGTAATTAATCATCATACAGTGGGGCCTGTCAA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AAAAGTCC--AACGAAGC-TGAGAAGTAATTAATCATC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AAAAGTCC--AATGAAGC-TGAGAAGTAATTAATCATC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AAAAGTCC--AATGAAGC-TGAGAAGTAATTAATCATC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AAAAGTCC--AATGAAGC-TGAGAAGTAATTAATCATT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AAAAGTCC--AATGAAGC-TGAGAAGTAATTAATCATT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AAAAGTCC--AATGAAGC-CGAGAAGTAATTAATCATCATACAGCGGGGCCTGTCAGA 5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GAAAAGTCC--AATGAAGC-TGAGAAGTAATTAATCATC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AAAAGTCT--AACGAAGCCTGAGAAGTAATTAATCATCATACAGTGGGGCCTGTCAAA 58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GAAAAGTCC--AATGAAGC-TGGGAAGTAATTAATCATC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AAAAGTCC--AATGAAGC-TGAGAAGTAATTAATCATC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AAAAGTCC--AATGAAGC-TGAGAAGTAATTAATCATCATACAGTGGGA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AAAAGTCC--AATGAAGC-CGAGAAGTAATTAATCATCATACAGTGGGGCCTGTCAAA 5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AAAAGTCC--AATGAAGC-TGAGTAGTAATTAATCATCATACAGTGGGGCCTGTCAA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AAAAAGCCTGGCCTCAGC-CCAGCAGCTATTAATCACTCCAGAGAGGCTCCTGTCAGA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*    *         *       **  ********      ** **   ******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7052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IRX3/5/6.7352 </a:t>
            </a:r>
          </a:p>
        </p:txBody>
      </p:sp>
      <p:sp>
        <p:nvSpPr>
          <p:cNvPr id="7" name="Rectangle 6"/>
          <p:cNvSpPr/>
          <p:nvPr/>
        </p:nvSpPr>
        <p:spPr>
          <a:xfrm>
            <a:off x="4559006" y="872066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4559006" y="56966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787346" y="872067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6787346" y="5697947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76881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-------------------CCCCGCTGCCAGCCCATTTATCTCCATGCTGTCAATTAGAG 17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------------------CCCCGCTGCCAGCCCATTTATCTCCATGCTGTCAATTAGAG 17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-------------------CCCCGCTGCCAGCCCATTTATCTCCATGCTGTCAATTAGAA 17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-----------------CCCCGCTGCCAGCCCATTTATCTCCATGCTGTCAATTAGAG 17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-------------------CCCGGCTGCCAACCCATTTATCTCCATGCTGTCAATTAGAG 17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-------------------CCCTGCTGCCAGCCCATTTATCTCCATGCTGTCAATTAGAG 17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-----------------CCCCGCTGCCAGCCCATTTATCTCCATGCTGTCAATTAGAG 17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------------------CCCCGCTGCCAGCCCATTTATCTCCATGCTGTCAATTAGAG 17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------------------TCC--CTGCCAGCCCATTTATCTCCATGCTGTCAATTAGGG 171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---------------TTCCATTGCCAGCCCATTTATCTCCATGCTGTCAATTAGAG 17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---------------------TCATCGGCAGCCCATTTATCTCCATGCTGTCAATTAGAG 18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--------------------TCATCGGCAGCCCATTTATCTCCATGCTGTCAATTAGAG 18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------------------TCATCGGCAGCCCATTTATCTCCATGCTGTCAATTAGTG 181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-------------------TCATCGGCAGCCCATTTATCTCCATGCTGTCAATTAGAG 18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CCCTCTCTCTCTCTCCTTTTTCATCGGCAGCCCATTTATCTCCATACTGTCAATTAGAG 22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-------------------GCCCATTTATCTCCATCCTGTCAATTAGAG 3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------------------TCCCACTGAAAAGCCATTTATCTCCATGCTGTCAATTAGAG 15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 ************** ******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36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LMO1.6396 </a:t>
            </a:r>
          </a:p>
        </p:txBody>
      </p:sp>
      <p:sp>
        <p:nvSpPr>
          <p:cNvPr id="7" name="Rectangle 6"/>
          <p:cNvSpPr/>
          <p:nvPr/>
        </p:nvSpPr>
        <p:spPr>
          <a:xfrm>
            <a:off x="4927306" y="872067"/>
            <a:ext cx="952500" cy="470898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4927306" y="5712999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317446" y="872067"/>
            <a:ext cx="558800" cy="470897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ight Arrow 11"/>
          <p:cNvSpPr/>
          <p:nvPr/>
        </p:nvSpPr>
        <p:spPr>
          <a:xfrm>
            <a:off x="6330146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896823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0096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85869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TGATTACTCATTTATCACACCTGGCAGCCCTGCTGAACTATAATTACTCTTCTG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TACTCATTTATCACACCTGGCAGCCCTGCT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TAGTCATTTATCACACCTGGCAGCCCTGCTGAACTATAATTACTCTTTC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TTAGTCATTTATCACACCTGGCAGCCCTGCT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ATTAGTCATTTATCACACCTGGCAGTCCTGTT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TTAGTCATTTATCACACCTGGCAGCCCTGCTGAACC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ATTAGTCATTTATCACACCTGGCAGCCCTGCT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TAGTCATTTATCACACCTGGCAGCCCTGCTT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TAGTCATTTATCACACCTGGCAGCCCTGCT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TTAGTCATTTATCACACCTGGCAGCCCTGCT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ATTAGTCATTTATCACACCTGGCAGCCCTGCTGCACTATAATTACTCTTCTCTTATCC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TTAGTCATTTATCACACCTGGCAGCCCTGCT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TTAGTCATTTATCACACCTGGCAGCATGGCCA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TAGTCATTTATCACACCTGGCAGCATGGCCGAACTATAATTACTCTTCTCTTATCC 11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ATTAGTCATTTATCACACCTGGCAGCACCGCTGAACTATAATTACTCTTCTCTTATCC 115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TTAGTCATTTATCACACCTGGCAGCCTTGCTGAACTATAATTACTCTTCTCTTATC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ATTAGTCATTTATCACACCTGGCAGCCTCAGTGAACCATAATTACTCTTCCCTTATC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ATTAGTCATTTATCACACCTGGCAGCCTCAGTGAACCATAATTACTCTTCCCTTATCC 12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ATTAGTCATTTATCACACCTGGCAGCCTCACTGAACCATAATTACTCTTCCCTTATC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TATTAGTCATTTATCACACCTGCCAGCCTGGCTGAACCATAATTACTCTGGCCTTATCC 10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**** **************** ***         ** ***********    ****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frog             T-GGTGCACTGTCATGTCCCAGAGAAGAG- 14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-GCTGCACTGTCATGTCCAAGAGGAGA-- 144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-CCTGCGCTGTCATGTCCGAGAGGAGA-- 14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CCTG-GCTGTCATGTCCGAGAGGAGAG- 14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-ATTGCACTGTCATGTCCGAGAGGAGAG- 14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-CTTGCACTGTCATGTCCGAGAGGAGAG- 145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-GC-GCACTGTCATGTCCGAGAGGAGAG- 144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-GCCGCACTGTCATGTCCGAGAGGAGAG- 14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-GCCGCACTGTCATGTCCGAGAGGAGAG- 145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-GCCGCACTGTCATGTCCGAGAGGAGA-- 14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-GCCGTACTGTCATGTCCGAGAGGAGAG- 14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-GCCGCACTGTCATGTCCGAGAGGAGAG- 14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ACGGCACTGTCATGTCCGAGAGGAGAG- 14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ACGGCACTGTCATGTCCGAGAGGAGAG- 146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GCCG-CACTGTCATGTCCGAGAGGAGAG- 143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-GCCGCACTGTCATGTCCGAGAGGAGAG- 14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CCT-GCACTGTCATGTCGGTGAGAGCGAG 14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CCT-GCACTGTCATGTCGGTGAGAGCAAG 14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CCC-ACACTGTCATGTCCATGAGAGGGAG 14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CTTCGTGCTGTCATGTC------------ 12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********** </a:t>
            </a:r>
          </a:p>
        </p:txBody>
      </p:sp>
      <p:sp>
        <p:nvSpPr>
          <p:cNvPr id="7" name="Rectangle 6"/>
          <p:cNvSpPr/>
          <p:nvPr/>
        </p:nvSpPr>
        <p:spPr>
          <a:xfrm>
            <a:off x="2654300" y="872067"/>
            <a:ext cx="952500" cy="395393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19076" y="506355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2752017" y="5469465"/>
            <a:ext cx="558800" cy="396738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19076" y="972641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78748" y="138668"/>
            <a:ext cx="2484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MAF.11498</a:t>
            </a:r>
          </a:p>
        </p:txBody>
      </p:sp>
      <p:sp>
        <p:nvSpPr>
          <p:cNvPr id="12" name="Left Arrow 11"/>
          <p:cNvSpPr/>
          <p:nvPr/>
        </p:nvSpPr>
        <p:spPr>
          <a:xfrm>
            <a:off x="2654300" y="4917501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Arrow 14"/>
          <p:cNvSpPr/>
          <p:nvPr/>
        </p:nvSpPr>
        <p:spPr>
          <a:xfrm>
            <a:off x="2752017" y="958036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155522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480157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ATCATTTATCACTGTCACC-ACATAATGATTCCCCTCGCAGCTCCTTATTGATGTTTGT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ATCATTTATCACTGTCACC-ACATAATGATTCCCCTCGCAGCTCCTTATTGATGTTTGT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ATCATTTATCACTGTCAGC-ACATAATGATTCCCCTCGCAGCTCCTTATTGATGTTTGT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ATCATCTATCACTGTCACC-ACGTAATGATTCCCCTCGCAGCT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GTCATTTATCACTGTCACA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GTCATTTATCACTGTCACA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GTCATTTATCACTGTCAG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GTCATTTATCACTGTCACC-GCATAGTGATTCCCCTTGCAGCCTCTTATTGATGTTTGT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GTCATTTATCACTGTCAG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GTCATTTATCACTGTCACC-GCATAATGATTCCCCTTGCAGCC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GTCATTTATCACTGTCACC-ACATAATGATTCCCCTTGCAGCT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GTCATTTATCACTGTCACC-GCATAATGATTCCCCTCGCAGCT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GTCATTTATCACTGTCACC-ACATAATGATTCCCCTTGCAGCTCCTTATTGATGTTTGTA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ATCATTTATCAATGTCACCCACATAATGATTCTCTCTGCAGCCTCCTATTGATGAGGAT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 ***** *****    * ** ****** *   *****  * ********    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3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MEIS1.1705</a:t>
            </a:r>
          </a:p>
        </p:txBody>
      </p:sp>
      <p:sp>
        <p:nvSpPr>
          <p:cNvPr id="6" name="Rectangle 5"/>
          <p:cNvSpPr/>
          <p:nvPr/>
        </p:nvSpPr>
        <p:spPr>
          <a:xfrm>
            <a:off x="2961632" y="858246"/>
            <a:ext cx="558800" cy="472279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988568" y="858246"/>
            <a:ext cx="952500" cy="472279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1975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Left Arrow 10"/>
          <p:cNvSpPr/>
          <p:nvPr/>
        </p:nvSpPr>
        <p:spPr>
          <a:xfrm>
            <a:off x="1988568" y="6038674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2941068" y="6038674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69229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78748" y="872066"/>
            <a:ext cx="7572506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rat              ATCATCACCCTCTTGTCAGCTGTAATAGGCTTTCCCTCAA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TCATCACCCTCTTGTCAGCTGTAATAGGCTTTCCCTCAA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TCATCATCCTCTTGTCAGATGTAATAGGCTTTCCCTCCAAAAAATAATTCATAAAAGTG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TCATCAC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TCATCACCCTCTTGTCAGCTGTAATAGGCTTTTCCCCACAGAAATAATTCATAAAACC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TCATCACCCTCTTGTCAGCTGTAATAGGCTTTTCCTCACAGAAATAATTCATAAAACTG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TCATCATCCTCTTGTCAGCTGTAATAGGCTTTTCCTCACAGAAATAATTCATAAAACCG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TCATCATCCTCTTGTCAGCTGTAATAGGCTTTTCCTCACAGAAATAATTCATAAAACTG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TCATCATCCTCCTGTCAGCTGTAATAGGCTTCTCCTCTCAGAAATAATTCATAAAGC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TCATCATTCCTCTGTCAGCTCTAATAGGCTTTTCCTGCCTCACATCACTCATACAGAC- 59</a:t>
            </a:r>
          </a:p>
          <a:p>
            <a:r>
              <a:rPr lang="en-US" sz="1200" dirty="0">
                <a:latin typeface="Courier New"/>
                <a:cs typeface="Courier New"/>
              </a:rPr>
              <a:t>fugu             ATCATCATCCCCCTGTCAGGCCTAATAGGCTTTCCTTGGTAGAAATCACTCACACAGA-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TCATCATCCCCCTGTCAGGCCTAATAGGCTTTCCTTGGTAGAAATCACTCACACAGA-G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TCATCATCCCCCTGTCAGGCCTAATAGGCTTTCCTTGGTAGAAATCACTCACACAGA-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TCATCATCCCCCTGTCAGGCCTAATAGGCTTTCCTTGGTAGAAATCAGTCACACAGA-G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  *   ******   **********  *       * ** * *** * * </a:t>
            </a:r>
            <a:endParaRPr lang="en-US" sz="1200" dirty="0" smtClean="0">
              <a:latin typeface="Courier New"/>
              <a:cs typeface="Courier New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111500" y="901698"/>
            <a:ext cx="558800" cy="474328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78748" y="138668"/>
            <a:ext cx="2346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MEIS2.965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2082800" y="5950953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ight Arrow 18"/>
          <p:cNvSpPr/>
          <p:nvPr/>
        </p:nvSpPr>
        <p:spPr>
          <a:xfrm>
            <a:off x="3111500" y="580069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848350" y="901698"/>
            <a:ext cx="952500" cy="4733897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Left Arrow 9"/>
          <p:cNvSpPr/>
          <p:nvPr/>
        </p:nvSpPr>
        <p:spPr>
          <a:xfrm>
            <a:off x="5848350" y="5800695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38705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93048" y="889000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bat              CTTAATTTTGTTCAGTACATTCTTGGGGTGATGTTCAGATTAATTGAACTGACAGTTCTC 20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TAATTTTGTTCAGTACATTCTTGGGGTGCTGTTCAGATTAATTGAACTGACAGCTCCC 203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TAATTTTGTTCAGTACATTCTTGGGGTGATGTTCAGATTAATTGAACTGACAGTTCTC 20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TAATTTTGTTCGGTACATTCTTGGG-TGATGTTCAGATTAATTGAACTGACAGTTCTC 20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TAATTTTGTTCAGTACATTCTTGGGGTGATGTTCAGATTAATTGAACTGACAGTTCTC 204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TAATTTTGTTCAGTACATTCTTGGGGTGATGTTCAGATTAATTGAACTGACAGTTCTC 20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TAATTTTGTTCAGTACATTCTTGGGGTGATGTTCAGATTAATTGAACTGACAGTTCTC 20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TAATTTTGTTCAGTACATTCTTGGGGTGATGTTCAGATTAATTGAACTGACAGTTCTC 20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TAATTTTGTTCAGTACATTCTTGGGGTGATGTTCAGATTAATTGAACTGACAGTTCTC 20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TAATTTTGTTCAGTACATTCTTGGGGTGATGTTCAGATTAATTGAACTGACAGTTCTC 20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TAATTTTGTTCAGTACATTCTTGGGGTGATGTTCAGATTAATTGAACTGACAGTTCTC 20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TAATTTTGTTCAGTACATTCTTGGGGTGATGTTCAGATTAATTGAACTGACAGTTCTC 20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TAATTTTGTTCCGTACATTCTTGGGGTGATGTTCAGATTAATTGAACTGACAGTTTTC 20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TAATTTTGTTCTGTACATTCTTGGGGTGATGTTCAGATTAATTGAACTGACAGTTTTC 20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TAATTTTGTTCAGTACATTCTTGGGGTGATGTTCAGATTAACTGAACTGACAGTTCTC 20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TAATTTTGTTCAGTACATTCTTGGGGTGATGTTCAGATTAATTGAACTGACAGTTCTC 14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TAATTTTGTTCAGTACATTCTCGGGGTGATGTTCAGATTAATTGAACTGACAGTTCTC 20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TAATTTTGTTCAGTACATTCTCAGGGTGATGTTCAGATTAATTGAACTGACAGCTTCT 19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TAATTTTGTTCAGTACATTCTCAGGGTGATGTTCAGATTAATTGAACTGACAGCTTCT 19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TAATTTTGTTCAGTACATTCTCAGGGTGATGTTCAGATTAATTGAACTGACAGCTTCT 19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TAATTTTGTTCAGTACATTCTCAGGGTGATGTTCAGATTAATTGAACTGACAGCTTCC 197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TAATTTTGTTCGGTACATTCT-GGGGTGATGTTCAGATTAATTGAAACGACAGTTCTC 1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TATTATCGCTGGCTTCATT-------TAAAGTTCCGATTAATTGAGCTGACAGCTTCT 22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* * * * *   * ****       *   **** ****** ***   *****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3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MEIS2.1042</a:t>
            </a:r>
          </a:p>
        </p:txBody>
      </p:sp>
      <p:sp>
        <p:nvSpPr>
          <p:cNvPr id="6" name="Rectangle 5"/>
          <p:cNvSpPr/>
          <p:nvPr/>
        </p:nvSpPr>
        <p:spPr>
          <a:xfrm>
            <a:off x="6616700" y="889001"/>
            <a:ext cx="558800" cy="452431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411714" y="889000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184400" y="6214446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5411714" y="6057053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Left Arrow 9"/>
          <p:cNvSpPr/>
          <p:nvPr/>
        </p:nvSpPr>
        <p:spPr>
          <a:xfrm>
            <a:off x="6616700" y="6057053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3332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78748" y="872066"/>
            <a:ext cx="7572506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orangutan        AGTT-ACCCTAATGCTCATTCATCACAG-CTGTAATGCCATTTGCAG---CT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AGTT-ACCCTAATGCTCATTCATCACAG-CTGTAATGCCATTTGCAG---CAGAGGATT 17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AGTT-ACCCTAATGCTCATTCATCACAG-CTGTAATGCCATTTGCAG---CAGAGGATT 169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AGTT-ACCCTAATGCTCATTCATCACC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cken          AGTT-ACCCTAAT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AGTT-ACCCTAATGCCCATTCATCACG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AGTT-ACCCTAACGCTCATTCATCACA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AGTT-ACCCTAATGCTCATTCATCATGG-CTGTAATGCCATTTGCAG---CAGAGGATT 16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AGTT-ACCCTAATGCTCATTCATCATAG-CTGCAATGCCATTTGGAG---AAGAG---- 163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AGTTTACCCTAATGCTCATTCATCACAGTCTGTAATGCCATTTGCAG--GCCGAGGATT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AGTTTACCCTAATGCTCATTCATCACGGGCTGTAATGCCATTTGCAG--GCCCCGGATT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ugu             AGTTTACCCTAATGCTCATTCATCACGGGCAGTAATGCCATTTGCAG--GCCGCGGATT 173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AGTTTACCCTAATGCTCATTCATCACGGGCAGTAATGCCATTTGCAG--GCCACGGATT 167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AGTTTACTCTAACGCTCATTCATCACGGGCTGTAATGCCATTTGCAGCGGCCA--GATC 153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**** ** **** ** **** *****  * * * *********** **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673600" y="901698"/>
            <a:ext cx="558800" cy="449468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78748" y="138668"/>
            <a:ext cx="2463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MEIS2.1089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2082800" y="5773153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ight Arrow 18"/>
          <p:cNvSpPr/>
          <p:nvPr/>
        </p:nvSpPr>
        <p:spPr>
          <a:xfrm>
            <a:off x="4673600" y="56449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378200" y="901698"/>
            <a:ext cx="952500" cy="4494682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3378200" y="5650327"/>
            <a:ext cx="952500" cy="275116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15176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0" y="0"/>
            <a:ext cx="9144000" cy="12242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87716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ATTTATCTTGTGTCTGTCATTTTTCTTC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TTTATCCTGTGTCTGTCATTTTTCTTC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TTTATCTTGTGTCTGTCATTTTTCTTC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TTTATCTTGTGTCTGTCATTTTTCTTCACAC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TTTATGTTGTGTCTGTCATTTTTCTTT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TTTATCTTGTGTCTGTCATTTTTCTTCACGTGATTTAAAAATAATTAATTGCTGTACTC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----------TCTGTCATTTTTTT---CATGATTTAAAAATAATTAATTGCAATACTC 4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TTTATCTTGTGTCTGTCATGTTTCTTCACATGATTTAAAAATAATTAATTGCAGTACTC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TTTATCTTGTGTCTGTCATTTTTCTTC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TTTATCTTGTGTCTGTCATTTTTCTTC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TTTATCTTGTGTCTGTCATTTTTCTTC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TTTATCTTGTGTCTGTCATTTTTGTTCACATGATTTAAAAGTA----ATTGCAGCACTC 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TTTATCTTCTGCCTGTCATTTGTCTTCACATGACTTT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TTTATCTTGTGCCTGTCATTTTTCTTCACATGATTTAAAAATAATTAATTGCAGCACTC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TTTATCTTGTGCTTGTCAGTTTTCTTCACATGACTTACAAATAATTAATTGCAGTACTC 60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---TATCTTGATCCTGTCAGTT-TCTTCTTATGACTAAAAGATAATTAATTGCAGCTCTC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TTCGTCTCTACTCTGTCATGTTCTTCG-CAGGGGTAGAAAATAATTAATTACTGCGCCC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TTTATCTCTACTCTGTCATGGTCTTCA-CACGAGTAGAAAATAATTAATTACTGCACCC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TCTCTGCCCTGTCATGTTCTTTA-CATCAGGAGAAAATAATTAATTACTCAGTCC 5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TTTATCTCTACTCTGTCATGTTCTTCAACACACATGGAAAATAATTAATTACTGCACCC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*****      *             *  **    *** *      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AGTGATGATTTATGATTTCTACTGACA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TGATGATTTATGATTTCTACTGACA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TGATGATTTATGATTTCTACTGACA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TGATGATTTATTATTTCTACTGACA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TGATGATTTATGATTTTTACTGACA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TGATGATTTATGACTTCTACTGACGTAATTAATGATACG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TTGATGATTTATGATTTTTGCTGATGTAATTAATGATACACATCAATTTTCTTT-CTTA 104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GTGATGATTTATGATTTCTACTGACG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TGATGATTTATGATTTCTACTGACG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TGATGATTTATGATTTCTACTGACG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CAATGATTCATGCTTTCTACTGACGTAATTAATGATACACATCAATTTTCCTT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TGATGATTTATGATTTCTACTGACGTAATTAATGATACACATCAATTTTTCTT-CTTA 11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AGATGATTTATGATTTCTACTGACGTAATTAATGATACACATCAATTTTTCTT-GTTA 11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AGGTGATTTATGATTTCTACTGACGTAATTAATGATACACATCAATTTTCTTC-CTTA 11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TGATGATTTATGATTTCTACTGACATAATTAATGATACACATCCATTTTCCTTTCTTA 120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--TGGTAATTTATGATTTCTACTGACAAAATTAATGCCATACATCAATTTTCTTA-CTT-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TGATGATTTATGATAT--ACTGGCATAATTAATGATACACATCAATTTTCCTG-CTTA 11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TGATGATTTATGATATT-ACTGACATAATTAAGGATACACATCAATTTTCCTG-CTTA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CTCATGATTTATGATATT-ACTGACATAATTAATGAAACACATCAATTTTCCTG-TTTA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TGATGATTTATGATATC-ACAGACGTAATTAATGATACACATCAATTTTCCTG-CTAA 11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* *** **    *   * *    ****** *  *  **** *****  *  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19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Calibri"/>
                <a:cs typeface="Calibri"/>
              </a:rPr>
              <a:t>PREDICTED: </a:t>
            </a:r>
            <a:r>
              <a:rPr lang="en-US" dirty="0">
                <a:solidFill>
                  <a:srgbClr val="000000"/>
                </a:solidFill>
                <a:latin typeface="Calibri"/>
                <a:ea typeface="Courier New"/>
                <a:cs typeface="Calibri"/>
              </a:rPr>
              <a:t>NR2F1.8107</a:t>
            </a:r>
            <a:r>
              <a:rPr lang="en-US" dirty="0" smtClean="0">
                <a:latin typeface="Calibri"/>
                <a:cs typeface="Calibri"/>
              </a:rPr>
              <a:t> </a:t>
            </a:r>
          </a:p>
        </p:txBody>
      </p:sp>
      <p:sp>
        <p:nvSpPr>
          <p:cNvPr id="7" name="Rectangle 6"/>
          <p:cNvSpPr/>
          <p:nvPr/>
        </p:nvSpPr>
        <p:spPr>
          <a:xfrm>
            <a:off x="2472437" y="5656405"/>
            <a:ext cx="952500" cy="390313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21244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>
            <a:off x="3218646" y="506639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218646" y="872067"/>
            <a:ext cx="558800" cy="390313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/>
          <p:nvPr/>
        </p:nvCxnSpPr>
        <p:spPr>
          <a:xfrm>
            <a:off x="2032000" y="995499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ight Arrow 9"/>
          <p:cNvSpPr/>
          <p:nvPr/>
        </p:nvSpPr>
        <p:spPr>
          <a:xfrm>
            <a:off x="2472437" y="981148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173687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0" y="0"/>
            <a:ext cx="9144000" cy="12242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879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--------CTTGAGTGTCAAATGTCAGACCTTGTACTATGCTGTCAAAGAGGAGAAAAGG 52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----GGGTCTTGGGTGTCAAATGTCAGGCCTTGTACTGAGCTGTCAAAGAGGAGAATAGG 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GGGTCTTGGGTGTCAAATGTCAGGCCTTGTACAGAGCTGTCAAAGAGGAGAATAGG 5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---GGGTCTTGGGTGTCAAATGTCAGGCCTTGTACTGAGCTGTCAAAGAGGAGAATAGG 5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CTGGGGTCTTG-GTGTCAAATGTCAGGCCTTGTACTAAGCTGTCAAAGAGGAGAATAGG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-CCGGGGTCTTGGGTGTCAAATGTCAGGCCTTGTACTGAGCTGTCAAAGAGAAGAATG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-CCGGGGTCTTGGGTGTCAAATGTCAGGCCTTGTACTGAGCTGTCAAAGAGAAGAATGGG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-CCGGGGTCTTGGGTGTCAAATGTCAGGCCTTGTACTGAGCTGTCAAAGAGAAGAATGGG 5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CCGGGGTCTTGGGTGTCAAATGTCAGGCCTTGTACTGAGCTGTCAAAGAGAAGAATGGG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CCGGGGTCTTGGGTGTCAAATGTCAGGCCTTGTACTGAGCTGTCAAAGAGAAGAATGGG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----GGGTCTCGGGTGTCAAATGTCAGGCCTTGTACTGAGCTGTCAAAGAGAAGAATGGG 5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---GGGTCTTGGGTGTCAAATGTCAGGCCTTGTACTGAGCTGTCAAAGAGAAGAATGGG 5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-CCAGGGTCTTGGGTGTCAAATGTCAGGCCTTGTACTGAGCTGTCAAAGAGAAGAATGGG 5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----GGGTCTTGGGTGTCAAATGTCAGGCCTTGTACTGAGCTGTCAAAGAGAAGAATGGG 5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---GGGTCTTGGGTGTCAAATGTCAGGCCTTGTACTGAGCTGTCAAAGAGAAGAATGGT 5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----GGGTCTTGGGTGTCAAATGTCAGGCCTTGTACTGAGCTGTCAAAGAGAAGAATAGC 5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----GGGTCTTGGGTGTCAAATGTCAGGCCTTGTACTGAGCTGTCAAAGAGAAGAATGGC 56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-CCAGGGTCTTGGGTGTCAAATGTCAGGCCTTGTACTGAGCTGTCAAAGAGAAGAATGGG 5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-AGGGTCCTAGGTGTCAAATGTCAGGCCTTGTACTGAGCTGTCAGAGAGAAGAATGGG 5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CCAGGGTCCTGAGTGTTAAATGTCAAGCCTTGTAGTGAGCTGTCAAAGAACAGAATA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GGGTCCTGAGTGTTAAATGTCAAGCCTTGTAGTGAGCTGTCAAAGAACAGAATAGG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CCGGGGTCGTGAGTGTTAAATGTCAAGCCTTGTAGTGAGCTGTCAAAGAGCAGAATA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-CCGGGGTCGCGAGTGTTAAATGTCAAGCCTTGTACTGAGCTGTCAGAGAACAGAATA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CCGGGGTCGTGAGTGTTAAATGTCAAGCCTTGTACTGAGCTGTCAGAGAACAGAATAGG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*    **** ********  *******    ******* ***  ****  *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frog             CT-GAGATGATTGATGACTGGAAAGGCTGAAATCCAAACCTCT--GCAGCAATTGCTTCT 109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CT-GAGATGATTGATGACTGGAAAGGCTGAAATCCAAGCCTCT--GCCAT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-GAGATGATTGATGACTGCAAAGCCTGAAATCCAAACCTCT--GCTGC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-GAGATGATTGATGACTGGAAAGCCTGAAATCCAAACCTCC--GCAGC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T-TAGATGATGGATGACTGGAGAGGCTGTAACCCAAACCTC------------------ 10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-GAGATGATTGATGACTGGGAGGCCTGAAACCCAAACCTCC--ACTGCAAATGCTTCT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-GAGATGATTGATGACTGGGAGGCCTGAAACCCAAACCTCC--ACTGCAAATGCTTCT 11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-GAGATGATTGATGACTGGGAGGCCTGAAACCCAAACCTCC--ACTGCAAATGCTTCT 11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-GTGATGATTGATGACTGGGAGGCCTGAAACTCAAACCTCC--ACTTCGAATGCTTCT 11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-GTGATGATTGATGACTGGGAGGCCTGAAACCCAAACCTCC--ACTGCAAATGCTTCT 11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A-GAGATGATTGATGACTGGGAGGCCTGAAACTCAAACCTCC--AGTGC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-GAGATGATTGATGACTGGGAGGCCTGAAACCCAAACCTCC--ACTGC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-GAGATGATTGATGACTGGGAGGCCTGAAACCCAAACCTCC--ACTGCAAATGCTTCT 11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T-GAGATGATTGATGACTGGGAGGCCTGAAACCCAAACCTCC--ACTGC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-GAGATGATTGATGACTGGGAGGCCTGAAACCCAAACCTCC--ACTGC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-GGGATGATTGATGACGGGGAGGCTTGAAACCCACACCTCC--ACTGAAAATGCTGTT 113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-GGGATGATTGATGACTGGGAGGCTTGAAACCCAAACCTCC--ACTGCAAATGCTTCT 113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-GAGATGATTGATGACTGAGAAGTCTGAAACCCAAACCTCC--ACTGCAAATGCTTCT 11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C-GAGATGATTGATGACTGGGAGGCCTGAAACCCAAACCTCC--GCTGCAAATGCTTCT 114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CCGGCATGATTGATGACTGGAGAGCCTGAAACCAAAACCTCCCAATTGCAAATGCTAC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CCGGCATGATTGATGACTGGAGGGCCCAAAACCCAAACC-CCAGATTGCAAATGCTACC 11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CCGGGATGATTGATGACTGGAGAGCCTGAAACCAAAACCTCCCAATTGCAAATGCTAC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CGGGATGATTGATGACCGCGGAGTCTGAAACCAAAACCTCCCAATTGCAAATGCTAC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CCGGCATGATTGATGACTGCGGAGTCTGAAACCAAAACCTCCCAATTGCAAATGCTACC 11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***** ****** *    *     **   *  **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87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NR2F2.8394 </a:t>
            </a:r>
          </a:p>
        </p:txBody>
      </p:sp>
      <p:sp>
        <p:nvSpPr>
          <p:cNvPr id="7" name="Rectangle 6"/>
          <p:cNvSpPr/>
          <p:nvPr/>
        </p:nvSpPr>
        <p:spPr>
          <a:xfrm>
            <a:off x="2641306" y="5988781"/>
            <a:ext cx="952500" cy="4727172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>
            <a:off x="5689306" y="56966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689306" y="872066"/>
            <a:ext cx="558800" cy="46317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/>
          <p:nvPr/>
        </p:nvCxnSpPr>
        <p:spPr>
          <a:xfrm>
            <a:off x="2032000" y="110624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ight Arrow 9"/>
          <p:cNvSpPr/>
          <p:nvPr/>
        </p:nvSpPr>
        <p:spPr>
          <a:xfrm>
            <a:off x="2641306" y="109189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4268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08839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572506" cy="8956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himp            TTTAATCAATCAAATTTGAGGCAGAAAATAGGTTTTGTCACGCCTGGTCCCGGGGTAGTG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TTAATCAATCAAATTTGAGGCAGAAAATAGGTTTTGTCACGCCTGGTCCCGGGGTAGTG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TTAATCAATCAAATTTGAGGCAGAAAATAGGTTTTGTCACGCCTGGTCCCGGGGTAGTG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TTAATCAATCAAATTTGAGGCAGAAAATAGGTTTTGTCACGCCTGGTCCCGGGATAGTG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TTAATCAATCAAATTTGAGGCAGAAAATAGGTTTTGTCACGCCTGGTCCCGGGATAGTG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TTAATCAATCAAATTTGAGGCAGAAAATAGGTTTTGTCACGCCTGGTCCCGGGGTAGTG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TTAATCAATCAAATCTGAGGCAGAAAATAGGTTTTGTCACGCCTGGTCCCGGGGTAGTG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TTAATCAATCAAATTTGAGGCAGAAAATAGGTTTTGTCACGCCTGGTCCCGGGGCGGTG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TTAATCAATCAAATTTGAGGCAGAAAATAGGTTTTGTCACGCCTGGTCCCGGGGTGGTG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TAATCAATCAAATTTGAGGCAGAAAATAGGTTTTGTCACGCCTGGTCCCGGGGTGGTG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TTAATCAATCAAATTTGAGGCAGAAAATAGGTTTTGTCACGCCTGGTCCCGGGGTGGTG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TTAATCAATCAAATTTGAGGCAGAAAATAGGTTTTGTCACGCCTGGTCCCGGGGTGG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TTAATCAATCAAATTTGAGGCAGAAAATAGGTTTTGTCACGCCTGGTCCTGGGGTAGTG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TAATCAATCAAATTTGAGGCAAAAAATAGGCTTGGTCACGCCTGGTCCTTGGGTCGTG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TTAATCAATCAAGTATGAGGCAGAAAATTGGCTTTGTCACGGCTGGGCTGTGGGTCG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TAATCAATCAAGGAGCAGGCAGAAAATAGGCTTTGTCATGGCTTGGCCCGGGGTCG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TAATCAATCAAGGAGCAGGCAGAAAATAGGCTTTGTCATGGCTTGGCCTGGGGTCGTG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TAATCAATCAAGAAGCAGGCAGAAAATAGGCTTTGTCACGGCTTGGCCTGGGGTCG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TTAATCAATCAAGAAGCAAGCAGAAAATAGGCTTTGTCATGGCCTTGCCCGGGGTCG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TTAATCAATCAAGTACGAGGCAGAAAATAGGCTTTGTCACGGCCGGGCCCGGGGTCGTG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*     * *** ***** ** ** **** * *    *   **   *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chimp            TGA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CTCTCACTCAGGCTCCTGACAGCTCCTGAA 93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CTCTCACTCG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ACTCTCACTCG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GCTCTCACTCAGGCTCCTGACAGCTCCTCA- 92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G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G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G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GCTCTCACTCAGGCTCCTGACAGCTCCTCAA 9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CTCTCACTCAGGC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CACTCACTCAGGGTC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ACAATCACACTGTCTCTTGACAGCT------ 8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TGCCTGCTCTGCCCGGTGACAGGTCTTCAA 9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ATGCCTGCTCTGCCCGGTGACAGGTCTTCAA 93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TGCCTGGTCTTCCCGGTGACAGGTCTTCAA 9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TGCCTGCTCTGCCTGGTGACAGGTCTTCAA 9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TGCTCGCTTTGCGCACTGACAGCTCCTCAA 93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                 ****** * </a:t>
            </a:r>
          </a:p>
        </p:txBody>
      </p:sp>
      <p:sp>
        <p:nvSpPr>
          <p:cNvPr id="7" name="Rectangle 6"/>
          <p:cNvSpPr/>
          <p:nvPr/>
        </p:nvSpPr>
        <p:spPr>
          <a:xfrm>
            <a:off x="2177246" y="875013"/>
            <a:ext cx="952500" cy="396368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5379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3777446" y="5830679"/>
            <a:ext cx="558800" cy="3997687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4782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8748" y="138668"/>
            <a:ext cx="2214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CST.9947</a:t>
            </a:r>
          </a:p>
        </p:txBody>
      </p:sp>
      <p:sp>
        <p:nvSpPr>
          <p:cNvPr id="17" name="Left Arrow 16"/>
          <p:cNvSpPr/>
          <p:nvPr/>
        </p:nvSpPr>
        <p:spPr>
          <a:xfrm>
            <a:off x="2266146" y="53918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Arrow 19"/>
          <p:cNvSpPr/>
          <p:nvPr/>
        </p:nvSpPr>
        <p:spPr>
          <a:xfrm>
            <a:off x="3777446" y="103347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88856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0" y="0"/>
            <a:ext cx="9144000" cy="11379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10064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-TGATTTATGTGCAGTA-AAAGGTCTTATAAAAATGATCACATACACATGAGGGATTAA 17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-TGATTTATGTGCAGTA-AAAGGTCTTATAAAAATGATCACATACACATGAGGGATTAA 171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-TGATTTATGTGCAGTA-AAAGGTCTTATAAAAATGATCACATACACATGAGGGATTAA 17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-TGATTTATGTGCAGTA-AAAGGTCTTATAAAAATGATCACATACACATGAGGGATTAA 17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-TGATTTATGTGCAGTA-AAAGGTCTTATAAAAATGATCACATACACATGAGAGATTAA 174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-TGATTTATGTGCAGTA-AAAGGTCTTATAAAAATGATCACATACACATGAGAGATTAA 17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-TGATTTATGTGCAGTA-AAAGGTCTTATAAAAATGATCACATACACATGAGAGATTAA 174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TGATT-ATGTGCAGTA-AAAG-TCTTATAAAA-TGATCACATACACATGAGAGAT-AA 6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TTGATTTATGTGCAGTA-AAAGGTCTTATAAAAATGATCACATACACATGAGAGATTAA 10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-TGATTTATGTGCAGTA-AAAGGTCTTATAAAAATGATCACATACACATGAGAGATTAA 174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-TGATTTATGTGCAGTA-AAAGGTCTTATAAAAATGATCACATACACATGAGAGATTAA 174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-TGATTTATGTGCAGTA-AAAGGTCTTATAAAAATGATCACATACACATGAGAGATTAA 17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-TGATTTATGTGCAGTA-AAAGGTCTTATAAAAATGATCACATACACATGAGAGATTAA 174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-TGATTTATGTGCAGTA-</a:t>
            </a:r>
            <a:r>
              <a:rPr lang="en-US" sz="1200" dirty="0" smtClean="0">
                <a:latin typeface="Courier New"/>
                <a:cs typeface="Courier New"/>
              </a:rPr>
              <a:t>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cken 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T-TGATTTATGTGCAGTA-AAAGGTCTTATAAAAATGATCACATACACATGAGAGATTAA 17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T-TGATTTATGTGCTGTA-AAAGGTCTTATAAAAATGATCACATACACATGAGAGATTAA 172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T-TGATTTATGTTTGGGAGAAAGGCCTTATAAAAATGATCACATACACGAAGGGGATTCA 75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  ***** ****   * * ****  ********* *************    * ***  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TGCGCAGAAGATCAATAGAAATTTCATT-CTTGACACT--AGACTGTCACCTATGGTGAA 235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TGCGCAGAAGATCAATAGAAATTTCATT-CTTGACACT--AGACTGTCACCTATGGTGAA 228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TGCGCAGAAGATCAATAGAAATTTCATT-CTTGACACT--AGACTGTCACCTATGGTGAA 235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TGCGCAGAAGATCAATAGAAATTTCATT-CTTGACACT--AGACTGTCACCTATGGTGAA 235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TGCGCAGGAGATCAATAGAAATTTCATT-CTTGACGCT--AGACTGTCACCTATGGTGAA 123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TGCGCAGGAGATCAATAGAAATTTCATT-CTTGACGCT--AGACTGTCACCTATGGTGAA 164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armadillo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cken          TGCGCT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TGCGCAGGAGATCAATAGAAATTTCATT-CTTGACGCT--AGACTGTCACCTATGGTGAA 23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TGCACAGGAGATCAATAGAAATTTCATT-CTTGACGCT--AGACTGTCACCTATGGTGAA 229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TGAGCCTCAGATCAATAGACATCCTGTTTCTCAACGCTTTGGACCATCACCGACTGTGAA 135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**  *   *********** **    ** **  ** **   ***  ***** *  *****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1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NR4A2.2390</a:t>
            </a:r>
          </a:p>
        </p:txBody>
      </p:sp>
      <p:sp>
        <p:nvSpPr>
          <p:cNvPr id="7" name="Rectangle 6"/>
          <p:cNvSpPr/>
          <p:nvPr/>
        </p:nvSpPr>
        <p:spPr>
          <a:xfrm>
            <a:off x="2196806" y="872066"/>
            <a:ext cx="952500" cy="46317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5949440" y="6215205"/>
            <a:ext cx="558800" cy="46317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Arrow 14"/>
          <p:cNvSpPr/>
          <p:nvPr/>
        </p:nvSpPr>
        <p:spPr>
          <a:xfrm>
            <a:off x="2196806" y="5683614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0" name="Straight Connector 19"/>
          <p:cNvCxnSpPr/>
          <p:nvPr/>
        </p:nvCxnSpPr>
        <p:spPr>
          <a:xfrm>
            <a:off x="2032000" y="11087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>
            <a:off x="2749256" y="6215205"/>
            <a:ext cx="952500" cy="46317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ight Arrow 21"/>
          <p:cNvSpPr/>
          <p:nvPr/>
        </p:nvSpPr>
        <p:spPr>
          <a:xfrm>
            <a:off x="2749256" y="10941445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ight Arrow 12"/>
          <p:cNvSpPr/>
          <p:nvPr/>
        </p:nvSpPr>
        <p:spPr>
          <a:xfrm>
            <a:off x="5949440" y="10936364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894400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58148" y="872066"/>
            <a:ext cx="7757202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macaque          AATTCATTGTTTTATGACAGATGGGAAAAGC-GTACATGCT-CATAGTACTGATTTATGG 40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TTCATTGTTTTATGACAGATGGGAAAAGT-GTACATGCT-CATAGTACTGATTTATGG 404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TTCATTGTTTTATGACAGATGGGAAAAGT-GTACATGCT-CATAGTACTGATTTATGG 404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TTCATTGTTTTATGACAGATGGGAAAAGT-GTACATGCT-CATAGTACTGATTTATGG 404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ATTCATTGTTTTATGACAGATGGGAAAAGT-GTACATGCT-CATAGTACTGATTTATGG 33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TTCATTGTTTTATGACAGATGGGAAAAGT-GTACATGCT-CATAGTACTGATTTATGG 40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TTCATTGTTTTATGACAGATGGGAAAAGT-GTACATGCT-CATACTACTGATTTATGG 402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ATTCATTGTTTTATGACAGATGGGAAAAGT-GTACATGCT-CATAGTACTGATTTATGG 401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TTCATTGTTTTATGACAGATGGGGAAAGT-GTACACGCT-CGTAGTCTTGATTTATGG 403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TTCATTGTTTTATGACAGATGGGGAAAGT-GTACACGCT-CGTAGTCTTGATTTATGG 403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ATTCATTGTTTTATGACAGATGGG-AAAGT-GTACATGCT-CATAGTACTGATTTATGG 403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ATTCATTGTTTTATGACAGATGGGAAAAGT-GTACATACT-CATAGTCCTGATTTATGG 40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ATTCATTGTTTTATGACAGATGGGAAAAGT-GTACATGCT-CATAGTCCTGATTTATGA 404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AATTCATTGTTTTATGACAGATGGGAAAAGT-GTACATGCT-CACAGGACTGATTTATGA 40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TTCATTGTTTTATGACAGATGGGAAAAGT-GTACATGCT-CATAGTGGAGATTTACGA 40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ATTCATTGTTTTATGACAGATGGTTAAAGT-GTACATGTT-CCCTGTCCTGATTTATGA 40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ATCATTGTTTTATGACAGATGGGAAAACTTGTGCGCTTT-CAGCGAGCTGATTTATGT 40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AATCATTGTTTTATGACAGATGGGAAAACTTGTGCACTTTTCACCGATCTGATTTATGT 39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AATCATTGTTTTATGACAGATGGGAAAACTTCTGCACTTT-CACCGACCTGATTTATGT 40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AATCATTGTTTTATGACAGATGGGAAAACTTCTGCTCTTT-CACCGCCCTGATTTATGT 40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ATCATTGTTTTATGACAGCGGGGAAAACTTCTGCACGTT-TGTGGTGCTGATTTATGT 413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AATCATTGTTTTATGACAGGCGGGAAAACTTGTGCATGTT-</a:t>
            </a:r>
            <a:r>
              <a:rPr lang="en-US" sz="1200" dirty="0" smtClean="0">
                <a:latin typeface="Courier New"/>
                <a:cs typeface="Courier New"/>
              </a:rPr>
              <a:t>CATACTGGTGATTTATGA </a:t>
            </a:r>
            <a:r>
              <a:rPr lang="en-US" sz="1200" dirty="0">
                <a:latin typeface="Courier New"/>
                <a:cs typeface="Courier New"/>
              </a:rPr>
              <a:t>25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*****************  **  ***    * *    *          ******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79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AX1.10260</a:t>
            </a:r>
          </a:p>
        </p:txBody>
      </p:sp>
      <p:sp>
        <p:nvSpPr>
          <p:cNvPr id="7" name="Rectangle 6"/>
          <p:cNvSpPr/>
          <p:nvPr/>
        </p:nvSpPr>
        <p:spPr>
          <a:xfrm>
            <a:off x="6857706" y="872066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3114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3579792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6857706" y="61183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3579792" y="61183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327340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/>
          <p:cNvSpPr/>
          <p:nvPr/>
        </p:nvSpPr>
        <p:spPr>
          <a:xfrm>
            <a:off x="0" y="0"/>
            <a:ext cx="9144000" cy="9550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71096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CCACCAGATCAGGCAATCAATAGGGGCAGCAGATATCATATATCACCTCT--CTGCGGGC 232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CACCAGATCAGGCAATCAATAGGGGCAGCAGATATCATATATCACCTCT--CTGCGGGC 232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CACCAGATCAGGCAATCAATAGGGGCAGCAGATATCATATATCACCTCT--CTGCGGGC 232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CACCAGATCAGGCAATCAATAGGGGCAGCAGATATCATATATCACCTCT--CTGCGGGC 232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CACCAGATCAGGCAATCAATAGGGGCAGCAGATATCATATATCACCTCT--CTGCGGGC 20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CACCAGATCAGGCAATCAATAGGGGCAGCAGATATCATATATCACCTCT--CTGCGGGC 232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CACCAGATCAGGCAATCAATAGGGGCAGCAGATATCATATATCACCTCT--CTGCGGGC 232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CCACCAGATCAGGCAATCAATAGGGGCAGCAGATATCATATATCACCTCT--CTCCGGGC 212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CACCAGATCAGGCAATCAATAGGGGCAGCAGATATCATATATCACCTCT--CTCCGTGC 223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CACCAGATCAGGCAATCAATAGGGCTAGCACATATCATATATCATCGCT--CCCAGTGC 211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CACAAGATCAGGCAATCAATAGGGCCT-TGCATATCATACATCACC-CA--CT----GC 20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GCTGGATCAGGCAATCAATAGCAGCCTTGCATATCATATATCACCGCAGCCTC---GC 23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GCTGGATCAGGCAATCAATAGCGGCCTTGCATATCATATATCACCACAGGCTC---GC 23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GGCGGATCAGGCAATCAATAGCGGCCTTGCATATCATATATCACCGCCGGCTC---GC 23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GAGCAGATCAGGCAATCAATAGCGGCCTTGCATATCATATATCACCGCTGGCTC---GC 23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CACCAGATCAGGCAATCAATAGGGGCCTTGCATATCATATATCACTACGCTCTC---GC 23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    *****************         ******** ****   *   *     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CGGGGAGAGAGCACCATAATCTCTCGCAAATTTAGAGTGACAGATTTGT-CAAGATCTGA 291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GGGGAGAGAGCACCATAATCTCTCGCAAATTTAGAGTGACAGATTTGT-CAAGATCTGA 291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GGGAGAGAGCACCATAATCTCTCGCAAATTTAGAGTGACAGATTTGT-CAAGATCTGA 291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GGGAGAGAGCACCATAATCTCTCGCAAATTTAGAGTGACAGATTTGT-CAAGATCTGA 291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GGGAGAGAGCACCATAATCTCTCGCAAATTTAGAGTGACAGATTTGT-CAAGATCTGA 26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GGGAGAGAGCACCATAATCTCTCGCAAATTTAGAGTGACAGATTTGT-CAAGATCTGA 291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GGGAGAGAGCGCCATAATCTCTCGCAAATTTAGAGTGACAGATTTGT-CAAGATCTGA 291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TGGGGAGAGAGCACCATAATCTCTCGCAAATTTAGAGTGACAGATTTGT-CAAGATCTGA 271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GGGAGAGAGCACCATAATCTCTCGCAAATTTAGAGTGACAGATTTGT-CAAGATCTGA 282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AGAAAGGGAGCGCCATAATCTCTCGCAAATTTAGACTGACAGATTTGT-CGTGATCTGA 27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AGAGGAGAAC---ATAATCTGCAGCAAATTTAGAATGACAGATTTGT-TGGTATCTGA 26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CAGGAGAGAAC---ATAATCTGCTGCAAATTTAGAATGACAGATTTGTATGGGAGCTAA 29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CAGGAGAGAAC---ATAATCTGCTGCAAATTTAGAATGACAGATTTGTATGAGCGCTAA 292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CAGGAGAGAAC---ATAATCTGCTGCAAATTTAGAATGACAGATTTGTATGGGAGCTAA 29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CAGGAGAGAAC---ATAATCTGCTGCAAATTTAGAATGACAGATTTGTACGGGAGCTAA 29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GAGGAGAGAAC---ATAATCTGCTGCAAATTTAGAATGACAGATTTGTAAGGGAGC--- 28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* ** *   *******   *********** ************      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261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AX2</a:t>
            </a:r>
            <a:r>
              <a:rPr lang="en-US" dirty="0"/>
              <a:t>A</a:t>
            </a:r>
            <a:r>
              <a:rPr lang="en-US" dirty="0" smtClean="0"/>
              <a:t>.90</a:t>
            </a:r>
          </a:p>
        </p:txBody>
      </p:sp>
      <p:sp>
        <p:nvSpPr>
          <p:cNvPr id="6" name="Rectangle 5"/>
          <p:cNvSpPr/>
          <p:nvPr/>
        </p:nvSpPr>
        <p:spPr>
          <a:xfrm>
            <a:off x="5384800" y="4787899"/>
            <a:ext cx="558800" cy="308610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97328" y="893233"/>
            <a:ext cx="952500" cy="3170767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4446093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Left Arrow 14"/>
          <p:cNvSpPr/>
          <p:nvPr/>
        </p:nvSpPr>
        <p:spPr>
          <a:xfrm>
            <a:off x="5197328" y="4300043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Connector 15"/>
          <p:cNvCxnSpPr/>
          <p:nvPr/>
        </p:nvCxnSpPr>
        <p:spPr>
          <a:xfrm>
            <a:off x="2070100" y="8122496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Left Arrow 10"/>
          <p:cNvSpPr/>
          <p:nvPr/>
        </p:nvSpPr>
        <p:spPr>
          <a:xfrm>
            <a:off x="5384800" y="7981703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0607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3231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rat              ACAATCTCG--GTGCTGACAGC--CGAGT---GGGTGATAAATGC-CGGCGACGCGGGGA 52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CAATCTCG--GCGCTGACAGC--CGAGT---GGGTGATAAATGC-CGGCGACGCGGGGA 52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CAATCTCG--GCGCTGACAGC--CGAGC---AGGTGATAAATGC-CGGCGACGCGGGGA 52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CAATCTCG--GCGCTGACAGG--CGAGC---GGGTGATAAATGC-CGGCGACGCGGGGA 52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CAATCTCG--GCTCTGACAGC--CGAGC---GGGTGATAAATGC-CGGCGACGCGGGGA 52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CAATCTCG--GCGCTGACAGC--CGAGC---GGGTGATAAATGC-CGGCGACGCGGGGA 52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CAATTTGG--GCGCTGACAGC--CGAGG---GGGTGATAAATCC-TGGCGACGAGGGGA 52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CAATGTCG--TAGCTGTCAAT--CGAGC---CGGTGATATATTC-GTGCGACGCGGGGA 52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CAATCTCG--CCGCTGACAGC--AGCGC---GGGTGATAAATGC-CCGCGACGCGGGGA 5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CAATCTCCATTAGGTGACAGCGCCCCGG-CAGGTTGATAAATGCTCCCTGACGAAAC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CAATCTCCATTAGGTGACAGCGCCCCGG-CAGGTTGATAAATGCTCCCTGACGAAAGGG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CAATCTCCATTAGGTGACAGCGCCCCGG-CAGGTTGATGAATGCTCCCCGGCGAAAGGG 5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CAATCTCCATTAGCTGACAGC---CAGG-CAGGTTGATAAATGC-CCACAACGAAAGGG 55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CAATCTCCATTAAGC-ACGGCA---------GTGTGATAAATGTCCC-TGGCGATGGG- 4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CAATCTCCATTAGATGACGGCGCCGGGGTCTGGGTGATAAATGCCCCCTGACGGTGGGG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CAATCTCCATTAGCTGACAG----GCAGGCAGGGTGATAAATGCCCC-CGACGAAGGGG 55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 *           *                ****  **         **   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78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AX2</a:t>
            </a:r>
            <a:r>
              <a:rPr lang="en-US" dirty="0"/>
              <a:t>A</a:t>
            </a:r>
            <a:r>
              <a:rPr lang="en-US" dirty="0" smtClean="0"/>
              <a:t>.135</a:t>
            </a:r>
          </a:p>
        </p:txBody>
      </p:sp>
      <p:sp>
        <p:nvSpPr>
          <p:cNvPr id="6" name="Rectangle 5"/>
          <p:cNvSpPr/>
          <p:nvPr/>
        </p:nvSpPr>
        <p:spPr>
          <a:xfrm>
            <a:off x="3390900" y="918632"/>
            <a:ext cx="558800" cy="308610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97328" y="893233"/>
            <a:ext cx="952500" cy="3170767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4446093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Right Arrow 19"/>
          <p:cNvSpPr/>
          <p:nvPr/>
        </p:nvSpPr>
        <p:spPr>
          <a:xfrm>
            <a:off x="5197328" y="4302583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Arrow 20"/>
          <p:cNvSpPr/>
          <p:nvPr/>
        </p:nvSpPr>
        <p:spPr>
          <a:xfrm>
            <a:off x="3390900" y="4302583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636110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154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GCCAGCCCAAACACATGATAAATTGCCT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GTCAGCCCAAACACATGATAAATTGCCCTGTCAACAGAATTCATTCAGGGACCA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GTCAGCCCAAACACATGATA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CTGTCAACCCAAACACATGATAAATTGCCCTGTCAACAGAATC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GTCAACCCAAACACATGATAAATTGCCCTGTCAACAGAATTCATTCAGGGACCA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GTCAGGCCAAACACATGATG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GTCAGGCCAAACACATGATGAATTGCCCTGTCAACAGAATTCATTCAGGGACCA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GTCAGGCCAAACACATGATGAATTGCCCTGTCAACAGAATTCATTCAGGGACCA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GTCAGGCCAAACACATGATGAATTGCCCTGTCAACAGAATTCATTCAGGGACCA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GTCAGGCCAAACACATGATGAATTGCCCTGTCAACAGA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TGTCAGGCCAAACACATGATGAATTGCCCTGTCAACGGT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GTCAAGCCAAACACATGATAAATTGCTCTGTCAACGGTATTCATTCAGGGACCAATT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 **  ************* ******  ******* * ** *******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78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AX2</a:t>
            </a:r>
            <a:r>
              <a:rPr lang="en-US" dirty="0"/>
              <a:t>A</a:t>
            </a:r>
            <a:r>
              <a:rPr lang="en-US" dirty="0" smtClean="0"/>
              <a:t>.174</a:t>
            </a:r>
          </a:p>
        </p:txBody>
      </p:sp>
      <p:sp>
        <p:nvSpPr>
          <p:cNvPr id="6" name="Rectangle 5"/>
          <p:cNvSpPr/>
          <p:nvPr/>
        </p:nvSpPr>
        <p:spPr>
          <a:xfrm>
            <a:off x="2006600" y="872066"/>
            <a:ext cx="558800" cy="415498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571728" y="872066"/>
            <a:ext cx="952500" cy="415498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551398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Right Arrow 19"/>
          <p:cNvSpPr/>
          <p:nvPr/>
        </p:nvSpPr>
        <p:spPr>
          <a:xfrm>
            <a:off x="3571728" y="5370479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4663928" y="872066"/>
            <a:ext cx="558800" cy="415498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ight Arrow 17"/>
          <p:cNvSpPr/>
          <p:nvPr/>
        </p:nvSpPr>
        <p:spPr>
          <a:xfrm>
            <a:off x="4663928" y="537047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ight Arrow 21"/>
          <p:cNvSpPr/>
          <p:nvPr/>
        </p:nvSpPr>
        <p:spPr>
          <a:xfrm>
            <a:off x="2006600" y="535777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679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9144000" cy="112776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378748" y="872066"/>
            <a:ext cx="7664854" cy="85869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macaque  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CTTCAGGCA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CTTCAGGCA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CTTCAGGCA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CTTCAGGCAC-TC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CTTCAGGCA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CTTCAGGCG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CTTCAGGCAC-TGCTGTCAAGTGTTATTCAAATAATAC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CTTCAGGCAC-TGCTGTCAAGAGTTATTCAAATAACACCAGCCTCACATTTGAATAAC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CTTCAGGCGT-CGCTGTCAAGTGTTATTCAAATAACATCAGCCGCACATTTGAATAAC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CTTCAGGCGT-CGCTGTCAAGTGTTATTCAAATAACATCAGCCTCACATT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CTTCAGGCAT-CGCTGTCAAGTGTTATTCAAATAACACCAGCCTCACATTTGAATAAC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CTTCAGGCATTCGCTGTCAAGTGTTATTCAAATAGCGCCAGCCTCATATTTGAATAAC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CTTCAGGCAG-CGCTGTCAAGTACTATTCAAATAACACCAGCCTCGCTTGTGAATAACA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     ********   **********    ***** *   * ******** </a:t>
            </a:r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macaque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CAGACATTC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CAGACATTTTGAATTAATTAATCAGATGAGATAGTCTAGGCC-TC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CAGACATTTTGAATTAATTAATCAGATGAGATAGTCTG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CAGACATTTTGAATTAATTAATCAGATGAGATAGTT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CAGACATTTTGAATTAATTAATCAGATGAGATAGTCTAGGCC-TTTTCTCATTAGTCTC 11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CAGACATTTTGAATTAATTAATCAGAGGAGATAGTCCAGGGC-TTTTCTCATTAGTCTT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CCGACATTTTGAATTAATTAATCAGACAAGATAGTC-TGGGCCTTTTCTCATTAGTCTA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CCGGCATTTTGAATTAATTAATCAGACAAGATAGTC-GGGCCTTTTTGTCATTAGTCTA 11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CCGACATTTTGAATTAATTAATCAGACAAGATAGTC-TGGGCCTTTTCTCATTAGTCTA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CCGACATTTTGAATTAATTAATCAGCCGAGATCGTCCAGGGCCTTTTCTCATTAGCGGA 12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CAGACATTTTGAATTAATTAATCAGCTGAGATAGCTCGATCCCTCTTCTCATTAGTCTG 11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* **** ****************   **** *       * * ** *******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1846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79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BX3B.3200</a:t>
            </a:r>
          </a:p>
        </p:txBody>
      </p:sp>
      <p:sp>
        <p:nvSpPr>
          <p:cNvPr id="6" name="Rectangle 5"/>
          <p:cNvSpPr/>
          <p:nvPr/>
        </p:nvSpPr>
        <p:spPr>
          <a:xfrm>
            <a:off x="3302000" y="872067"/>
            <a:ext cx="558800" cy="39274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359150" y="5448299"/>
            <a:ext cx="952500" cy="411589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99440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Left Arrow 10"/>
          <p:cNvSpPr/>
          <p:nvPr/>
        </p:nvSpPr>
        <p:spPr>
          <a:xfrm>
            <a:off x="3359150" y="9780093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Connector 15"/>
          <p:cNvCxnSpPr/>
          <p:nvPr/>
        </p:nvCxnSpPr>
        <p:spPr>
          <a:xfrm>
            <a:off x="2070100" y="51180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Left Arrow 12"/>
          <p:cNvSpPr/>
          <p:nvPr/>
        </p:nvSpPr>
        <p:spPr>
          <a:xfrm>
            <a:off x="7061200" y="4971962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302000" y="4959262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7035800" y="872067"/>
            <a:ext cx="558800" cy="39274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666772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9144000" cy="9550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378748" y="872066"/>
            <a:ext cx="7664854" cy="8032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CACTGTTAGACATTATAAATCAAAAGTGTCAGGATTTAGTAATGTTTATAGCC-AGCCA 43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CACTGTTAGACATTATAAATCAATAGTGTCAGAATTTAGTAATGTTTATCGCC-ATCCA 43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CACTGTTAGACATTATAAATCAATACTGTCAGGATTTAGTAATGTTTATCACC-AGCCC 44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CACTGTTAGACATAATAAATCAATAGTGTCAGAATTTGGGAATGTTTG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CACTGTTAGACATAATAAATCAATAGTGTCAGAATTTGGG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CACTGTTAGACATAATAAATCAATAGTGTCAGAATTTGGTAATGTTTATAGCT-AGC-A 435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CACTGTTAGACATAATAAATCAATAGTGTCAGAATTTGGT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CACTGTTAGACATCATAAATCAATAGTGTCAGAATTTGGTAATGTTTATAGCT-TGC-A 43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CACTGTTAGATATAATAAATCAATAGTGTCAGAATTTGGT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CACTGTTAGACATAATAAATCAATAGTGTCAGAATTTGGTAATGTTTATAGCT-AGC-A 433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CACTGTTAGACATAATAAATCAATAGTGTCAGAATTTGGT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CACTGTTAGACATAATAAATCAATAGTGTCAGAATTTGGT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CACTGTTAGACATAATAAATCAATAGTGTCAGAATTTGGT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CACTGTTAGACATAATAAATCAATAGTGTCAGAATTTGGT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CACTGTTAGACATAATAAATCAATAGTGTCAGAATTTGGTAATGTTTATAGCT-AGC-A 43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CACTGTTAGACATAATAAATCAATAGTGTCAGAATTTGGTAATGTTTATAGCT-AGC-A 43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CACTGTTAGACATAATAAATCAATAGTGTCAGAATTTGGTAATGTTTATAGCT-AGC-A 42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CAGTGTTAGCCGTTATAAATCAATAGTGTCAGGATTTGGTAATGTTTATAGCAGAGCCA 52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 ******   * ********* * ****** **** * ******* *  *    *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GGTTTATTATTTCATGTGACTGTCATGGACAAATAGTATTTATCATAGCTGTCTATGAA 49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GTTTATT---TCATGTGACTGTCATGGGCAAATAGTATTTATCATAGCTGTGTATGAA 49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CTTTATTATTTCATATGACTGTCATGGACAAAGAGTATTTATCATAGCTGCCTATAAA 50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TGTTTATTATTTCATATGACTGTCATGTACAAATAGTGGTTATCATGGT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TGTTTATTATTTCATATGACTGTCATGTACAAATAGTGGTTATCATGGT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GTTTATTATTTCATATGACTGTCATGTATAAATAGTGGTTATCATGGTTGCCTCTAAA 495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GTTTATTATTTCATATGACTGTCATGTACAAATAGTGGTTATCATGGT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GGTTTATTATTTCATATGACTGTCATGTACAAATAGTGGTTATCATGGCTGCCTCTAAA 49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GTTTATTATTTCATATGACTGTCATGTACAAATAGTGGTTATCATGGT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GGTTTATTATTTCATATGACTGTCATGTACAAATAGTGGTTATCATGGCTGCCTCTAAA 493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GTTTATTATTTCATATGACTGTCATGTACAAATAGTGGTTATCATGGC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GTTTATTATTTCATATGACTGTCATGTACAAATAGTGGTTATCATGGC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GTTTATTATTTCATATGACTGTCATGTACAAATGGTGGTTATCATGGC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GTTTATTATTTCATATGACTGTCATGTACAAATGGTGGTTATCATGGCTGCC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GTTTATTATTTCATATGACTGTCATGTACAAATAGTGGTTATCATGGCTACCTCTAAA 49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GTTTATTATTTCATATGACTGTCATGTACAAATAGTGGTTATCATGGCTGCTTCTAAA 49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GTTTATTATTTCATATGACTGTCATGTACAAATAGTGGTTATCATGGCTGCCTCTAAA 48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GTTTATTATTTCATGTGACTGTCATGGACAAATAGTATTTATCATAGCTGTCTATAAA 58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******   **** ***********   ***  **  ******* * *   * * **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1846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79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BX3B.3211</a:t>
            </a:r>
          </a:p>
        </p:txBody>
      </p:sp>
      <p:sp>
        <p:nvSpPr>
          <p:cNvPr id="6" name="Rectangle 5"/>
          <p:cNvSpPr/>
          <p:nvPr/>
        </p:nvSpPr>
        <p:spPr>
          <a:xfrm>
            <a:off x="3854450" y="5258981"/>
            <a:ext cx="558800" cy="364605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181350" y="868769"/>
            <a:ext cx="952500" cy="3601632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923680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070100" y="4863924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3860800" y="909075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Left Arrow 10"/>
          <p:cNvSpPr/>
          <p:nvPr/>
        </p:nvSpPr>
        <p:spPr>
          <a:xfrm>
            <a:off x="3181350" y="4717874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308813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orse 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TATATTCATGACCC----AGCTTGATTGATGGAAGGACAGTGTTTGGTGACACTGTTA 5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TATATTCATGACCC----AGCTTGATTGATGGAAGGACAGTGTTTGGTGACATTGTCA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TATATTCATGACCC----G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TATATTCATGAT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TATATTCATGACCC----AA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TATATTCATGACCC----AGCTTGATTGATGGAAGGACAGT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TATATTCATGACCC----AGCTTGATTGATGGAAGGACGGCGTTTG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TATATTCATGACCC----AGGGTGATTGATGGAAGGACAGCGATTGTTGACACTGTCA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TATATTCATGACCTCCT-GACTTGATTGATGGAAGGATAGCATTTGGTGACA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TATATTCATGACCCCCTTGACTTGATTGATGGAAGGATAGCATTTGGTGACACTGT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TATATTCATGACCCCCTCCACTTGATTGATGGAAGGATAGCATTTGGTGACACTGT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TATATTCATGACCCCCCAGACTTGATTGATGGAAGGATAGCGTTTGGTGACACTGTCA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TATATTCATGACCC----AGTGTTATTGATGGAAGAATGGCTTTCAGTGACACTGTCA 5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* *         * *********** *  *   *   ***** ***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79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BX3B.3213</a:t>
            </a:r>
          </a:p>
        </p:txBody>
      </p:sp>
      <p:sp>
        <p:nvSpPr>
          <p:cNvPr id="6" name="Rectangle 5"/>
          <p:cNvSpPr/>
          <p:nvPr/>
        </p:nvSpPr>
        <p:spPr>
          <a:xfrm>
            <a:off x="6959600" y="872067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205214" y="872067"/>
            <a:ext cx="952500" cy="452431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19751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4205214" y="6038674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6985000" y="6033593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208771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at     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TCTGCACACTGCTGTCAGCT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TCTGCACACC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TCTGCACACCGCTGTCAGCCTGTGATGGATTCCTCACTTACTTCAATGAATGTTCTAAC 11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TCTGCA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TCTGCACG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TCTACGCACTGCTGTCAGCCC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TCTGCGCACTGCTGTCAGCCTGTGATGGATTCCTCACTTAC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TCTGCACATTGCTGTCAGCCCGTGATGGGTTTCTCACTCACTGCAATGAATGTTCGAAC 11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TCTGCACATTGCTGTCACGTCTTGATGGATTTCTCACTTAGTTCAATGAATGTTCTAAC 11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TGAGCAGGGAGCTGTCAGCGGGTGATGGATCTCTCACTTACTTCAATGAATGTTCTAAC 11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TCTAAAGTGTGCTGTCACCGCTTGATGGATTTCTCACTTAGTTCAATGAATGTTCTAAC 11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TCTACTGTTTCCTGTCAGCCTTTGATGGATTCCTCACTTAGTCCAATGAATGGTCTAAT 114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TCTTCAGCTTCCTGTCAGCTTTTGATGGATTCCTCACTTAGTTCAATGAATGGTCTAA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TCTGCAGCTCCCTGTCAGCTTTTGATGGATTCCCCACTTAGTTCAATGAATGGTCTTCT 11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         ******     ****** *  * **** * * ********* 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80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BX3B.3244</a:t>
            </a:r>
          </a:p>
        </p:txBody>
      </p:sp>
      <p:sp>
        <p:nvSpPr>
          <p:cNvPr id="6" name="Rectangle 5"/>
          <p:cNvSpPr/>
          <p:nvPr/>
        </p:nvSpPr>
        <p:spPr>
          <a:xfrm>
            <a:off x="3111500" y="893233"/>
            <a:ext cx="558800" cy="431848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116314" y="872067"/>
            <a:ext cx="952500" cy="433964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5741493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4116314" y="5582655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111500" y="5595443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035995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154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himp            GATGATGAATGCGG-CGAGGCCTGGGCTGGGGCCTGCCAACT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ATGATGAATGCGG-CGAGGCCTGGGCTGGGGCCTGCCAACT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ATGATGAATGCGG-CGGGGCCTGGGCTGGGGCCTGCCAACT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ATGATGAATGCGG-CGAGGCCTGGGCTGAGGCCTGCCAACTAGGCCTCGCTGGCTGTC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ATGATGAATGCGG-CGAGGCCTGGGCTGGGGCCTGCCAACTAGGCCG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ATGATGAATGCGGGCGAGGCCTGGGCTGGGGCCTGCCAACTAGGCCTCGCTGGCTGTC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ATGATGAATGCGG-GGAGGCCCGGGCTGGGGCCTGCCAACT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ATGATGAATGCGG-CCAGGCCTGGGTTGGGGCCTGCCAACG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ATGATGAATGCTG-CAAGGCCTGGGTTGGGGCCTGCCAACT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ATGATGAATGCAG-CGAGGCC-GGGTTGGGGCCTGCCAACTAGGCCTCGCTGGCTGTCA 5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ATGATGAATGCGG-CGAGGCCCTGGCTGGGGCCTGCCAACG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ATGATGAATGCGG-CGAGGCCCTGGCTGGGGCCTGCCAACGAGGCCTC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ATGATGAATGCGG-CGAAGCCG-GGCTGCGGC-TGCCAACTAGGCCTCGCTGGCTGTCA 5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ATGATGAATGCGG-CACGGCCTGGGCCGGGGC-TGCCAACTAGGCCTCGCTGGCTGTCA 5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ATGATGAATGCTG-CACGGCCCAGGCTGGGGCCTGCCAACTAGGCCTT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ATGATGAATGCGC-CCTGGCCCAAGTTGGAGCCTGCCAACTAGGCCTTGC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ATGATGAATGCGT-TGCAGCCGCCACTGAATCCTGCCAA---AGCCTCGCTGGCTGCCA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ATGATAAAT-TGGTGGATGCCCAGGTTAGTGGCTGCCAAGGATGCCTCTTTGGCTGTC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ATGATAAAT-TGTTGGACGTCCAGGTTAGCGGCTGCCAAGGAGGCCTCTTTG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ATGATGAAT-TAGTGGATGCCCGGGTTCCTGGCTGCCAAGGAGGCCTCTTTGGCTGTC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ATGATGAAT-AGTCCTATGGCTGCACCAGTGGCTGCCAACGAGGCCTCTCATGCTGTCA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 ***         * *            ******    ***      **** 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79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BX3B.3253</a:t>
            </a:r>
          </a:p>
        </p:txBody>
      </p:sp>
      <p:sp>
        <p:nvSpPr>
          <p:cNvPr id="7" name="Rectangle 6"/>
          <p:cNvSpPr/>
          <p:nvPr/>
        </p:nvSpPr>
        <p:spPr>
          <a:xfrm>
            <a:off x="2180541" y="872066"/>
            <a:ext cx="952500" cy="415498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2180541" y="5692136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946900" y="872066"/>
            <a:ext cx="558800" cy="415498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6946900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8026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macaque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ATCTGGTAAAATGGTACCATATCGGAGCTGTCTGTTGTGGTATTCATCATGCTGTCA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TCTGGTAAAATGGTACCATATTGGAGCTGTCTGTTGTGG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TCTGGTAAAATGGTACCATATTGGAGCTGTCTGTTGTGGTATTCATCACACTGTCAC 11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CTGGTAAAATGGTACCATATTGGAGCTGTCTGTTGTGGTATTCATCACTCTGTCAC 11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ATCTGGTAAAATGGTACCATATTGGAGCTGTCTGTTGTGGTATTCATCATA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CTGGTAAAATGGTACCATATTGGAGCTGTCTGTTGTGGTATTCATCATGCTGTCA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GATCTGGTAAAATTGTCCCATATTGGAGCTGTCTGTTGTGATATTCATCATGCTGTCA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GATCTGGTAAAATTGTCCCATATTGGAGCTGTCTGTTGTGATATTCATCATGCTGTCAC 11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GATCTGGTAAAATTGTCCCATATGGGAGCTGTCTGTTGTGATATTCATCATGCTGTCA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GATCTGGTAAAATTGTCCCATATTGGAGCTGTCTGTTGTGATATTCATCATGCTGTCA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TCTGCTAAAATTGTACCATATTGGAGCTGTCTGTTGTGATATTCATCATTCTGTCA- 11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ATCTGGTAAAATGGCACCTTATTGGAGTTGTCTGTTGTGGTATTCATCATGCTGTCAC 115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AATCAAGTAAAATGGT-CCACATTGGGATTTTGGTTCGTAGTGTCCATCAAACTGCTA- 11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**   ****** *  **  ** **   * *   * **  * * *****  *** 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40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DACHD.229</a:t>
            </a:r>
          </a:p>
        </p:txBody>
      </p:sp>
      <p:sp>
        <p:nvSpPr>
          <p:cNvPr id="7" name="Rectangle 6"/>
          <p:cNvSpPr/>
          <p:nvPr/>
        </p:nvSpPr>
        <p:spPr>
          <a:xfrm>
            <a:off x="5756128" y="872067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564732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6861028" y="872066"/>
            <a:ext cx="558800" cy="448571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ight Arrow 17"/>
          <p:cNvSpPr/>
          <p:nvPr/>
        </p:nvSpPr>
        <p:spPr>
          <a:xfrm>
            <a:off x="6861028" y="550381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Arrow 20"/>
          <p:cNvSpPr/>
          <p:nvPr/>
        </p:nvSpPr>
        <p:spPr>
          <a:xfrm>
            <a:off x="5756128" y="5503815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320544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481535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orse           GGGGGCTGGTGTGGCAGCTGTGGGCTGCACCGAGGCCTGTCAGGC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-GGGGCTGGTGTGGCAGCTGTGGGCTGCACCGAAGCCTGTCAGAGAGGAATGATTAATGA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GGGGGCTGGCGTGGCAGCTGTGGGCTGCACCA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GGGGGCTTGCATGGCAGCTGTGGGCTGCACCA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GGGGGCTGGCGTGGCAGCTGTGGGCTGCACCAAGA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GGGGGCTGGTGTGGCAGCTGTGGGCTGCACCA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GGGGGCCGTCGTGGCAGCTGTGGGCTGCACCG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GGGGGCCGTCGTGGCAGCTGTGGGCTGCACCGAGGCCTGTCAA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GGGGGCTGGCGTGGCAGCTGTGGGCTGCACCG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GGGGGCTGGCGTGGCAGCTGTGGGCTGCACCGCGGCCTGTCAGGGAGGAATGATTAATG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GGGGGCTGGCGTGGCAGCTGTGGGCTGCACCG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GGGGGCTGGTGTGGCAGCTGTGGGCTGCACCG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GGGGGCTGGCGTGGCAGCTGTGGGCTGCACCGAGG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-GGGGCCCGTGTGGCAGCTGTGGGCTGCACGGAGGCCTGTCAGGGAGGAATGATTAATGA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GGGGGACGGCATGGCAGATGTGGGCTGCTCCGAGTCCTGTCAGG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GGGGGACCGAGTGGCAGATGTGGGCTGCTCAGAGCCCTGTCAGCAAGGAATGATTAATG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GGGGGACGGGGTGGCAGCTGCAGGCTGCTCGGTGCACTGTCAGAGCGGAATGATTAATG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GGGGGACGGGGTGGCAGCTGCAGGCTGCTCGGTGCACTGTCAGAGCGGAATGATTAATG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GGGGGACGGGGTGGCAGCTGTGGGCTGCTCAGAGCACTGTCAGAGCA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GGGGGACAGGGTGGCAGATGTGGGCCTCTCCCAAGCCTGTCACTGAGGAATGATTAATGA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--GGGACGTCGCGGCAGATGTGGGACGCTCAGAGCCCTGTCAGGAAGGAATGATTAATGA 5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------------------------------------CTGTCAGCCAGGAATGATTAATGA 2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    ******     ***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632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Calibri"/>
                <a:cs typeface="Calibri"/>
              </a:rPr>
              <a:t>PREDICTED</a:t>
            </a:r>
            <a:r>
              <a:rPr lang="en-US" dirty="0">
                <a:latin typeface="Calibri"/>
                <a:cs typeface="Calibri"/>
              </a:rPr>
              <a:t>: </a:t>
            </a:r>
            <a:r>
              <a:rPr lang="en-US" dirty="0">
                <a:solidFill>
                  <a:srgbClr val="000000"/>
                </a:solidFill>
                <a:latin typeface="Calibri"/>
                <a:ea typeface="Courier New"/>
                <a:cs typeface="Calibri"/>
              </a:rPr>
              <a:t>POU3F1.7785</a:t>
            </a:r>
            <a:endParaRPr lang="en-US" dirty="0" smtClean="0">
              <a:latin typeface="Calibri"/>
              <a:cs typeface="Calibri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489406" y="872066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968206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ight Arrow 9"/>
          <p:cNvSpPr/>
          <p:nvPr/>
        </p:nvSpPr>
        <p:spPr>
          <a:xfrm>
            <a:off x="6489406" y="56992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5199846" y="569922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199846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9665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ATCCATCCAACTGCTGTCACCACAGGGGAGCAGACAATCTATCAAGGCATCGGGATGC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ATCCATCCAGCTGCTGTCACCACAGGGGAGCAGACAATCTATCAAGGCATCGGGATG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TCCATCCAGCTGCTGTCACCACAGGGGAGCAGACAATCTATCAAGGCATCGGGATG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ATCCATCCAGCTGCTGTCACCACAGGGGAGCAGACAATCTATCAAGGCATCGGGATGC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TCCATCCAGCGGCTGTCACAGTGGGGAAGCGGACAATCTATCAAGGTATCGAGATA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ATCCATTCAGCGGCTGTCACAGTGGGGAAGCGGACAATCTATCAAGGTATCA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TCCATCCAGCGGCTGTCACAGA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TCCATCCAGCGGCTGTCACAGTGGGGAAGCGGACAATCTATCAAGGTATCGAGATAT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ATCCATCCAGCGGCTGTCACAGTGGGGAAGCGGACAATCTATCAAGGTATCGAGATA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TCCATCCAGCTGCTGTCACGGCAGGAGAGCAGCCAATCTATCACGCCATCCAGACAC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 ** * ********    **  *** * ********** *  ***  **  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632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OU3F2.9802</a:t>
            </a:r>
          </a:p>
        </p:txBody>
      </p:sp>
      <p:sp>
        <p:nvSpPr>
          <p:cNvPr id="7" name="Rectangle 6"/>
          <p:cNvSpPr/>
          <p:nvPr/>
        </p:nvSpPr>
        <p:spPr>
          <a:xfrm>
            <a:off x="5206706" y="872067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5206706" y="61157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3300392" y="61157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300392" y="872067"/>
            <a:ext cx="558800" cy="452431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488383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TAATTTGATG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ATTTGATTGATTTGTTTTGACAGCAGCCCAAATAATTGAGAGTGAAAGGTGTCAGCAC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ATTTGATTGATTTGTTTTGACAGCAGCC-AAATAATTGAGAGTGAAAGGTGTCAGCAC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ATTTGATTGATTTGTTTTGACAGCAGCC-ACATAATTGAGAA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AATTTGATTGATTTGTTTTGACAGCAGCA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ATTTGATTGATTTGTTTTGACAGCAGCC-AAATAATTGAGAGTGAAAGGTGTCAGCAC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ATTTGATTGATTTGTTTTTACAGCAGCC-AAATAATTGAGAGTGAAAGGTGTCAGCGC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AATTTGATTGATTTGTTGTGACAGCAGCC-AAATAATTGAGAGTGAGAGGTGCTGCTGG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AATTTGATTGATTTGTTGTGACAGCAGCC-AAATAATTGAGAGTGAGAGGTGCTGCT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AATTTGATTGATTTGTTGTGACAGCAGCC-AAATAATTGAGAGTGAGAGGTGCTGGC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AATTTGATTGATTTGTTGTGACAGCAGCC-AAATAATTGAGAGTGAGAGGTGCTGCC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ATTTGATTGATTTGTTATGACAGCAGCC-AAATAATTGAGAGTGAGAGGTG------- 5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AATTTGATTGATTTGCT-TGACAGCAGTC-AAATAATTTAGAGGGAAGGGTGGAATCGC 5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 ****** * * *******   * ****** ***  **  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634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POU6F2.1568</a:t>
            </a:r>
          </a:p>
        </p:txBody>
      </p:sp>
      <p:sp>
        <p:nvSpPr>
          <p:cNvPr id="7" name="Rectangle 6"/>
          <p:cNvSpPr/>
          <p:nvPr/>
        </p:nvSpPr>
        <p:spPr>
          <a:xfrm>
            <a:off x="2457156" y="872066"/>
            <a:ext cx="952500" cy="46317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22480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3765040" y="872066"/>
            <a:ext cx="558800" cy="46317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Arrow 19"/>
          <p:cNvSpPr/>
          <p:nvPr/>
        </p:nvSpPr>
        <p:spPr>
          <a:xfrm>
            <a:off x="3765040" y="6065693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Arrow 14"/>
          <p:cNvSpPr/>
          <p:nvPr/>
        </p:nvSpPr>
        <p:spPr>
          <a:xfrm>
            <a:off x="2457156" y="6066596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951876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TGTCGGTAGGTGGCTGTCACCGGGTCTGATTAATGACCCCAC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TCGGTAGGTGGCTGTCACCGGGTCTGATTAATGACCCCAC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--TCGGTAGGTGGCTGTCACCGGGTCTGATTAATGACCCCACTGAAACATGTCCAGCCAC 5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-------GGTGGCTGTCACCGGGTCTGATTAATGACCCCACTGAAACATGTCCAGCCAC 52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------GGTGGCTGTCACCGGGTCTGATTAATGACCCCACTGAAACATGTCCAGCCAC 52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-----------GGCTGTCACTGGGCCTGATTAATGACCCCACTGAAACATGTCCAGCCAC 4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---CGGGAGGTGGCTGTCAGAGGGTCTGATTAATGACCGCACTGAAGCATGTCCGGCCAC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-----------GGCTGTCAGCGGGTCTCAGAAATGACTCCACCGAAACATGTCCAGCCCC 4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--------------TGTCACCGGGTCTGATTAATGGCC-CAGTGAAACATGTCCAGCCAC 45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TTGGTTGGTGGCTGTCAGTGCGTCTGATTAATGACCCCAG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TTGGTAGGTGGCTGTCAGTGGGTCTGATTAATGACCCCAG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TGGGTAGGTGGCTGTCAGCGTGTCTGATTAATGACCCCAG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-GTCGGTAGGTGGCTGTCAGTGCGTCTGATTAATGACCCCGGTGAAACATGTCCAGCCAC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GCGGGAGGTGGGTGTCAGTGCCTCTGATTAATGACCCCGG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TCGGGAGGTGGCTGTCAGTGTGTCTGATTAATGACCCCAG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TTGGTAGGTGGCTGTCACCGTGTCTGATTAATGACCCCAGTGAAACAT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GGTAGGTGGCTGTCACAGCGGCTGATTAATGACCCCAGTGAAACATGTCCAGCCAC 5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TCGGGAGGTGGCTGTCACTGGGTCTGATTAATGACCCCGGTGAAACATGTCCAGCCA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GGAAGAAGTGGCTGTCACAGTGTCTGATTAATGACCCTTCGATGGCACGTCCAGCCA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GGAAGAAGTGGCTGTCACAGTGTCTGATTAATGACCCTTCGATGGCACGTCCAGCCAC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GGAAGAAGTGGCTGTCACGGTGTCTGATTAATGACCCGTCGGTGGCGTGTCCAGCCA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GGAGAGGTGGCTGTCACTGTGTCTGATTAATGACCCGTCGGAGGCATGTCCAGCCAT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*****  *   ** *  **** *          *  **** 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23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ALL3.2991</a:t>
            </a:r>
          </a:p>
        </p:txBody>
      </p:sp>
      <p:sp>
        <p:nvSpPr>
          <p:cNvPr id="7" name="Rectangle 6"/>
          <p:cNvSpPr/>
          <p:nvPr/>
        </p:nvSpPr>
        <p:spPr>
          <a:xfrm>
            <a:off x="4393906" y="872066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4393906" y="5697217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218646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218646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09313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154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TGATGGATTATGGGATTGT-AAC--TGTCCCTGC-CAGC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GGATTATGGGATTGT-AAC--TGTCCCTGC-CAGC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GGATTATGGGATTGT-AAC--TGTCCCTGC-CAGC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GGATTATAGGATTGT-AAC--TGTCCCTGC-CAGT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GGATTATAGGATTGT-AAC--TGTCCCTGC-CAGTTGACAGCTTC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TGGATTATAGGATTGT-AAC--TGTCCCTGC-CAGT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TGGATTATAGGATTGT-AAC--TGTCCCTGC-CAGTTGACAGCTTTTATTGGCTGGG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TGGATTATGGGATTGT-AAC--TGTCCCTGC-CAGT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ATGGATTATGGGATTGT-AAC--TGTCTCTGC-CAGTTGACAGCTTTTATTGGCCGGG 5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GGATTATGGGATTGT-AAC--TGTCCCTGC-CAGG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TGGATTATGGGATTGT-AAC--TGTCCCTGC-CAGT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TGGATTATGGGATTGT-AAC--TGTCCCTGC-CAGT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ATGGATTATGGGATTGT-AAC--TGTCCCTGG-CAGTTGACAGCTTTTATTGGCTAGG 5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TGGATTATGGGATTGT-AAC--TGTCCAGGC-CAGT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TGGATTATGGGATTGT-AAC--TGTCTCTGC-CAGC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TGGATTATGGGATTGT-AAC--TGTCGCGGC-CGGCTGACAGCTTTTATTGGCTGGG 5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ATGGATTATGGGATTGT-AAC--TGTCCCTGC-TTGCTGACAGCTTTTATTGGTTGGG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TGGATTATGGGGGTTTTGGCCGTA-CCCTTTGCTGCTGACAGGCTTTATTGGTCGGG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ATGGATTATGGGGGTTTTGGCCAAA-CCCTCTGCTGCTGACAGGCTTTATTGCTTGGG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TGGATTATGGGGATTT--ACCTCG-CCGGGTGCCGCTGACAGGCTTTATTGGT---- 5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TGGATTATGGGATTGCT--CCATGTCCTGCTCTTGCTGACAGCCTTTATTGGTGTTG 5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 **  *     *     *        * ******  * 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23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ALL3.3016</a:t>
            </a:r>
          </a:p>
        </p:txBody>
      </p:sp>
      <p:sp>
        <p:nvSpPr>
          <p:cNvPr id="7" name="Rectangle 6"/>
          <p:cNvSpPr/>
          <p:nvPr/>
        </p:nvSpPr>
        <p:spPr>
          <a:xfrm>
            <a:off x="2006600" y="872066"/>
            <a:ext cx="952500" cy="415498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2006600" y="5697217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593546" y="872066"/>
            <a:ext cx="558800" cy="415498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5593546" y="5697217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944091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opossum          AGGTGTGTTT-CGCTGTCAGAGA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GTGTGTTT-CGCTGTCAGAGGCATAATATAATGATAAATCGACATCATTTCTCATACT 28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GGTGTGTTT-CGCTGTCAGAGGCATAATATAATGATAAATCGACATCATTTCTCATACT 28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CCCCCCCTAACGCTGTCAGAGGCATAATATAATGATAAATCGACA-------------- 274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GGTGTGTTT-TGCTGTCATTGGGATAATATGATGATAAATCGACACCATTTCTCATAGT 27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GTGTGTTT-CCCTGTCAGAGCTGTAATATCATGATAAATCAACATCATCCTTCATAGT 28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GTGTGTTT-CCCCGTCAGAGCTGTAATATCATGATAAATCGACATCATCCCTCATCGT 28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GTGTGTTT-CCCTGTCAGGGCTGTAATATCATGATAAATCGACATCATCCCTCATAGT 295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      *    * ****  *   ****** ********** 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7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ATB1.5966 </a:t>
            </a:r>
          </a:p>
        </p:txBody>
      </p:sp>
      <p:sp>
        <p:nvSpPr>
          <p:cNvPr id="7" name="Rectangle 6"/>
          <p:cNvSpPr/>
          <p:nvPr/>
        </p:nvSpPr>
        <p:spPr>
          <a:xfrm>
            <a:off x="5028906" y="872066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5028906" y="5692136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205946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205946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199168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8966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69249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GTCAGAGCGTATCAGCTTGTCATATTAGTGGTGATCG-TTGGCTCTACCTAATCTGC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GTCAGAGCGTATCAGCTTGTCATATTAGTGGTGATCG-TTGGCTCTACCTAATCTGCT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GTCACAGCGTATCAGCTTGTCATATTAGTGGTGATCG-TTGGCTCCACCTAATCTGC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GTCACAGCGTATCAGCTTGTCATATTAGTGGTGATGG-TTGCCTCTACCTAATCTGC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GTCATGCGGCATCAGCTTGTCATATTAGTGCTGATCG-TTCCCTGAACCTAATCTACT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GTCAGCCTCCATCAGCTTGTCATATTAGAGGTGATTG-TTCCCTGAATCTAATCTACT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GTCAGCCTCCATCAGCTTGTCATATTAGAGGTGATTG-TTCCTTGAATCTAATCTACT 5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GTCAGCCTACATCAGCTTGTCATATTAGAGGTGATTG-TTCCCTGAATCTAATCTACT 5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GTCAGCCCCTATCAGCTTGTCATATTAGAGGGGATTG-TCCTAGGAACCTAATCTGCT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GTCAGCCCCTATGAGCTTGTCATATTAGAGGGGATTG-TCCTAGGAACCTAATCTGCT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GTCAGCACCTATCAGCTTGTCATATTAGAGGGGATTG-TCCTAGGAATCTAATCTGC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GTCAGCTTCCATCAGCTTGTCATATTGGAGGGGATTG-TCCTCAGAATCTAATCTGCT 5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GTCAGCCCCCATCAGGTTGTCATATTAGAAGGGATTG-TCCTCGGAAACTAATCTGCT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GTCAGGCTCCATCAGCTTGTCATATTAGAAGGGATTG-TCCTGCGAATCTAATCTACT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GTCAGGCTCCATCAGCTTGTCATATTAGAGGGGCCTGGTCCCCTGCATCTAATCTGCC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      ** ** ********** *    *   * *       * ******* *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AAACAATTT-CATTGGGTGCTGGTCTATAAATCATCCCGTAATGGGATTGACA-CACG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AAACAATTT-CATTGGGTGCTGGTCTATAAATCATTCCGTAATGGGATTGACA-CACG 11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AAACAATTT-CATTGGGTGCTGGTCTATAAATCATTCCGTAATGGGATTGACA-CGCG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TTAACAATTT-CATTGGGTGCTGGTCTATAAATCATCCGGTAATGGGATTGACA-CGCG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TAAACAATTT-CATTGGACGGTGGTCTATAAATCATTTCATAATGGCCCTGACA-TACC 11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TAAATGATTT-CATTGGGTAGAGGTCTATAAATCATTTCAGAATGGGCCTGACA-GATG 11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AAATGATTT-CATTGGGTAGAGGTCTATAAATCATTTCAGAATGGGTCTGACA-GATG 117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TAAATGATTT-CATTGGGTAGAGGTCTATAAATCATCTCAGAATGGGCCTGACA-GATG 11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TAAATGATTTTCGTGGGGTGTTGGTCTATAAATCATCTCGAGGCAGGCCTGACAACGCG 11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TAAATGATTTTCGTGGGGTGTTGATCTATAAATCATCTCGAGGCAGGCCTGACAACGCG 11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TAAATGATTTTCGTGGGGTGTTGGTCTATAAATCATCTCGAGGCAGGCCTGACAACACG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TAAATGATTT-CGTGGGGTGGTGGTCTATAAATCATCGCGGAGCCGCCCTGACAACGCC 118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TAAATGATTT-CGTGGGGTGCTGGTCTATAAATCATGTCTGAGGCGCCCTGACA-TGGC 11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AAATGATTT-CGTGGGGTGGTGGTCTATAAATCATTTCAGAATCGCCCTGACA-CGTC 11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TAAATGGTTT-CGTGGGGCGGTGGTCTATAAATCATCTCGGAATGGGCCTGACA-CGTG 11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**   *** * * **     * ************         *   ***** </a:t>
            </a:r>
          </a:p>
        </p:txBody>
      </p:sp>
      <p:sp>
        <p:nvSpPr>
          <p:cNvPr id="7" name="Rectangle 6"/>
          <p:cNvSpPr/>
          <p:nvPr/>
        </p:nvSpPr>
        <p:spPr>
          <a:xfrm>
            <a:off x="4381500" y="4732866"/>
            <a:ext cx="952500" cy="306417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25650" y="439739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2025650" y="891435"/>
            <a:ext cx="558800" cy="2994766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25650" y="831036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78748" y="138668"/>
            <a:ext cx="2512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HOX.11103</a:t>
            </a:r>
          </a:p>
        </p:txBody>
      </p:sp>
      <p:sp>
        <p:nvSpPr>
          <p:cNvPr id="12" name="Right Arrow 11"/>
          <p:cNvSpPr/>
          <p:nvPr/>
        </p:nvSpPr>
        <p:spPr>
          <a:xfrm>
            <a:off x="2025650" y="424879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Arrow 14"/>
          <p:cNvSpPr/>
          <p:nvPr/>
        </p:nvSpPr>
        <p:spPr>
          <a:xfrm>
            <a:off x="4362450" y="8164315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735399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GC-TGGAGCACCAACTTGCCTGCTGTCACACTAGAG-GAGTCTTAAATGTTTAATGACA 11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GC-TGGAGCACCAAGTTGCCTGCTGTCATACTAGAG-GAGTGTTAAATGTTTAATGACG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GC-TGGAGCACCGAGTCGGCTGCTGTCATATTAGAG-GAGTGATAAATGTTTAATGACG 117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C-CCAAGCACAAAGTTGCCTGCTGTCGCATTGGAA-GTA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C-CGAAGCACAAAGTTGCCTGCTGTCACGTTGGAA-GTA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AC-TCAAGCACAAAGTTGCCTGCTGTCACACTGGAG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CT-CCAAGCACAAAGTTGCCTGCTGTCACATTG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AT-CCTGGCACAAAGTTGCCTGCTGTCACATTGGAA-GTGTGATAAATGTTTAATGAAA 11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T-CCTGGCACAAAGTTGCCTGCTGTCACATTGGAA-GTGTGATAAATGTTTAATGAAA 11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T-CCTGGCACAAAGTTGCCTGCTGTCACATTGGAA-GTGTGATAAATGTTTAATGAAA 11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T-CCTGGCACAAAGTTGCCTGCTGTCACTTTGGAA-GTGTGATAAATGTTTAATGAAA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AT-CCTGGCACAAAGTTGCCTGCTGTCACATTG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T-CCTTGCACAAAGTTGCCTGCTGTCACATTG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T-CCTGGCACTAAGTTGCCTGCTGTCACATTG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T-CCTGGCACAAAGTTGCCTGCTGTCACATTG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T-CCTGGCACAAAGTTGCCTGCTGTCACATTGGAAAGTGTGATAAATGTTTAATGAAA 10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T-CCTGGCACAAAGTTGCCTGCTGTCACATTG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T-CCTGGTACAAAGTTGCCTGCTGTCACATTCGAA-GTGTGATAAATGTTTAATGAAA 11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AT-ACTGGCACAAAGTTGCCTGCTGTCACATTC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T-ACTGGCACAAAGTTGCCTGCTGTCACATTC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T-CCTGGCACAAAGTTGCCTGCTGTCACATTCGAA-GTGTGATAAATGTTTAATGAAA 11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T-CCTGGCACAAAGTTGCCTGCTGTCACATCCGAA-GTGTGATAAATGTTTAATGAAA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TGCTGGGTGTGGAGGACCCTGCTGTCATCCTAGAG-CTCTGATCAATCTTTTATGAAA 11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*     *     ********      **     *  * *** *** 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12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HOX2.5627</a:t>
            </a:r>
          </a:p>
        </p:txBody>
      </p:sp>
      <p:sp>
        <p:nvSpPr>
          <p:cNvPr id="7" name="Rectangle 6"/>
          <p:cNvSpPr/>
          <p:nvPr/>
        </p:nvSpPr>
        <p:spPr>
          <a:xfrm>
            <a:off x="5765506" y="872067"/>
            <a:ext cx="952500" cy="452431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5765506" y="5697217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133046" y="872067"/>
            <a:ext cx="558800" cy="452431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4133046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03276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CTGGCAATCATGGGGGAAACAATGTTTACATCGATCAGCTGTCAGGAAGATTTATGG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CTGGCAATCATGGGGGAAACAATGTTTACATCGATCAGCTGTCAGGAA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CTGGCAATCATGGGGGAAACAATGTTTACATCGATCAGCTGTCAGGAAGATTTATGGC 10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CTGGCAATCATGGGGGAAACAATGTTTACATCGATCAGCTGTCAGGAAGATTTATGG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CTGGCAATCATGGGGGAAACAATGTTTACATCGATCAGCTGTCAGGAAGATTTATGGC 10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GCTGGCAATCATGGCGGAAACAATGTTTACATCGATCATCTGTCACGGTGATTTATGGC 9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CCTGGCAATCACGGCGGAAACAATGTTTACATCGATCAGCTGTCAC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CCTAC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CCTGGCAATCATGGCGGAAACAATGTTTACATCGATCAGCTGTCATCGTGATTTATGG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CTGGCAATCATGGCGGAAACAATGTTTACATCGATCAGCTGTCAC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G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CC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CTGGCAATCATGGCGGAAACAATGTTTACATCGATCAGCTGTCATGGTGATTTATGGC 12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   ****** ** *********************** ******    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12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HOX2.5643</a:t>
            </a:r>
          </a:p>
        </p:txBody>
      </p:sp>
      <p:sp>
        <p:nvSpPr>
          <p:cNvPr id="7" name="Rectangle 6"/>
          <p:cNvSpPr/>
          <p:nvPr/>
        </p:nvSpPr>
        <p:spPr>
          <a:xfrm>
            <a:off x="4647906" y="872066"/>
            <a:ext cx="952500" cy="479703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4647906" y="56966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682152" y="872066"/>
            <a:ext cx="558800" cy="479703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5682152" y="570556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6476706" y="870427"/>
            <a:ext cx="952500" cy="479703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>
            <a:off x="6476706" y="5697217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415951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990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84023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stickleback      AACATGATTTACA--TTCCCAATGTAATGTATTAAATCGTCGACAGGGCAAAA---GGGA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CATGATTTACA--TTCTCAATGTAATGTATTAAAACGTTGACAGGGCCAAA---GGGA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CATGATTTACAATTTCTCAATGTAATGTATTAAAACGTTGACAGAGCAAAA---GGG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ACACGCCTTAGA--TTCTAAGTGTAATGTATTAAAACGTTGACAGGGCAAAA---GGGA 5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ACACGATTTACA--TTCTCAATGTAATGTATTAAAAAGTTGACAGGGACGAA---AGGA 5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ACACGATTTACA--TTCTCAATGTAAC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ACACGATTTACA--TTCTCAATGTAATGTATTAAAAAGTTGACAGGGA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-CACGATTTACA--TTCTCAATGTAATGTATTAAAAAGTTGACAGGGACGAG---CGGA 53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CACGATTTACA--TTCTCAATGTAATGTATTAAAAAGTTGACAGGGACGAG---CGGA 5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CACGATTTACA--TTCTCAATGTAATGTATTAAAAAGTTGACAGGGCCGAA---AGGA 55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--------------------------------AAATGGTCCACATGGC----------- 1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ACACGATTTACA--TTTTCCATATTATGAATTAAATAGTCGACACGGCAAAAAAAGGGA 5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  ***  **  ***  *          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stickleback      TTCACTAGATG-CTGCATTAGAAACTC-AATTTCTGTGATGAATTGCCT-GAAGC-CAAT 11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CACAAGATG-CTGCATTAGAAACTC-AATTTCTGTGATGAATTGCCT-GAAGC-CACT 11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TCACAAGATG-CTGCATTAGAAACTC-AATTTCTATGATGAATTGCCT-GGGGC-TACT 11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TCACGAGATG-CTGCATTAGAAACTC-AATTTCTGGGATGAATCGCCCCGAAGG-CACC 112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TCACACGATGTCTGC-TAAGAAACCCCAATTTCCATGATGAATTGCCC-GAAGC-CCCT 112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TCACACGATGTCTGC-TAAGAAACCC-AATTTCCATGATGAATTGCCC-GAAGC-CCCT 11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TCACACGATGTCTGC-TAA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CACACGATGTCTGC-TAA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TCACACGATGTCTGC-TAA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TCACACGATGTCTGC-TAA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TCACACGATGTCTGC-TAA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TCACACGATGTCTGC-TAA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TCACACGATGTCTGC-TAA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TCACACGATGTCTGC-TACGAAACCC-AATTTCCATGATGAATTGCCC-GA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TCACACGATGTCTGC-TAAGAAACCC-AATTTCCATGATGAATTGCCC-GGAGC-CCCT 10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TCACACGATGTCTGC-TAAGAAACCC-AATTTCCATGATGAATTGCCC-GGAGC-CCCT 10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CACATGATGTCGGC-TAAGAAACCC-AATTTCCATGATGAATTGCCC-GGAGC-CCCT 111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CA------G--CGC---AGAAACCC--ATTTCCATGATGAATTGCCC-AAAGCATCTT 6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TCACTCCATG-TTGCCTGAGAAACCT-AATTTCTATGATGAATCGCCT-GCAGT-CTCT 11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**      *   **    *****    *****   ******* ***     * </a:t>
            </a:r>
          </a:p>
        </p:txBody>
      </p:sp>
      <p:sp>
        <p:nvSpPr>
          <p:cNvPr id="7" name="Rectangle 6"/>
          <p:cNvSpPr/>
          <p:nvPr/>
        </p:nvSpPr>
        <p:spPr>
          <a:xfrm>
            <a:off x="5321300" y="5469466"/>
            <a:ext cx="952500" cy="380490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19076" y="506355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5689600" y="884767"/>
            <a:ext cx="558800" cy="373803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19076" y="958036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ight Arrow 18"/>
          <p:cNvSpPr/>
          <p:nvPr/>
        </p:nvSpPr>
        <p:spPr>
          <a:xfrm>
            <a:off x="5295900" y="9436855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Arrow 20"/>
          <p:cNvSpPr/>
          <p:nvPr/>
        </p:nvSpPr>
        <p:spPr>
          <a:xfrm>
            <a:off x="5683026" y="492004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378748" y="138668"/>
            <a:ext cx="260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OX14.11250</a:t>
            </a:r>
          </a:p>
        </p:txBody>
      </p:sp>
    </p:spTree>
    <p:extLst>
      <p:ext uri="{BB962C8B-B14F-4D97-AF65-F5344CB8AC3E}">
        <p14:creationId xmlns:p14="http://schemas.microsoft.com/office/powerpoint/2010/main" val="30848696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0" y="0"/>
            <a:ext cx="9144000" cy="11379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879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elephant         TAGATTC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GATTAATCAAGGAGCAGACATTTGGAAG---AAAGTTTGT-A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GATTAATCAAGAAGCAGACATTTGGAAG---AAAGTTTGT-GTGAATGCCTGACAGTC 115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</a:t>
            </a:r>
            <a:r>
              <a:rPr lang="en-US" sz="1200" dirty="0">
                <a:latin typeface="Courier New"/>
                <a:cs typeface="Courier New"/>
              </a:rPr>
              <a:t>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GATTAATCAT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GATTAATCAAGGAGCAGA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GATTAATCAAGGAGCAGACATTTGGAAG---AAAGTTTGT-GTGAATGCCTGACAGTC 11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GATTAATCAAGGAGCAGACATTTGGAAG---AAAGTTTGT-GTGAATGCCTGACAGTC 114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AGATTAATCAAGGAGCAGACATTC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GATTAATCAAGGAGCAGGCATTTGGAAG---AAAGTTTGT-GTGAATGC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GATTAATCAAGGAGCAGACATTAAGAAG---AAAGTTTGT-GCGAACGGCTGACAGTC 115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ACACCAAGCTAACAGGAGACATTTTGAGG---AAAGTTTGT-GAAAGCACATGACAAGC 6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AGATTAATCAGCGCACAGACATTGTGGGG--AAAAGTTTGCCGTGAATGCCTGACAGT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AGATTAATCAGCGCACAGACATTGTGGGG--AAAAGTTTGCCGTGAATGCCTGACAGT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AGATTAATCAGCGCACAGACATTGTGAGG--AAAAGTTTGCAGTGAATGCCTGACAGTT 11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AGATTAATCAGCGCGCAGACGTTGTGGGGGGAAAAGTTTGCAGTGAATGCCTGACAGTC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GATTAATCAAGAGGCAGACATTGTGGGG---AAAGTTTGTTTCGAATGCCTGACAGTA 10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 *   * *       ** * **  *  *   ********     *     ***** </a:t>
            </a:r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r>
              <a:rPr lang="en-US" sz="1200" dirty="0" smtClean="0">
                <a:latin typeface="Courier New"/>
                <a:cs typeface="Courier New"/>
              </a:rPr>
              <a:t>opossum          </a:t>
            </a:r>
            <a:r>
              <a:rPr lang="en-US" sz="1200" dirty="0">
                <a:latin typeface="Courier New"/>
                <a:cs typeface="Courier New"/>
              </a:rPr>
              <a:t>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TTGATGAATTGTATGCAATATGCAAATTAGAATCCATAAATCTTATGAATGACAGC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TTGATGAATTGTATGCAATATGCAAATGAGAATCCATAAATCTTATGAATGACAGC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TTGATGAATTGTATGCAATATGCAAATGAGAATCCATAAATCTTATGAATGACAGC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TTGATGAATTGTATGCAATATGCAAATGAGAATCCATAAATCTTATGAATGACAGC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TTGATGAATTGTATGCAATATGCAAATGAGAATA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TTGATGAATTGTATGCAATATGCAAATGAGAATCCATAAATCTTATGAATGACAGC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TTGATGAATTGC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TTGATGAATTGTATGCAATATGCAAATGAGAATCCATAAATCTTATGAATGACAGCTT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 *************** ***** ***************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40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DACHD.232</a:t>
            </a:r>
          </a:p>
        </p:txBody>
      </p:sp>
      <p:sp>
        <p:nvSpPr>
          <p:cNvPr id="7" name="Rectangle 6"/>
          <p:cNvSpPr/>
          <p:nvPr/>
        </p:nvSpPr>
        <p:spPr>
          <a:xfrm>
            <a:off x="2108200" y="872067"/>
            <a:ext cx="952500" cy="463174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579337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070100" y="10967296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Left Arrow 10"/>
          <p:cNvSpPr/>
          <p:nvPr/>
        </p:nvSpPr>
        <p:spPr>
          <a:xfrm>
            <a:off x="6584656" y="10826503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Left Arrow 18"/>
          <p:cNvSpPr/>
          <p:nvPr/>
        </p:nvSpPr>
        <p:spPr>
          <a:xfrm>
            <a:off x="6787856" y="5649865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6787856" y="872068"/>
            <a:ext cx="558800" cy="4631748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Arrow 20"/>
          <p:cNvSpPr/>
          <p:nvPr/>
        </p:nvSpPr>
        <p:spPr>
          <a:xfrm>
            <a:off x="2070100" y="5649865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2200611" y="6194755"/>
            <a:ext cx="952500" cy="446054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6584656" y="6194754"/>
            <a:ext cx="558800" cy="4460545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>
            <a:off x="2200611" y="10826503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549220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rabbit           TGATGGATATTGTCAGCTGGAAGCTACACTACATTTCACTGCACAATAAACATGGCTGTCA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TGGATATTGTCAGCTGGAAGCTACACTACATTTCACTT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ATGGATATTGTCA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TGGATATTGTCA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ATGGATATTGTCA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ATGGATATTGTCA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TGGATATTGTCA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GGATATTGTCAGCTGGAAGCTACACTACATTTCACTGCG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GGATATTGTCAGCTGGAAGCTACACTACATTTCACTGCG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TGGATATTGTCG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TAGATATTGTCA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TGGATATTGTCAGCT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TGGATACTGTCAGCTGGGAGCTACACTG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GGATATTGTCAGCTGGAAGCTACACTG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TGGATATTGTCAGCTGGAAGCTACAG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TGGATATTGTCAGCCGGAAGCT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GGATATTGTCAGCTTGAAGCTACACTACATTTCACTGCG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GGATACAGTCAGCTTGAAACGACACTACATTTCAC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ATGGATACTGTCAGCTGAATGCTACACTAGATTTCACTGCACAATAAACATGGCTCTCC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TGGATACTGTCAACCCTTCGCCACACCACATTTCATTGCACAATAAACATGGTTGTCA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TGGATACTGTCAGCCCTCCACCACACCACATTTCATTGCACAATAAACATGGTTGTCA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TGGATACTGTCAGCCCTCTGCCACACCACATTTCATTGCACAATAAACATGGTTGTCA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ATGGATACTGTCAGGCCTCTGCCACACCACATTTCATTGCACAATAAACATGGTTGTCA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TGGATACTGTCAGCCCTACGCCACACTACATTTCATTGCACAATAAACATGGCTGTCA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 ****  ***         * ***    ****** * * ************ * 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368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SOX6.2298</a:t>
            </a:r>
          </a:p>
        </p:txBody>
      </p:sp>
      <p:sp>
        <p:nvSpPr>
          <p:cNvPr id="7" name="Rectangle 6"/>
          <p:cNvSpPr/>
          <p:nvPr/>
        </p:nvSpPr>
        <p:spPr>
          <a:xfrm>
            <a:off x="1980906" y="872066"/>
            <a:ext cx="952500" cy="46317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622480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Right Arrow 12"/>
          <p:cNvSpPr/>
          <p:nvPr/>
        </p:nvSpPr>
        <p:spPr>
          <a:xfrm>
            <a:off x="7041640" y="6084203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7041640" y="872066"/>
            <a:ext cx="558800" cy="46317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Arrow 14"/>
          <p:cNvSpPr/>
          <p:nvPr/>
        </p:nvSpPr>
        <p:spPr>
          <a:xfrm>
            <a:off x="1980906" y="6065693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635196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armadillo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ATTTGGTCCCTGTCAGTCAGAAATAATT-GTGTTCTTAATCTTGTCCCTGATGGATG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ATTTGGTCCCTGTCAGTCAGAAATAATTTGTGTTCTTAATCTTGTCCCTGATGGATGA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ATTTGGTCCCTGTCAGTCAGAAATAATT-GTGTT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ATTTGGTCCCTGTCAGTCAGAAATAATT-GTGTTCTTAATCTTGTCCCTGATGGGTGA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ATTTGGTCCCTGTCAGTCAGAAATAATT-GTGTTCTTAATCTTGTCCCTGATGGGTGA 5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ATTTGGTCCCTGTCAGTCAAAAATAATT-GTGTTATTAATCTTGTCCCTGATGGATG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ATTTGGTCCCTGTCAGTCAGAAATAATT-GTGTGCTTAATCTT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ATTTGGTCCCTGTCAGTCAGAAATAATT-GTGTGCTTAATCTTGTCCCTGATGGATG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ATTTGGTCCCTGTCAGTCAGAAATAATT-GTGTGCTTAATCTTGTCCCTGATGGATG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ATTTGGTCCCTGTCAGTCAGAAATAATT-GTGTGCTTAATCTCGTCCCTGATGGATGA 5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GATTTGGTCCCTGTCAGTCAGAAATAATT-GTGTTCTTAATCTTGTCCCTGATGGATGG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********* ******** ****  ******* *********** 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45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CF7L2.5398</a:t>
            </a:r>
          </a:p>
        </p:txBody>
      </p:sp>
      <p:sp>
        <p:nvSpPr>
          <p:cNvPr id="7" name="Rectangle 6"/>
          <p:cNvSpPr/>
          <p:nvPr/>
        </p:nvSpPr>
        <p:spPr>
          <a:xfrm>
            <a:off x="6578306" y="872066"/>
            <a:ext cx="952500" cy="3970317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6578306" y="5697217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028146" y="872066"/>
            <a:ext cx="558800" cy="3970317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3028146" y="5697217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085568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bat              CGTCCTTGATTTGATGTGTGATTGATCGCCTGTCATCTGG-CAGCCTTTGATCTATTCAT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TCCTTGATTTGATGTGTGATTGATCGCCTGTCATCCGG-CG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ATCCTTGATTTGATGTGTGATTGATCGCCTGTCATCTGG-CAGCCTTTGATCTATTCAT 11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ATCCTTGATTTGATGCGTGATTGATCGCCTGTCATCTGG-CAGCCTTTGATCTATTCAT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ATCCTTGATTTGATGCTTGATTGATCGCCTGTCACGCGT-CCGCCTTTGATCTATTCAT 6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ATCCTTGATTTGATGCTTGATTGATCGCCTGTCATGTGG-CCGCCTTTGATCTATTCAT 75</a:t>
            </a:r>
          </a:p>
          <a:p>
            <a:r>
              <a:rPr lang="en-US" sz="1200" dirty="0">
                <a:latin typeface="Courier New"/>
                <a:cs typeface="Courier New"/>
              </a:rPr>
              <a:t>fugu             CATCCTTGATTTGATGTGTGATTGATCGCCTGTCATGTGG-CACCCTTTGATCTATTCAT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ACCCTTGATTTGATGTGTGATTGATCGCCTGTCATGTGG-CACCCTTTGATCTATTCAT 11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ATCCTTGATTTGATGCGTGATTGATCGCCTGTCACGTGG-CAGTCTTTGATCTATTCAT 89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ATCCTTGATTTGATGCGTGATTGATCGCCTGTCATCTGGGCTGCCTTTGATCTATTCAT 74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AGTTTTGATTTGACATTTGATTGATCACCTGTCATCTCG-CTGCCTTTGATCTATTCAT 65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GTTTTGATTTGACATTTGATTGATCACCTGTCATCTCG-CTGCCTTTGATCTATTCAT 6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GTTTTGATTTGACATTTGATTGATCACCTGTCATCTCA-CTGGCTTTGATCTATTCAT 65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ATCCTTCATTTGACGACTGATTGATTGCCTGTCACCCCT-CTGTCTTTGATCTATTCAT 75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** ******    ********  *******      *   *****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0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SHZ1.8799</a:t>
            </a:r>
          </a:p>
        </p:txBody>
      </p:sp>
      <p:sp>
        <p:nvSpPr>
          <p:cNvPr id="7" name="Rectangle 6"/>
          <p:cNvSpPr/>
          <p:nvPr/>
        </p:nvSpPr>
        <p:spPr>
          <a:xfrm>
            <a:off x="3657012" y="872066"/>
            <a:ext cx="952500" cy="479703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>
            <a:off x="4679146" y="611323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679146" y="872066"/>
            <a:ext cx="558800" cy="479703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3657012" y="61183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847948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orse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CTTCATTAACAGGC--CCCTAATTATCTGTAAACCTGATGGATTTGTGACAGGCG-TA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CTTCATTAACAGGC--CC-TAATTATCTGTAAACCTGATG-ATTTGTGACAGGCG-TAA 5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CTTCATTAACAGGC--CCCTAATTATCTGTAAACCTGATGGATTTGTGACAGGCG-TAA 5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CTTCATTAACAGGC--CCCTAATTATCTGTAAACCTGATGGATTTGTGACAGGCT-TAA 5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CTTCATTAACAGGC--CCCTAATTATCTGTAAACCTGATGGATTTGTGACAGGCT-TAA 5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CTTCATTAACAGGC--CCCTAATTATCTGTAAACCTGATGGATTTGTGACAGGCT-TAA 5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CTTCATTAACAGGC--CCCTAATTATCTGTAAACCTGATGGATTTGTGACAGGCT-TAA 5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CTTCATTAGCAAAG--CCCTAATTATCTGTAAACCTGATGGATTTGTGACAGCTT-TA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CTTCATTAGGGAGGAACCCTAATTATCTGTGCTCCTGATGGATTTGTGACAGGCTCT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CTTCATTAGAGAGGGGGCCTAATTATCCGCGGAGCTGATGGATTTGTGACAGGCCCT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CTTCATTAGAGAGGGG-CCTAATTATCCGGCGAGCTGATGGATTTGTGACAGGCCCTAA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CTTCATTAGAGAGAGC-CCTAATTATCTGTGGAGCTGATGGATTTGTGACAGGCTCTAA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         * ******** *     ****** ***********    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0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SHZ1.8800</a:t>
            </a:r>
          </a:p>
        </p:txBody>
      </p:sp>
      <p:sp>
        <p:nvSpPr>
          <p:cNvPr id="7" name="Rectangle 6"/>
          <p:cNvSpPr/>
          <p:nvPr/>
        </p:nvSpPr>
        <p:spPr>
          <a:xfrm>
            <a:off x="5308306" y="876972"/>
            <a:ext cx="952500" cy="433474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6337006" y="876972"/>
            <a:ext cx="558800" cy="436733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5308306" y="61183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6337006" y="61183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842101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CAGCCCCTGACAGAATGACATGTGTCATTTATCAAAGGGGCCAGGC-C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GCCCCTGACAGAATGACATGTGTCATTTATCAAAGGGGCCAGGC-C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GCCCCTGACAGAATGACATGTGTCATTTATCAAAGGGGCCAGGC-C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GCCCCTGACAGAATGACATGTGTCATTTATCAAAGGGGCCAGGC-TGGGCCTTGGGAA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AGCCCCTGACG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AGCCTCTGACA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GCCTGTGACAGAATGGCATGTGTCATTTATCAAAGGGGCCAGGC-C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GCCTGTGACA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AGGCTGTGACA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AGCCTGTGACA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AGCCTGTGACA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AGCCCCTGACAGAATGACATGTGTCATTTATCAAAGGGGCCAGTTATGGGCCTTGGGAA 11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AGCCTCTGACA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AG-CTCTGACAGAATGACATGTGTCATTTATCAAAGGGGCCAGGC-CGGGCCTTGGGAA 11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AG-CTCTGACAGAATGACATGTGTCATTTATCAAAGGGGCCAGGC-TGGGCCTTGGGAA 11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AGCCTCTGACAGAATGACATGTGTCATTTATCAAAGGGGCCAGGC-TGGGCCTTGGGAA 11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AGCCCCTGACAGAATGACATGTGTCATTTATCAAAGGGGCCAGGC-CGGGCCTTGGGAA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ACAAGCTGACAGAATGACATGTGTCATTTATCAAAGGGGCCAGGCGGGGGCCTTGGGAA 12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ACAAGCTGACAGAATGACATGTGTCATTTATCAAAGGGGCCAGGCGGGGGCCTTGGGAA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ACAAGCTGACAGAATGACATGTGTCATTTATCAAAGGGGCCAGGCGGGGGCCTTGGGAA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ACACTCTGACAGAATGACATGTGTCATTTATCAAAGGGGCCAG-----AGCTTGGGAAA 115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AGCCCCTGACAGAATGACATGTGTCATTTATCAAAGGGGCCAGGT-CAGGCCTTGGGAA 11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CCCTCCTGACAGAATGACATATGTCATTTATCATATGGGCC------------------ 91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**** ***** *** ************ * 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0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SHZ1.8804 </a:t>
            </a:r>
          </a:p>
        </p:txBody>
      </p:sp>
      <p:sp>
        <p:nvSpPr>
          <p:cNvPr id="7" name="Rectangle 6"/>
          <p:cNvSpPr/>
          <p:nvPr/>
        </p:nvSpPr>
        <p:spPr>
          <a:xfrm>
            <a:off x="4216106" y="872067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4216106" y="6113239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396446" y="872068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3396446" y="61183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491780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ACTTTCTTC-ATTGTTGAGGTAATTGTCTTCCCTCTGACAGG-CACATTCATCAGTGGCT 11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TTTCTTC-ATTGTTGAGGTAATTGTCTCCTCTCTGACAGG-CACATTCATCAGTGGCT 161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TTTCTTC-ATTGTTGAGGTAATTGTCTCCTCTCTGACAGC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TTTCCTC-ATTGTTGAGGTAATTGTCTCCTCTTTGACAGG-CACATTCATCAGTGGCT 171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TTTCTTC-ATTGTTGAGGTAATTGTCTCCTCTTTGACAGG-CACATTCATCAGTGGCT 171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TTTCTTC-ATTGTTGAGGTAATTGTCTCCTCTCTGACAGG-CACATTCATCAGTGGCT 17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TTTCTTC-ATTGTTGAGGTAATTGTCTCCTCTCTGACAGGGCACATTCATCAGTGGCT 17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TTTCTTC-ATTGTTGAGGTAATTGTCTCCTCTCTGACAGG-CACATTCATCAGTGGCT 176</a:t>
            </a:r>
          </a:p>
          <a:p>
            <a:r>
              <a:rPr lang="en-US" sz="1200" dirty="0">
                <a:latin typeface="Courier New"/>
                <a:cs typeface="Courier New"/>
              </a:rPr>
              <a:t>fugu             AGTTTCTTC-ATTGTTGAGGTAATTGTCTCCTCTTTGACAGG-CACATTCATCAGTGGCT 17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TTTCTTC-ATTGTTGAGGTAATTGTCTCCTCTCTGACAGC-CACATTCATCAGTGGCT 163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TTTCTTC-ATTGTTGAGGTAATTGTCTCCTCTTTGACAGG-CACATTCATCAGTGGCT 16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TTTCTTC-ATTGTTGAGGTAATTGTCTCCTCTCTGACAGG-CACATTCATCAGTGGCT 16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TTTCTTC-ATTGTTGAGGTAATTGTCTCCTCTTTGACAGG-CACATTCATCAGTGGCT 172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CTTTCTTC-ATTGTTGAGGTAATTGTCTCTCCCTTGACAGG-CACATTCATCAGTGGCT 15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CTTTTTTCCAATATTGATTTAATTGTCTGTCTTTTGACAGG-CACATATATCATTGGCT 7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CTTTTTTCCAATATTGATTTAATTGTCTGTCTTTTGACAGG-CACATATATCATTGGCT 7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***  ** * * ****  *********      ******  *****  **** 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0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SHZ2.8749</a:t>
            </a:r>
          </a:p>
        </p:txBody>
      </p:sp>
      <p:sp>
        <p:nvSpPr>
          <p:cNvPr id="7" name="Rectangle 6"/>
          <p:cNvSpPr/>
          <p:nvPr/>
        </p:nvSpPr>
        <p:spPr>
          <a:xfrm>
            <a:off x="6031912" y="872066"/>
            <a:ext cx="952500" cy="479703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 rot="10800000">
            <a:off x="5256192" y="611323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256192" y="872066"/>
            <a:ext cx="558800" cy="479703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 rot="10800000">
            <a:off x="6031912" y="61183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86167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775459"/>
            <a:ext cx="7664854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shark            CTGTAAACCTGATGGATTTGTGACAGCTTTAACGATTAATGCTGACAAATTCAGTAAGGT 10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GTAAACCTGATGGATTTGTGACAGGCGTAACGATTAATGCCGACAA------------ 8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GTAAACCTGATGGATT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GTAAACCTGATGGATTCCTGACAGCTTTAATGATTGGAGATGACAAGCTCGACGCAG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GTAAACCTGATGGATT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GTAAACCTGATGGATT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GTAAACCTGATGGATT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GTAAACCTGATGGATT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GTAAACCTGATGGATT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GTAAACCTGATGGATTCCTGACAGCTTTAATGATTGGAGATGACAAGCTT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GTAAACCTGATGGATTCCTGACAGCTTTAATGATTGGAGATGACAAGCTT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GTAAACCTGATGGATCCCTGACAGCTTTAATGATTGGAGATGACAAGCTCGACACAGT 12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GTAAACCTGATGGATC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GTAAACCTGATGGATTTCTGACAGCTTTAATGATTGGAGATGACAAGCC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GTAAACCTGATGGATTTCTGACAGCTTTAATGATTAGAGATGACAAGCCCA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GTAAACCTGATGGATTT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GTAAACCTGATGGATTCCTGACAGCTTTAATGATTGGAGATGACAAGCTCC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GTAAACCTGATGGATTCCTGACAGCTTTAATGATTGGAGATGACAAGCTCG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GTAAACCTGATGGATTCCTGACAGCTTTAATGATTGGAGATGACAAGCTCCACGCAGT 12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GTAAACCTGATGGATTCCTGACAGCTTTAATGATTGGAGATGACAAGCTCCACGCAG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GTAAAGCTGATGGATTCCTGACAGGCCTAATGATTGGAGATGACAAGCTCCGCACAC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CACGAGGCTGATGGAGTCCTGACAGGCCCTGTGATTGGAGATGACAAGCTCGG---GGT 93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CGCGAGGCTGATGGAGTCCCGACAGGCCGCGTGATCGGAGATGACAAGCTCGG---GGT 9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CGAGCATCTGATGGATCTCTGACAGGGTTAATGATTGGAGATGACAAGCTCCGCACACT 10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CGAGGGTCTGATGGATCTCTGACAGACCTAATGATTGGAGATGACAAGCTCCGCACCCT 12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      ********     *****       ***    *  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18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SHZ3.7689 </a:t>
            </a:r>
          </a:p>
        </p:txBody>
      </p:sp>
      <p:sp>
        <p:nvSpPr>
          <p:cNvPr id="7" name="Rectangle 6"/>
          <p:cNvSpPr/>
          <p:nvPr/>
        </p:nvSpPr>
        <p:spPr>
          <a:xfrm>
            <a:off x="2819106" y="775459"/>
            <a:ext cx="952500" cy="480550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97427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ight Arrow 9"/>
          <p:cNvSpPr/>
          <p:nvPr/>
        </p:nvSpPr>
        <p:spPr>
          <a:xfrm>
            <a:off x="2819106" y="583076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3853646" y="583076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873206" y="775459"/>
            <a:ext cx="558800" cy="479703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22809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37856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orangutan        CTATTATTAGATCACATTAATCATTACTGTGCCAAC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ATTATTAGATCACATTAATCATTACTGTGCCAAC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ATTATTAGATCACATTAATCATTACTGTGCCAAC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ATTATTAGATCACATTAATCATTACTGTGCCAAC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ATTATTAGATCACATTAATCATTACTGTGCCAAC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ATTATTAGATCACATTAATCATTGCTGTGCCAAC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ATTATTAGATCACATTAATCATTACTGTGCCAACGGCG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ATTATTAGATCACATTAATCATTACTGTGCCAACGGCG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ATTATTAGATCACATTAATCATCACTGTGCCAACGGCG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ATTATTAGATCACATTAATCATTACTGTGCCAAC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ATTATTAGATCACATTAATCATCGCGCAGCCGACGGC--TGACAGCC--GCTGAAAAG 5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ATTATTAGATCACATTAATCATGACTGTGCCAACGGCACTGACAGCCC-GCTGAAAAG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ATTATTAGATCACATTAATCATTACTGTGCCAACGGCACTGACAGCCC-GCTGAAAAG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ATTATTAGATCACATTAATCATTACTGTGCCAAAGGCACTGACAGCA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ATTATTAGATCACATTAATCATTACTGTGCCAAAGGCACTGACAGCCCCA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ATTATTAGATCACATTAATCATTACTGTGCCAAAGGCACTGACAGGCCCGCTGAATA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ATTATTAGATCACATTAATCACAAGTGTGCCGACGGCGGTGACAGCCGCG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ATTATTAGATCACATTAATCACGAGTGTGCCAAAGGCAGTGACAGCCGCGCTGAAAA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ATTATTAGATCACATTAATCATGAGGGTGCCAAAGGCACTGACAGCAGCCCTGAAAAG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***********       *** * ***  ******     ***** 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18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SHZ3.7761 </a:t>
            </a:r>
          </a:p>
        </p:txBody>
      </p:sp>
      <p:sp>
        <p:nvSpPr>
          <p:cNvPr id="7" name="Rectangle 6"/>
          <p:cNvSpPr/>
          <p:nvPr/>
        </p:nvSpPr>
        <p:spPr>
          <a:xfrm>
            <a:off x="3218646" y="872066"/>
            <a:ext cx="952500" cy="378565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3218646" y="56966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5796746" y="570176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796746" y="872066"/>
            <a:ext cx="558800" cy="378565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250304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rabbit           CTTAACCTTTGACAGAATTCTACAGAAACTGTTCATCATCGCCCACGCCTTGATTAATT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TAACCTTTGACAGAATTCTACAGAAACTGTTCATCATCGCCT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TAACCTTTGACAGAATTCTACAGAAACTGTTCATCATCGCCCACGCTC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TAACCTTTGACAGAATTCTACAGAAACT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TAACCTTTGACAGAATTCTACAGAAACTGTTCATCATCGCCCACGCTTTGATTAATT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TAACCTTTGACAGAGTTCCACAGAAACTGTTCATCATCGCCCCCGCTTTGATTAATT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TAACCTTTGACAGAATTCCACAGAAACTGTTCATCATCACCCCTGCTTTGATTCATTT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TAACCTTTGACAGAATTCTACAGAAACTGTTCATCATCGCCCCCGCTTTGATTAATT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TAACCTTTGACAGAATTCTACAGAAACTGTTCATCACCGCCCC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TTAACCTTTGACAGAATTCTTCAGAAACTGTTCATCATCGCCCACGCTTTGATTAATTC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TAACCTTTGACAGAATTCTACAGAAACG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TAACCTTTGACAGAGTTCCACAGAAACC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TAACCTTTGACAGAGTTCCACAGAAACCGTTCATCATC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TAACCTTTGACAGGATTCCGCAGGAGCCGTTCATCACGGCCCACGCTTTGATTAATTT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***  ***  *** * * ********   **   **  ***** 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TSHZ3.7774 </a:t>
            </a:r>
          </a:p>
        </p:txBody>
      </p:sp>
      <p:sp>
        <p:nvSpPr>
          <p:cNvPr id="7" name="Rectangle 6"/>
          <p:cNvSpPr/>
          <p:nvPr/>
        </p:nvSpPr>
        <p:spPr>
          <a:xfrm>
            <a:off x="6584146" y="872066"/>
            <a:ext cx="952500" cy="46317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2837646" y="872066"/>
            <a:ext cx="558800" cy="46317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6584146" y="56992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2837646" y="56992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77284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08839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325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TGCATCCGACGCCATCATTTTTCTTTCTAATTACGGAGGTGTCAGGTCGAGCTGTCATGC 34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CATCCGACGCCATCATTTTTCTTTCTAATTACGGAGGTGTCAGGTCGAGCTGTCATGC 34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CATCCGACGCCATCATTTTTCTTTCTAATTACGGAGGTGTCAGGTCGAGCTGTCATGC 35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CATCCGACGCCATCATTTTTCTTTCTAATTACGGAGGTGTCAGGTCGAGCTGTCATGC 34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CATCCGACGCCATCATTTTTCTTTCTAATTACGGAGGTGTCAGGTCGAGCTGTCATGC 10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CATCCGACGCCATCATTTTTCTTTCTAATTACGGAGGTGTCAGGTCGAGCTGTCATGC 34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CATCCGACGCCATCATTTTTCTTTCTAATTACGGAGGTGTCAGGTCGAGCTGTCATGC 34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CATCCGACGCCATCATTTTTCTTTCTAATTACGGAGGTGTCAGGTCGAGCTGTCATGC 34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CATCCGACGCCATCATTTTTCTTTCTAATTACGGAGGTGTCAGGTCGAGCTGTCATGC 34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CATCCGACGCCATCATTTTTCTTTCTAATTACGGAGGTGTCAGGTCGAGCTGTCATGC 34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CATCCGACGCCATCATTTTTCTTTCTAATTACGGAGGTGTCAGGTCGAGCTGTCATGC 34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CATCCGACGCCATCATTTTTCTTTCTAATTACGGAGGTGTCAGGTCTAGCTGTCATGC 35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CATCCGACGCCATCATTTTTCTTTCTAATTACGGAGGTGTCAGGTCTAGCTGTCATGC 35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CATCCGACGCCATCATTTTTCTTTCTAATTACGGAGGTGTCAGGTCGGGCTGTCATGC 351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CATCGGACGCCATCATTTTTCTTTCTAATTACGGAGGTGTCAGGTCGGGCTGTCATGC 21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CATCGGACGCCATCATTTTTCTTTCTAATTACAGAGGTGTCAGGTCGGGCTGTCATGC 23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CATCGGACGCCATCATTTTTCTTTCTAATTACGGAGGTGTCAGGTCGGGCTGTCATCT 2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CATCGGACGCCATCATTTTTCTTTCTAATTACGGAGGTGTCAGGTCGGGCTGTCATGC 33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CATCGGACGCCATCATTTTTCTTTCTAATTACGAAGGTGTCAGGTCGGGCTGTCATGC 33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CATCGGACGCCATCATTTTTCTTTCTAATTACGAAGGTGTCAGGTCGGGCTGTCATGC 33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CATCGGACGCCATCATTTTTCTTTCTAATTACGGAGGTGTCAGGTCGGGCTGTCATGC 33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CATCGGACGCCATCATTTTTCTTTCTAATTACGGAGGTGTCAGGTCGGGCTGTCATGC 24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 ***************************  ************  ********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AGGCGCTGATTTTCAATTTAACTGATCATCATACATTCATTTTCCCATTTGATAAATCTG 40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GCGCTGATTTTCAATTTAACTGATCATCATACATTCATTTTCCCATTTGATAAATCTG 40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GCGCTGATTTTCAATTTAACTGATCATCATACATTCATTTTCCCATTTGATAAATCTG 41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GCGCTGATTTTCAATTTAACTGATCATCATACATTCATTTTCCCATTTGATAAATCTG 40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GCGCTGATTTTCAATTTAACTGATCATCATACATTCATTTTCCCATTTGATAAATCTG 16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GCGCTGATTTTCAATTTAACTGATCATCATACATTCATTTTCCCATTTGATAAATCTG 40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GCGCTGATTTTCAATTTAACTGATCATCATACATTCATTTTCCCATTTGATAAATCTG 40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GCGCTGATTTTCAATTTAACTGATCATCATACATTCATTTTCCCATTTGATAAATCTG 40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GCGCTGATTTTCAATTTAACTGATCATCATACATTCATTTTCCCATTTGATAAATCTG 40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GCGCTGATTTTCAATTTAACTGATCATCATACATTCATTTTCCCATTTGATAAATCTG 40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GCGCTGATTTTCAATTTAACTGATCATCATACATTCATTTTCCCATTTGATAAATCTG 40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GCGCTGATTTTCAATTTAACTGATCATCATACATTCATTTTCCCATTTGATAAATCTG 41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GCGCTGATTTTCAATTTAACTGATCATCATACATTCATTTTCCCATTTGATAAATCTG 41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GCGCTGATTTTCAATTTAACTGATCATCATACATTCATTTTCCCATTTGATAAATCTG 411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GCGCTGATTTTCAATTTAACTGATCATCATACATTCATTATACCATTTGATAAATCTG 27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GGCGCTGATTTTCAATTTAACTGATCATCATACATTCATTTTCCCATTTGATAAATCTG 29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GGCGCTGATTTTCAATTTAACTGATCATCATACATTCATTTCCCCATTTGATAAATCTG 27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GCGCTGATTTTCAATTTAACTGATCATCATGCATTCATTTTCCCATTTGATAAATCTG 39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ACGCTGATTTTCAATTTAACTGATCATCACGCATTCATTTTCCCATTTGATAAATCTG 39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ACGCTGATTTTCAATTTAACTGATCATCACGCATTCATTTTCCCATTTGATAAATCTG 39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ACGCTGATTTTCAATTTAACTGATCATCATGCATTCATTTTCCCATTTGATAAATCTG 39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ACGCTGATTTTCAATTTAACTGATCATCGTGCATTCATTTCCCCATTTGATAAATCTG 30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 ***************************   ********   ******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585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UNC4.1.9830</a:t>
            </a:r>
          </a:p>
        </p:txBody>
      </p:sp>
      <p:sp>
        <p:nvSpPr>
          <p:cNvPr id="7" name="Rectangle 6"/>
          <p:cNvSpPr/>
          <p:nvPr/>
        </p:nvSpPr>
        <p:spPr>
          <a:xfrm>
            <a:off x="6476706" y="5830679"/>
            <a:ext cx="952500" cy="418235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5379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Right Arrow 15"/>
          <p:cNvSpPr/>
          <p:nvPr/>
        </p:nvSpPr>
        <p:spPr>
          <a:xfrm>
            <a:off x="6698446" y="53918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698446" y="872066"/>
            <a:ext cx="558800" cy="432223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4782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6476706" y="103347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9403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dog              GACCTGTCAGTTCATATGGACAAATCTCCTGCTTACTGAAATGTACAAAATAAATC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ACCTGTCAGTTCATATGGACAAATCT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ACCTGTCAGTTCATATGGACAAATCCCCTGCTTACTGAAATGTACAAAATAAATCATTG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ACCTGTCAGTTCATATGGACAAATCCCCTGCTTACTGAAATGTAC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ACCTGTCAGTTGTTATGGACAAATCTCCCGCATCGTGAAATGTACAAAATAAATC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ACCTGTCAGTGAGTATGGACAAATCTCTCGCTCGCAGAAATGTAG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ACCTGTCAGCGAGTATGGACAAATCTCTCGCTCGCAGAAACGTAGAAAATAAATC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ACCTGTCAGTGGGTATGGACAAATCTCTCGCTCGCAGAAATGTAGAAAATAAATC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ACCTGTCAGTGGCTATGGACAAATCTCTCGCTCGCAGAAATGTAGAAAATAAATCATT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ACCTGTCAGCGCGTATGGACAAATCTCTCGCTCGCAGAAATGTAGAAAATAAATCATT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    ************ *  **     **** *** ********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40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DACHD.240</a:t>
            </a:r>
          </a:p>
        </p:txBody>
      </p:sp>
      <p:sp>
        <p:nvSpPr>
          <p:cNvPr id="7" name="Rectangle 6"/>
          <p:cNvSpPr/>
          <p:nvPr/>
        </p:nvSpPr>
        <p:spPr>
          <a:xfrm>
            <a:off x="6311606" y="872066"/>
            <a:ext cx="952500" cy="463174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70100" y="579337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2292056" y="872066"/>
            <a:ext cx="558800" cy="4631748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Arrow 23"/>
          <p:cNvSpPr/>
          <p:nvPr/>
        </p:nvSpPr>
        <p:spPr>
          <a:xfrm>
            <a:off x="2292056" y="564732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Left Arrow 24"/>
          <p:cNvSpPr/>
          <p:nvPr/>
        </p:nvSpPr>
        <p:spPr>
          <a:xfrm>
            <a:off x="6311606" y="5664024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081772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AGCTGTCATTG-TGT--TTGAACTTCAGTCCT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CTGTCATTG-T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CTGTCACTG-AGC--TTGAACTTCAGTCT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CTGTCACTG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CTGTCACTG-AGC--TTGAACTTG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GCTGTCACTG-AGC--TTGAACTTCAGTCCTAGTGATTAATGAAAAGCTGCAGGGCAC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CTGTCACTG-AGC--TTGAACTTCAGTCCT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CTGTCACCA-AGC--TTGAACTTCAGTCCCA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CTGTCACTG-GGC--TTGAACTTCAGTCCTCGTGATTAATGAAAAGCTGCA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AGCTGTCACGA-TAC--TTGAACTTCAGTCCTAGTGATTAATGAAAAGCTGCAA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CTGTCAGTG-AGC--</a:t>
            </a:r>
            <a:r>
              <a:rPr lang="en-US" sz="1200" dirty="0" smtClean="0">
                <a:latin typeface="Courier New"/>
                <a:cs typeface="Courier New"/>
              </a:rPr>
              <a:t>T-</a:t>
            </a:r>
            <a:r>
              <a:rPr lang="en-US" sz="1200" dirty="0">
                <a:latin typeface="Courier New"/>
                <a:cs typeface="Courier New"/>
              </a:rPr>
              <a:t>GAACTTCAGTCCTAGTGATTAATGAAAAGCTGCAGGGCACA 5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CTGTCAGTG-AGC--T-GAACCTCAGTCCCAGTGATTAATGAAAAGCTGCAGGGCACA 5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GCTGTCACTG-AGCAGCGGAACTTCAGTCCTGGTGATTAATGAAAGGCTGTGGGGCACA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</a:t>
            </a:r>
            <a:r>
              <a:rPr lang="en-US" sz="1200" dirty="0" smtClean="0">
                <a:latin typeface="Courier New"/>
                <a:cs typeface="Courier New"/>
              </a:rPr>
              <a:t>AGCTGTCACAG-TGT--CGTAGCTTTAGCCCATTTGATTAATGATGAGCTGT-</a:t>
            </a:r>
            <a:r>
              <a:rPr lang="en-US" sz="1200" dirty="0">
                <a:latin typeface="Courier New"/>
                <a:cs typeface="Courier New"/>
              </a:rPr>
              <a:t>GGGCGCA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CTGTCACGCATGC--CTCCGCTTCATTCAGCTTGATTAATGATAAGCTGTGGGGCACA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CTGTCACAC-TGC--CTCTGCTTCATTCAGCTTGATTAATGATAAGCTGTGGGGCACA 5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CGTGTCACAT-CGC--CTCGGCTTCATTCAACTTGATTAATGATGAGCTGTGGGGCACA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CTGTCACAA-CGC--CTCAGCTTCACTCAGCTTGATTAATGATAAGCTGTGGGGCACT 5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 *****              * * *  *    **********   ****   ***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278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IC1.5745</a:t>
            </a:r>
          </a:p>
        </p:txBody>
      </p:sp>
      <p:sp>
        <p:nvSpPr>
          <p:cNvPr id="7" name="Rectangle 6"/>
          <p:cNvSpPr/>
          <p:nvPr/>
        </p:nvSpPr>
        <p:spPr>
          <a:xfrm>
            <a:off x="5105106" y="872066"/>
            <a:ext cx="952500" cy="482515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5105106" y="569922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189946" y="872066"/>
            <a:ext cx="558800" cy="480973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2189946" y="5692136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312763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2242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10802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-AATGCTTTTCTCTATTAATCAGACCTTGC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AATGCTTTTCTCTATTAATCAGAGCTCACC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AATGCTTTTCTCTATTAATCAGAGCTCAC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-AATGCTTTTCTCTATTAATCAGAGCTCCCAGCTCG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-AATGCTTTTCTCTATTAATCAGAGCCCAGAGCTCAGATTGGTCTTCAACTTCCT-CCCA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-AATGCTTTTCTCTATTAATCAGAGCTCAGAGCTCAGATTGGTCTTCAACTTCCT-TCCA 5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-AATGCTTTTCTCTATTAATCAGAGCTCG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-AATGCTTTTCTCTATTAATCAGAGCTCAGAGCTCAGATTGGTC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AATGCTTTTCTCTATTAATCAGAGCTCAGAGCTCAGATTGGTG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AATGCTTTTCTCTATTAATCAGAGCTCAGAGCTCAGATTGGTGTTCAACTTCCT-CCCA 5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AATGCTTTTCTCTATTAATCAGAGCTTTCAGTTTGGCCTGGTCTTGAGATTGCT-TCCA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TGCTTTTTCTCCATTAATCGGGGCTCACAGCTCAAACTGGCCTTCAACTTCCTCCCC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ATGCGTTTTCTTCATTAATCGTGGCTCACAGCTCAAACTGGCCTTCAACTTTCTACCC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----TTTTTTCTATTAATCAGAGCTCGCAGCTCAAACTGGGCTTTAACTTCCTCCCCA 5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---TTTTCTCTAATAATCAGAGCTTACAGCTCAAACTGGTCTTCAACTTCCTCCCCA 5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---TTCTCTATTAATCAGAGCTCACAGTTCAAACTGGTCTTCAACTTCCTCCCCA 5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** *  * *****    *     * *     ***  ** *  ** **  *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frog             ATCCTTGCTAAGCCTGTCATTTCTAT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TCTTTGCTAAGCCTGTCATTTCTAGCTATTATTTACTTTAATGGACTTT-GGCTGATCT 11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TCCTTGCTAAGCCTGTCATTTCTAGCTATTATTTACTTTAATGGACTTT-GGCTGATCC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TCCTTGCTAAGCCTGTCATTTCTAGCTATTATTTACTTTAATGGAT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TCCTTGCTAAGCCTGTCATTTCTA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TCCTTGCTAAGCCTGTCATTTCTG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TCCTTGCTAAGCCTGTCATTTCTGGCTATTATTTACTTTAATGGACTTT-GGCTGATCC 11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TTCTGGATAAGCTCGTCGTTTCTAGCTATTATTTAATTTAATGGACTTTTGGCTGATCC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TCCTTGCTAAGCCTGTCATTTCTGGCTATTATTTACTTTAATGGGCTTT-GGCTGATC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TCCTCACTAAGCCTGTCATTTCTGGCTATTATTTACTTTAATGGGCTTT-GGCTGATCC 11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TCCTGGGTAAGCCTGGGATTTCTGGGTATTATTTACTTTAATGGGCTTT-GGGTGATCC 11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TCCGTGCTAAGCCTGTCATTTCTGGCTATTATTTACTTTAATGGGCTTT-GGCTGATCC 11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TCCGCACTAAGCCTGTCATTTCTGGCTATTATTTACTTTAATGGGCTTT-GGCTGATCC 111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     *****  *   *****   ********* ********  *** ** 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278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IC1.5763 </a:t>
            </a:r>
          </a:p>
        </p:txBody>
      </p:sp>
      <p:sp>
        <p:nvSpPr>
          <p:cNvPr id="7" name="Rectangle 6"/>
          <p:cNvSpPr/>
          <p:nvPr/>
        </p:nvSpPr>
        <p:spPr>
          <a:xfrm>
            <a:off x="3098506" y="872067"/>
            <a:ext cx="952500" cy="508405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15208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3098506" y="6084203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218646" y="6528704"/>
            <a:ext cx="558800" cy="502031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1828724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Right Arrow 19"/>
          <p:cNvSpPr/>
          <p:nvPr/>
        </p:nvSpPr>
        <p:spPr>
          <a:xfrm>
            <a:off x="3218646" y="1167813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56065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1887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694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squirrel         ------CTTAAAATGCAACGGTTCTGTCATCTCAAGTA-CACTT-ACTGAAAGCAAC-AT 51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TTCATCTTAAAATGCAATG-TTCTGTCATCTCAAGTAATACTT-ACTGAAAA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TTCATCTTAAAATGCAATG-TTCTGTCATCTCAAGTAACACTC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TTCATCTTAAAATGCACTG-TTCTGTCATCTTGAGTAACACTT-ACTGAAAGCAACCAT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TTCATCTTAAAATGCAAT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TTCATCTTAAAATGCAATA-TTCTGTCATCTAAG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TTCATCTTAAAACGCAACG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TTCATCTTAAAACGCAACA-TTCTGTCATCTCAAGTAACACTT-ACTGAAAGCAACCAT 5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TTCATCTTAAAATGCAATG-TTCTGTCATCTCCAGTAACACTT-ACTGAAAGCAACCAT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TTCATCTTAAAATGGATTG-CTCTGTCACCTGGACTAACACTTTACTGAGAGCAGCCAT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TTCATCTTAAAATGGATTG-CTCTGTCACCTGGACGAACACTTTACTGAGAGAAGC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TTCATCTTAAAATGGATTG-CTCTGTCACCTGGACTAACACTTTACTGAGAGCGGC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TTCATCTTAAAATGGATTG-CTCTGTCACCTGGACTAACACTTTACTGAGAGCAGCCA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TTCATCTTAAAATGGATTG-CTCTGTCACCTCCACTAACACTT-ACTGAGAGCACCCAT 58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******* * *     ******* **     *  ***  ***** *    * 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squirrel         CAATACTTTTTGTCAAAAGGCCCGTACTCTGTGTAAA-TGTTCCATCAATCTCTATTTAC 11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AATACTTTTTGTCAAAAG-CCT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ATACTTTTTGTCAAAAG-ACT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AATACTTTTTGTCAAAAG-CCT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AATACTTTTTGTCAAAAG-CCT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AATACTTTTTGTCAAAAG-CCCGTACTCTGTGTAAAATGTTCCATCAATCTCTATTTAC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AATACTTTTTGTCAAAAG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AATACTTTTTGTCAAAAA-CCC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AATACTTTTTGTCAAAAG-CCT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AATACTTTTTGTCAAAAG-CCTGTACTCTGTGTAAAATGTTCCATCAATCTCT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AATACTTTTTGTCAAAAA-CCTGCACTCTGTGTAAAATGTTCCATCAATCTCTATTTAC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AATACTTTTTGTCAAAAA--CTGCAGGCTGTGCCAGACATGCCATCAATCACCATTTAC 11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AATACTTTTTGTCAAAAA--CTGCAGGCAGTGCCAGACATGCCATCAATCACCATTTAC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AATACTTTTTGTCAAAAA--CTGCAGGCTTCGCCAGACGTGTCATCAATCACCATTTAC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AATACTTTTTGTCTAAAA--CTGCAGGCTTCACCAGACATGTCATCAATCACCATTTAC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AATACTTTTTGTCAAAAG--CTGCACACTAGGTAAGATGTGCCATCAATCACTATTTAC 11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** ***   * * *  *      *    *  ******** * ******</a:t>
            </a:r>
          </a:p>
        </p:txBody>
      </p:sp>
      <p:sp>
        <p:nvSpPr>
          <p:cNvPr id="7" name="Rectangle 6"/>
          <p:cNvSpPr/>
          <p:nvPr/>
        </p:nvSpPr>
        <p:spPr>
          <a:xfrm>
            <a:off x="5847546" y="6019800"/>
            <a:ext cx="952500" cy="443230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68398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4133046" y="872067"/>
            <a:ext cx="558800" cy="45198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74937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503.10049 </a:t>
            </a:r>
          </a:p>
        </p:txBody>
      </p:sp>
      <p:sp>
        <p:nvSpPr>
          <p:cNvPr id="17" name="Left Arrow 16"/>
          <p:cNvSpPr/>
          <p:nvPr/>
        </p:nvSpPr>
        <p:spPr>
          <a:xfrm>
            <a:off x="5847546" y="10593162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ight Arrow 17"/>
          <p:cNvSpPr/>
          <p:nvPr/>
        </p:nvSpPr>
        <p:spPr>
          <a:xfrm>
            <a:off x="4133046" y="553793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2824946" y="6019800"/>
            <a:ext cx="558800" cy="443230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2824946" y="10603321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184500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CTCTGTCACAG-TTCACCTTCATTCCC-TGGACACAAATTCAA-GTTGTCATCCATCATT 223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CTGTCACAG-TTCACCTTCATTCCC-TGGACACAAATTCAA-GTTGTCATCCATCATT 223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CTGTCACAG-TTCACCTTCATTCCC-TGGACACAAATTCAA-GTTGTCATCCATCATT 20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CTGTCACAG-TTCACCTTCATTCCC-TGGACACAAATTCAA-GTTGTCATCCATCATT 223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CTGTCACAG-TTCACCTTCATTCCC-TGGACACAAATTTAA-GTTGTCATCCATCATT 83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CTGTCACAG-TTCACCTTCATTCCC-TGGACACAAATTTAATGTTGTCATCCATCATT 101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CTGTCACAG-TTCACCTTCATTCCC-TGGACACAAATTTAA-GTTGTCATCCATCATT 222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CTGTCACAG-TTCACCTTCATTCCC-TGGACACAAATTTAA-GTTGTCATCCATCATT 22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CTGTCACAG-TTCACCTTCATTCCC-TGGACACAAATTTAA-GTTGTCATCCATCATT 221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CTGTCACAG-TTCACCTTCATTCCC-TGGACACAAATTTAA-GTTGTCATCCATCATT 223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CTGTCACCA-TTCACCTTCATTCCC-TGGACACAAATTTAA-GTTGTCATCCATCATT 203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CTGTCACAG-TTCACCTTCATTCCC-TGGACACAAATTTAA-GTTGTCATCCATCATT 223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CTGTCACAG-TTCACCTTCATTCCC-TGGACACAAATTTAA-GCTGTCATCCATCATT 223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CTGTCACAG-TTCACCTTCATTCCC-TGGACACAAATTTAA-GCTGTCATCCATCATT 223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TCTGTCACAGATTCACCTTCATACCCATGGACACAAATTTAG-TTTGTCATCCATCATT 231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CTGTCACAG-TTCACCTTCATTCCC-TGGACACAAATTTAA-GTTGTCATCCATCATT 22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CTGTCACAG-TTCACCTTCACTCCC-CAGACACAAATTTAA-CTTGTCATCCATCATT 22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CTGTCACAG-TTCACCTTCACTCCC-CAGACACAAATTTAA-CTTGTCATCCATCATT 22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CTGTCACAG-TTCACCTTCACTCCC-CAGACACAAATTTAA-CTTGTCATCCATCATT 22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CTGTCACAG-TTCACCTTCACTCCC-CAGACACAAATTTAA-CTTGTCATCCATCATT 22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CTGTCACAG-TTCACCTTCACTCCC-CCAACACAAATTTAA-CTCGTCATCCATCATT 22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TCTGTCACAG-TTCACCCTCATTCCC-TGGACACAAATTTAA-CTTGTCATCCATCATT 22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GCTGTCACCA-TTCACCTTCATTCCC-TGGGCACACATTTAA-GATGTCATCCATCATT 133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******   ****** ***  ***     **** *** *     *************</a:t>
            </a:r>
          </a:p>
        </p:txBody>
      </p:sp>
      <p:sp>
        <p:nvSpPr>
          <p:cNvPr id="7" name="Rectangle 6"/>
          <p:cNvSpPr/>
          <p:nvPr/>
        </p:nvSpPr>
        <p:spPr>
          <a:xfrm>
            <a:off x="6387806" y="872067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6387806" y="61157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2202646" y="61157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202646" y="872066"/>
            <a:ext cx="558800" cy="4524315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503.10105</a:t>
            </a:r>
          </a:p>
        </p:txBody>
      </p:sp>
    </p:spTree>
    <p:extLst>
      <p:ext uri="{BB962C8B-B14F-4D97-AF65-F5344CB8AC3E}">
        <p14:creationId xmlns:p14="http://schemas.microsoft.com/office/powerpoint/2010/main" val="1132781540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1887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510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himp    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GTCAAACCCGCCAACGATAATATATGGCCT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GTCAGACCCGCCAACGATAATGTATGGCCCGACCG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GTCAAACCCGCCAACGATAATATATGGCCCGACCAACAAGAACAGCTGTAGT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GTCAAAC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GTCAAAGCCGCCAACGATAATATATGGCCCG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GTCAAACCCGCCAACGATAATATATGGCCCGACCAACG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GTCAAACCCGCCAACGATAATATATGGCCCGACCAACGAGAACAGCTGTAGCCACTCT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GTCAAACCCGCCAACAATAATATATGGCCCAACCAACA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GTCAAAGCCGCCAACTATAATATATGGCCCGACCAAAGAGAACAGCTGTAGCCATTCT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GTCAGAGCCAGCCAGGGTAATATATGTCCTGAGCAAAGTGAACAGCTGTAAGCATTC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GTCAAACACGCCAACTATAATATATGGCCCCTCCAATGAGAACAGCTGTAGCCATTC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GTCAAAGCCGCCAAGTATAATATATGGCCTCTCCAATGAGAACAGCTGTAGCCACTCT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GTCAAGGCCACCACGTATAATATATGGCCTCCCCAATGAGAACAGCTGTAGCCACTC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GTCAAAGCCGCCAACTATAATATATGGCCCCTCCAATGAGAACAGCTGTAGCCGCTC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GTCAAAGCCGCCAAGTATAATATATGGCCCCTCCAATGAGAACAGCTGTAGCTGCTCT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    *  *     **** **** **    * *   ***********     *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chimp            CTCC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CC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CC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CC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CT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CTGCAGGTTCC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CT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CT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CTGCAGGTTCTC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CT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CG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CCGCAGGTTCT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CGGCAGGTTCC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CGGCAGGTTCC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CTGCTGGTTCCTGC-ACCCTGTTCTGCATAA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CTCCTGGTTCCTGT-ACCCTGCTCTGCATAAAATAATAT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GTGCTGCTCCCTGT-ACCCTGTCCTGCATAAAATAATACATCAAGATTAATTGATTTG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CCGCTGCCTCTTGT-ACCCCGTCCTGCATGAAATAATATATCAAGATTAATTGATTT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CTGC-TGCT---GCTACCCTGCCCTGCACGAAATAATACATCAAGATTAATTGATTTC 11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CTCTGTGCT---GCTGC--TACCCTGCATGAAATAATACATCAAGATTAATTGATTTC 11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CCGC-TGCCACGGCTACCCTGCCCCGCACCCAATAATACATCAAGATTAATTGATTT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CTGC-TGCCACGGCTAGCCTGCCCCACACCCAATAATACATCAAGATTAATTGATTTC 11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           *          *  **   ******* ****************** </a:t>
            </a:r>
          </a:p>
        </p:txBody>
      </p:sp>
      <p:sp>
        <p:nvSpPr>
          <p:cNvPr id="7" name="Rectangle 6"/>
          <p:cNvSpPr/>
          <p:nvPr/>
        </p:nvSpPr>
        <p:spPr>
          <a:xfrm>
            <a:off x="5207224" y="6028265"/>
            <a:ext cx="952500" cy="425311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68398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2032000" y="872065"/>
            <a:ext cx="558800" cy="4253115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1074937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503.10147 </a:t>
            </a:r>
          </a:p>
        </p:txBody>
      </p:sp>
      <p:sp>
        <p:nvSpPr>
          <p:cNvPr id="17" name="Left Arrow 16"/>
          <p:cNvSpPr/>
          <p:nvPr/>
        </p:nvSpPr>
        <p:spPr>
          <a:xfrm>
            <a:off x="5207224" y="10603321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ight Arrow 17"/>
          <p:cNvSpPr/>
          <p:nvPr/>
        </p:nvSpPr>
        <p:spPr>
          <a:xfrm>
            <a:off x="2032000" y="553793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488452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244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106182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GAGCAGTGGCGGAGAC-AGATCGACGAAGCTG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AGCAGTGGCGGAGAC-AGATCGACGAAGCTG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AGCAGTGGCGGAGAC-AGATCGACGAAGCTG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AGCAGTGGCGGAGAC-AGATCGACGAAGCTGACAGTGTGGTATTCATCCTGCGTGGTAG 16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AGCAGTGGCGGAGAC-AGATCGACGAGGCTG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AGCAGTGGCGGAGAC-AGATCGACGAGGCTG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AGCAGTGGTGGAGAC-AGATCGACGAAGCTGACAGTGTGGTATTCATCCTGCAC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AGCAGTGGTGGAGAC-AGATCGACGAAGCTGACAGTGTGGTATTCATCCTGCAC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GCAGTGGTGGAGAC-AGATCGACGAAGCTGACAGTGTGGTATTCATCCTGCGCGGTGG 16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AGCAGTGGCGGAGAC-AGATCGACGAAGCTG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--GCAGTGGCGGAGAC-GGATCGACGAAGCTGACAGTGTGGTATTCATCCTGCGTGGTGG 16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CACGGCGGCGGAGAC-AGATCGACGGAGCTA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CACAGTGGCGGAGAC-AGATCGACGAAGCTGACAGTGTGGTATTCATCCTGCGTGGTGC 16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CGCGGCGGTGGAGAC-AGATCGACGGAGCTGACAGCGCGGCATTCATCCCGCGCGCCGG 16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CA--GTGGTGGAGAC-AGATCGACGGAGCTGACAGTGTGGTATTCATCCTGCGCCGCGC 16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AGCAGTGGCGGAGAC-AGATCGACGGAGCTGACAGTGTGGTATTCATCCTGCGTGGTGG 169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-------------------------------------------------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CGCAGTGGCAGAGAC-AGATCGACAGAGCTGACAGTGTGGTATTCATCCTGCATGGTAC 7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CG----CAAGGAGAC-GGATGGACGGGAGTGACAGGCCGGTATTCATCGTGCACGCCCC 13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CG----CGTGGAGAC-GGATGGACGGGAGTGACAGGCCGGTATTCATCCTGCACGCCCC 16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CG----AGAGGAGAC-GGATGGACAGGACTGACAGGCTGGTATTCATCCTGCACGCCCC 17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CG----AGAGGAGAC-GGATGGACGGGAGTGACAGGCTGGTATTCATCCTGCACGCCCC 16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AG----AGA-AAGGCTGGCCTGGCCAGGATGACAGCAATGCATTCATCCTCCACGCTAC 11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CG----AGAGAAGGATGGAC-AGC---GCTGACAGCGGCGTATTCATCCTGCACGCTAC 152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------------GAT-AGATGGACATGGCTGACACTTCTGAATCCATTCTGCATGGTAC </a:t>
            </a:r>
            <a:r>
              <a:rPr lang="en-US" sz="1200" dirty="0" smtClean="0">
                <a:latin typeface="Courier New"/>
                <a:cs typeface="Courier New"/>
              </a:rPr>
              <a:t>46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                             </a:t>
            </a: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AGCAGACG-CCCTGCTAGTGGCAGC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GCAGACG-CCCTGCTAGTGGCAGC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GCAGACG-CCCCGCTAGTGGCAGC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GCAGACG-CCCCGCTAGTGGCAGC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GCAGGCG-TCCCGCTAGTGGCGGG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GCAGGCG-TCCCGCTAGTGGCGGT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GCAGACG-CCCCGCTAGTGGCAGT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GCAGACG-TCCCGCTAGTGGCAGT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GCAGGCG-TCCCGCTAGTGGCAGTAGACAGCG-CAATAAATCAAGGGCTCTCGAAGCTG 225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GCAGACG-TCCCGCTAGTGGCAGT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GCAGACGTCCCCGCTAGTGGCAGTAGACAGTG-CAATAAATCAAGGGCTCTCGAAGCTG 22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GCAGACG-CCCCGCTAGTGGCAGT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GCAGACG-GCCCGCTAGTGGCAGG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GCAGACG-CCCCGCTAGTGGCAGGAGACAGCA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GCAGACG-TCCCGCTAGTGGCAGGAGACAGCG-CAATAAATCAAGGGCTCTCGAAGCTG 22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GCAGGCG-TCCCGCTAGTGGCAGCAGACAGCG-CAATAAATCAAGGGCTCTCGAAGCTG 22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CAGACG-TCCTGCTTGTGGTGGTCGACAGAG-CAATAAATCAAGGGCTGGCGATGCTG 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GCAGACG-TCCTGCTAGTGGCAGTCGACAGTG-CAATAAATCAAGGGCTCTCGATGCTG 13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GTGGCCG-GACTGCTACTGGCGCTCGACAGAG-CAATAAATCACCAGCTCTCCACTCTG 18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GCGGCCG-GACTGCTACTGGAGCTCGACAGAG-CAATAAATCACCAGCTCTCCAGTCTG 22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CGGCCG-GACTGCTACTGGCGCTCGACAGAG-CAATAAATCACCAGCTCTCCAGTCTG 22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GCGGCCG-GACCGCTACTGGCGCTCGGCAGAG-CAATAAATCACCGGCTCTCCAGTCTG 22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GCAGACA-AAGCGCTGGCACTGCCTGACAGGGACCATAAATCATGAGCAGGAGATGCTG 16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GCAGACG-TCCCGCTAGTGCTGGTCGACAGAG-CAATAAATCAAGGGCCCTCCATGCTG 21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CCAGTTG-CGACGTTACTTGCTGCAGACAGCG-CAATAAATCAAGGTCTGCCGGTGCTG 104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*        * *          * ***   * ********    *        ***</a:t>
            </a:r>
          </a:p>
        </p:txBody>
      </p:sp>
      <p:sp>
        <p:nvSpPr>
          <p:cNvPr id="7" name="Rectangle 6"/>
          <p:cNvSpPr/>
          <p:nvPr/>
        </p:nvSpPr>
        <p:spPr>
          <a:xfrm>
            <a:off x="5118324" y="6591506"/>
            <a:ext cx="952500" cy="478769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13556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4775200" y="872066"/>
            <a:ext cx="558800" cy="481191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1943100" y="1166698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503.10156 </a:t>
            </a:r>
          </a:p>
        </p:txBody>
      </p:sp>
      <p:sp>
        <p:nvSpPr>
          <p:cNvPr id="17" name="Left Arrow 16"/>
          <p:cNvSpPr/>
          <p:nvPr/>
        </p:nvSpPr>
        <p:spPr>
          <a:xfrm>
            <a:off x="5118324" y="11520932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Arrow 19"/>
          <p:cNvSpPr/>
          <p:nvPr/>
        </p:nvSpPr>
        <p:spPr>
          <a:xfrm>
            <a:off x="4775200" y="599459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674223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3157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510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TGAATTAGGAGAGACAGATGAGTGAGGCGCGAGCAGCGGAATAATACCATAATGTT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ATGAATTAGGGGAGACAGATGAGTGAGGCATGAGCAGCGGAATAATACTATAATGTTC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CGTATTGAGAGAGACAGATGAGTGAGGCGTGAGCGGCCGAGTAACGCTATAATGTT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CGAATTAAAGGAGACAGATGAGTAAG-CTTGAGCAGCACAGTAATACTATAATGTTC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ATGAATTAAAAAAGACAGATGAGTAAGCTATGAGCTGCAAAGTAATGCTATAATGTG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TGAATTAAACAAGACAGATGAGTAAGCTAC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GAATTAAACAAGACAGATGAGTAAGCTGTAGGCTGCAAAGTAAC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GAATTAAAAAAGACAGATGAGTAAGCTATGAGCTGCAAAGTAATA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GAATTAAAAAAGACAGATGAGTAAGCTATGAGCTGCAAAGTAATG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ATGAATTAAAACAGACAGATGAGTAAGCTATGCATACTGAAGTAATA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ATGAATTAAAAAAGACAGATGAGCAAGCCATGAGCTGCAAAGTAATACTATAATGTG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CGAATGAGGAGAGACAGATGAGTGAAGCATGAGCTGGAGTGTAATACTATAATGTGC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* * **      ***********  *                ***  * *******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CAGATATGAATATAAAATGACACAGCTGACAGGCCATACAAGGTTTTATTTCATTTC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CAGATATGAATATAAAATGACACCGCTGACAGGCCATACAAGGTTTTATTTCATTTCT 12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TAGATATGAATATAAAATGACACAGCTGACAGGCCATACAAGGTTTTATTTCATTTC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TAGATATGAATATAAAACGACACAGTTGACAGTCCATACAAGGTTTTATTTCATTTCT 11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TTAGATATGAATATCAACTGACACCCCTGACAGGCCATACAAGGTTTTATTTCATTTTG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TTAGATATGAATATCAACTGACACCCCTGACAGGCCATACAAGGC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TTAGATAT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TAGATAGGAATATCAACTGACACCCCTGACAGGCCA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TTAGATATGAATATCAACTGACACCCTTGACAAGCCATACAAGGTTTTATTTCATTTTC 12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TTAGATATGAATATCAACTGACACCAGTGACAGGCCGTACAAGGTTTTATTTCATTTTG 12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TTAGATATGAATATCAACTGACACCTTTGACAGGCCATACAAGGTTTTATTTTATTTTG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TTAGATATGAATATAAAACGACATTGCTGACAGTCCACACAAGGTTAGATTTCATTTCT 12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 ***** ****** **  ****    *****  **  ****** *  **** **** </a:t>
            </a:r>
          </a:p>
        </p:txBody>
      </p:sp>
      <p:sp>
        <p:nvSpPr>
          <p:cNvPr id="7" name="Rectangle 6"/>
          <p:cNvSpPr/>
          <p:nvPr/>
        </p:nvSpPr>
        <p:spPr>
          <a:xfrm>
            <a:off x="2019300" y="896491"/>
            <a:ext cx="952500" cy="4342908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68397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4584924" y="6032500"/>
            <a:ext cx="558800" cy="424179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1943100" y="1076528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503.10185 </a:t>
            </a:r>
          </a:p>
        </p:txBody>
      </p:sp>
      <p:sp>
        <p:nvSpPr>
          <p:cNvPr id="22" name="Right Arrow 21"/>
          <p:cNvSpPr/>
          <p:nvPr/>
        </p:nvSpPr>
        <p:spPr>
          <a:xfrm>
            <a:off x="2019300" y="5540469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Arrow 22"/>
          <p:cNvSpPr/>
          <p:nvPr/>
        </p:nvSpPr>
        <p:spPr>
          <a:xfrm>
            <a:off x="4584924" y="10621772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986632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37856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TAAACATTCCTGCGCCGTGACAGGCTGACAGAAA-AACCCGGGCCCGCATCAATCATCGC 5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AACATTCCTGCGCCGTGACAGGCTGACAGAAA-AACCCGGGCCCGCATCAATCATCGC 5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AACATTCCTGCGCCGTGACAGGCTGACAGAAA-AACCCGGGCCCGCATCAATCATCGC 5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AACATTCCTGCGCCGTGACAGGCTGAAAGAAA-AACCCGGGCCCGCATCAATAATCGA 5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AACATTCCTGCGCCGTGACAGGCTGACAGCGG-GGCC--GGCGCGCATCCATCATGGC 5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AACATTCCTGCGCCGTGACAGGCTGACAGAAA-AACCCGGGCTCGCATCAATCATCCT 5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AACATTCCTGCGCCGTGACAGGCTGACAGAAA-AACCCGGGCTCGCATCAATCATCCT 5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AACATTCCTGCGCCGTGACAGGCTGACAGAAA-AACCCAGGCTCCCATCAATCATCGC 5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AACATTCCTGCGCCGTGACAGGCTGACAGAAA-AACCCAGGCTCCCATCAATCATCGC 5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AACATTCCTGCGCCGTGACAGGCTGACAGAAA-AACCCATGCTCCCATCAATCATCGC 5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AACATTCCTGCGCCCTGACAGGCTGACAGAAA-AACCCAGGCTCGCATCAATCATCGC 59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TAAACATTCCTGCTCCGTGACAGGCTGACAGAAA-AACCCAGCCTCACATCAATCATCTT 5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AACATTCCTGCTTTGTGACAGGCTGACAGAAA-AACCAAGCCTCACATCAATCATCT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AAACATTCCAGCCACCTGACAGGCTGACAAAAGCAGCCTGGCCCTGCATCAATCATCCG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AAACATTCCAGCCACCTGACAGGCTGACAAAAACAGCCCGGCCTCGCATCAATCATCC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AAACATTCCAGCCACCTGACAGGCTGACAAAAACAGCCTGACCGGACATCAATCATCC-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AAACATTCCTGCCTCCTGACAGGCTGACAGGA-AAGCCCAGCCTGGCATCAATCATCT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AACATTCCTGCCTCCTGACAGCCTGACAGAA-CAGCCAGAGCTGACATCAATCATCTA 5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AACATTTGTGTAGTGTGACAGGCAATCTGAGA-TGTGCAACCCTGCATCAATTATC-- 5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   *     ****** *                  *   **** ** 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503.10193</a:t>
            </a:r>
          </a:p>
        </p:txBody>
      </p:sp>
      <p:sp>
        <p:nvSpPr>
          <p:cNvPr id="7" name="Rectangle 6"/>
          <p:cNvSpPr/>
          <p:nvPr/>
        </p:nvSpPr>
        <p:spPr>
          <a:xfrm>
            <a:off x="6210006" y="872066"/>
            <a:ext cx="952500" cy="378565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6210006" y="5697217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3561546" y="5694505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561546" y="872066"/>
            <a:ext cx="558800" cy="378565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954564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3157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572506" cy="87716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at              -CTCAAGGCTGGTTTCTG---CCGCAGGAGTTCACTCGGTGTCCATAAATCATG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CTCAAGGCTGGTTTCTG---CCGCAGGAGTTCACTTGGTGTCCATAAATCATG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-CTCAAGGCTGGTTTCTG---CCGCAGGAGTTCACTCGGTGTTCATAAATCATG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-CTCAAGGCTGGTTTCTG---CCGCAGGAGTTCACTCAGTGTCCATAAATCATG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CTCCAGGCTGGTTTCTG---CCGCAGGAGTTCACTCAGTGTCCATAAATCATG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CTCCAGGCTGGTTTCTG---CCGCAGGAGTTCACTCTGTGTCCATAAATCATG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-CTCAAGGCTGGTTTCTG---CCGCAGGAGTTCACTCGGTGTCCATAAATCACA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-CTCAAGGCTGGTTTCTG---CCGCAGGAGTTCACTCGGTGTCCATAAATCACA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-CTCAAGGCTGGTTTCTG---CCGCAGGAGTTCACTCGGTGTCCATAAATCACAAGCTGC 56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-----AGGCCGGTTTCTG---C-GCAGGAGTTCACTCGGTGTCCATAAATCACAGGCTGC 51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-CTCAAGGCTGGTTTCTG---CCGCAGGAGTTCACTCGGTGTCCATAAATCACGGGCTGC 5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-CTCATGGCTGGTTTTTG---CCGCAGGAGTTCACTCAGTGTCCATAAATCATGGTCTGC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---------------------CAGGAGTTCACTTGGTGTCCATAAATCATTGACTGT 3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TCCCCGACTTGCTTTTTCGCCCGCAGGAGTTCACTTGCTGTCCATAAATCATAGGCTG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CACGACCTCACT-----GCCCGCAGGAGTTCACCGACTGTCCATAAATCAAGGGCTGC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------ACCTCACT-----GCCCGCAGGAGTTCAGCGACTGTCCATAAATCAAGGGCTGC 4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CCCCACCTCGCT-----GCCCGCAGGAGTTCACCGACTGTCCATAAATCAGGAGCTGC 55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TGC---------CGCAGGAGTTCACTCGCTGTCCATAAATCATAGACTGC 41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-CTCATGGCTGGTTTTTG---CCGCAGGAGTTCACTTGGTGTCCATAAATCATGGTGTGC 5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CTCATGGCTGGTTTTTG---CCGCAGGAGTTCACTTGGTGTCCATAAATCATGGTCTGC 5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**********     *** *********     **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cat              TTACAGCTGGGGCTGCCCTGAGTCGTCAGCGGGCTGTGCGCTGAGTGACAGATCCC 112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TACAGCTGGGGCTGCCCTGAGTCGTCAGTGGGCTGTGCGCTGAGTGACAGATCCC 112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ACAGCTGGGGCTGCCCTGAGTCGTCAGCGGGCTGTGTGCTGAGTGACAGGTCCC 112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TACAGCTGGGGCTGCCCTGAGTCGTCAGCGGGCTGTGCGCTGAGTGACAGATCCC 112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TACAGCTGAGGCTGCCCAGAGTAGTCAGCGG-CTGTTTGCTGAGTGACAGATCCC 111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TACAGCTGAGGCTGCCTGGAGTAGTCAGCGG-CTGTTCGCTGAGTGACAGATCCC 111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TACAGCTGAAGCTGCCCTGAGTCGTCAGTGAGCTGTACGCTGAATGACAGATCCC 112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TACAGCTGAAGCTGCCCTGAGTCGTCAGTGAGCTGTACGCTGAATGACAGATCCC 112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TACAGCTGAAGCTGCCCTGAGTCGTCAGTGAGCTGTACGCTGAGTGACAGATCCC 112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TACAGCCCAAGCTGCCCTCAGTCGTCAGCGGGCTGGACGTTGAGTGACAGATCCC 10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TACAGCTGAAGCTGCCCTGAGTCGTCAGCGAGGTGTACGCTGAGTGACAGATCCC 112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TACAGCTGAAACTGCCCTGAGTCATCAGCATGCTGGAAGCTGAGTGACAGATTCC 11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TACAGCTGAAACCACCCTTAGTCATCAACATGCAATACACTGAGTGACAGATTCC 9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TACAGCTCAAACAGCCCTGAGTCATCAACATGCAATAAGCTGAGTGACAGATTCC 11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ACAGCTGAAACTACCCTGAGTCATCAGCATGCAATAAGCAGACTGACAGATTCC 11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ACAGCTGAAACTACCCTGAGTCATCAACATGCAGTAAGCAGACTGACAGATTCC 10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ACAGCCAGAACTACCCTGAGTCATCATCGTGCAATAAGCTGAGTGGCAGAT--- 10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TACAGCTGAAACTGCACTGAGTCATCAACATGCAATAAGCTGAGTGACAGATCCC 97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TTACAGCTGAAACTGCACTGAGTCATCAACATGCAATAAGCTGAGTGACAGATTCC 112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ACAGCTGAAACTGCACTGAGTCATCAACATGCAATAAGCTGAGTGACAGATTCC 11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     *  *    ***  ***              ** ** *** * </a:t>
            </a:r>
          </a:p>
        </p:txBody>
      </p:sp>
      <p:sp>
        <p:nvSpPr>
          <p:cNvPr id="7" name="Rectangle 6"/>
          <p:cNvSpPr/>
          <p:nvPr/>
        </p:nvSpPr>
        <p:spPr>
          <a:xfrm>
            <a:off x="5854700" y="872066"/>
            <a:ext cx="952500" cy="38721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44700" y="525217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6134324" y="5638800"/>
            <a:ext cx="558800" cy="3898900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44700" y="1011376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503.10196 </a:t>
            </a:r>
          </a:p>
        </p:txBody>
      </p:sp>
      <p:sp>
        <p:nvSpPr>
          <p:cNvPr id="18" name="Left Arrow 17"/>
          <p:cNvSpPr/>
          <p:nvPr/>
        </p:nvSpPr>
        <p:spPr>
          <a:xfrm>
            <a:off x="5854700" y="5103588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Arrow 22"/>
          <p:cNvSpPr/>
          <p:nvPr/>
        </p:nvSpPr>
        <p:spPr>
          <a:xfrm>
            <a:off x="2044924" y="9970255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2044924" y="5638800"/>
            <a:ext cx="558800" cy="3898900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Arrow 16"/>
          <p:cNvSpPr/>
          <p:nvPr/>
        </p:nvSpPr>
        <p:spPr>
          <a:xfrm>
            <a:off x="6134324" y="9979145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110133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dog              TGGCACAA--AACTCAC-TCAATAAATCATGTTCAAACACATGCCTGTAATGACAGGTAA 23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GCACAA--AACTCAC-TCAATAAATCATGTTCAAACACATGCCTGTAATGACAAGTAA 23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GCACAA--AGCTCAC-TCAATAAATCATGTCCC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GCACAA--AACTCAC-TCAATAAATCATGTTCAAACACATGCCTGC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GCACAA--AACTCAC-TCAATAAATCATGTTCAAACACATGCCTGTAATGACAGGTAA 23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GCACAA--AACTCAC-TCAATAAATCATGTTCAAACACATGCCTCTAATGACAGGTAA 23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GGCACCAGGCGGTCGC-TCTATAAATCACACTCGTACACATGCCCCCAATGACAGCTAA 23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GCACCAGGCGGTCGC-TCTATAAATCATGCTCGTACACATGCCCCCAATGACAGCTAA 237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GCACCAGGCAGGCG--TCTATAAATCACGCTCGAACACATGCCCCCAATGACAGCTAA 23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GCACAAGTAAAGCGC-TCTTTAAATCACATCGATCCCCAAGCCGCCAATGACAGCTAA 23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GCAC--GGAGAGCGAGTCTATAAATCATGTTGAAACACATGCCCCCAATGACAGCTAA 235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****        *   **  *******        * ** ***   *******  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703.10876</a:t>
            </a:r>
          </a:p>
        </p:txBody>
      </p:sp>
      <p:sp>
        <p:nvSpPr>
          <p:cNvPr id="7" name="Rectangle 6"/>
          <p:cNvSpPr/>
          <p:nvPr/>
        </p:nvSpPr>
        <p:spPr>
          <a:xfrm>
            <a:off x="3733506" y="872066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3751752" y="61157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609546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6609546" y="612086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3607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elephant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CAGACCACCCCTCCGTCCAATGTTGACAGTG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ACG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CG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CG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CGGACCACCCCTCAGTCCAATGTTGACAGTACATGATATTCCATTAATCTGCCTAATG 16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ACG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ACAGACCACCCCTCAGCCCAATGTTGACAGTACATGATATTCCATTAATCTGCCTAATG 17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CAGACCACCCCTCAGTCCAATGTTGACAGTACATGATATTCCATTAATCTGCCTAATG 16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CAGACCACCCCTCAGC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CAGACCACCCCTCAGTCCAATGTTGACAGTACATGATATTCCATTAATCTGCCTAATG 16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ACAGACCACCCCTCAGTCCAATGTTGACAGTACATGATATTCCATTAATCTGCCTAATG 16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ACACACCACCCCTCAGTCCAGTGTTGACAGTACATGATATTCCATTAATCTGCCTAATG 17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ACACACCACCCCTCAGTCCAGTGTTGACAGTACATGATATTCCATTAATCTGCCTAATG 11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ACACACCACCCCTCGGTCCAGTGTTGACAGTACATGATATTCCATTAATCTGCCTAATG 17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ACACACCACCCCTCGGTCCACTGTTGACAGTACATGATATTCCATTAATCTGCCTAATG 112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CAGGACATAACTCAGCTCCGTGTTGACAGAACCTGATATTCCATTAATCTGCCTAATG 121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**    **   *** *  *  *********  * ***************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19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EMX2.4548</a:t>
            </a:r>
          </a:p>
        </p:txBody>
      </p:sp>
      <p:sp>
        <p:nvSpPr>
          <p:cNvPr id="7" name="Rectangle 6"/>
          <p:cNvSpPr/>
          <p:nvPr/>
        </p:nvSpPr>
        <p:spPr>
          <a:xfrm>
            <a:off x="5854406" y="872067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8427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5854406" y="5692136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4336246" y="5692136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336246" y="872067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086382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dog              AAATGTGTTTTTAGGACTGTCAGAGTGATTAATGAGGGCTAGCCG-TCT-TTGCAAA--- 5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AATGTGTTTTTAGGACTGTCAGAGTGATTAATGAGA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ATGTGTTTTTAGGACTGTCAGAGTGATTAATGAGGGCTAGCCG-TCT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ATGTGTTTTTAGGACTGTCAGAGTGATTAATGAGGGTTAGCAA-TCC-TTGCAAA--- 55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AATGTGTTTTTAGGGCTGTCAGAGTGATTAATGAGGGTCAGCAA-TGC-TTGAAAAAAA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ATGTGTTTTTCAGGCTGTCAAGATGATTAATGGGTGAGAGCAAATCC-TCACAAA---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AATGTGTTTTTCAGGCTGTCAAGATGATTAATGGGTGAGAGCAAATCC-TCACAAA--- 5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AATGTGTTTTTCAAGCTGTCAAGATGATTAATGGCTGAGAGCAAATCCCTCACAAA--- 5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AATGTGTTTTTCAAGCTGTCAAGATGATTAATGACTGAGAGCAAATCC-TCACAAA--- 5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ATGTGTTTTTCAAACTGTCAAGATGATTAATGAGGGGGAGCAAATCC-TCACAAA--- 5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    ******   *********   *  ***   *   *   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703.10897</a:t>
            </a:r>
          </a:p>
        </p:txBody>
      </p:sp>
      <p:sp>
        <p:nvSpPr>
          <p:cNvPr id="7" name="Rectangle 6"/>
          <p:cNvSpPr/>
          <p:nvPr/>
        </p:nvSpPr>
        <p:spPr>
          <a:xfrm>
            <a:off x="4285956" y="887175"/>
            <a:ext cx="952500" cy="450920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3485346" y="872067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/>
          <p:cNvSpPr/>
          <p:nvPr/>
        </p:nvSpPr>
        <p:spPr>
          <a:xfrm>
            <a:off x="4285956" y="611578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>
            <a:off x="3485346" y="61157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514830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0" y="0"/>
            <a:ext cx="9144000" cy="113157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664854" cy="9694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ow     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TTCCACTTCCATTCGCAACTGTCAGGCGGGTGATTAATGACCAACAGGTTTGGAATCGC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TTCCACTTCCATTCGC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TTCCACTTCCATTCGCAACTGTCAA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TTCCACTTCCATTCGCAACTGTCAGGCGA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TTCCACTTCCATTCGAAACTGTCAGGCGGGTGATTAATGACCAACAGGTTTGGAGTCGC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TTCCACTTCCATTTGA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TTCCACTTCCATTCGAAACTGTCAGGA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TTCCAGCGCCATTCGAAACTGTCAGGCGGGTGATTAATGACCAACAGGTTTGGAATCGC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-------------------------GTGATTAATGACCAACTGCCTCGGAATTGG 3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TTCCACCTCTATTCACAACTGTCAGGC-AGTGATTAATGGCCAACAGGCTCGAAATTGC 5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-------------------TGTCATGGAAATGATTAATGGCCAACAGGCTCCAAATTAC 4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TCCCAGCTTGTCAGGCAGCTGTCGAG-AATTGATTTATGACCACTAGACTCCAACCTGT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TCCCAGCTTGTCGGGCGGCTGTCGAG-GAGTGATTTATGACCACCAGACTCCGACCTG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TCCCAGCTTGTCAGGCAGCTGTCGGG-GAGTGATTTATGACCACTGGACTCCAACCTG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TCCCAGCTTGTCAGGCAGCTGTCGGG-G-GTGATTTATGACCACCGGACTCCAACCTGT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----TGTCAGTGAGCTGTCAGA-GTGTGATTTATGGTTGTGAGACTCACAGCAGT 5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                   ***** ***       *  *   *     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cow              CTTT-ATTGCCAGATCAGTATTGTT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TT-ATTGCCAGATCAGTATTGTC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TT-ATTGCCAGATCAGTATTGTT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TT-ATTGCCAGATCAGTATTGTT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CT-ATTGCCAGATCAGTATTGTTGCCCC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CT-ATTGCCAGATCAGTATTGTTGCCCC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CT-ATTGCCAGATCAGTATTGTTGCCCGTGACAGCTAATGAGGTTGGA---------- 10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TT-ATTGCCAGATCAGTATTGTTGCCCATGACAGCTAATGAGGTTGGACAGGCTTCTC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TT-ATTGCCAGATCAGTATTGTTGCCT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TT-ATTGCCAGATCAGTATTGTT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TT-ATTGCCAGATCAGTATTGTT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TTTATTGCCAGATCAGTATTGTTGCCCGTGACAGCTAATGAGGTTGGACAGGCTTCTC 12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TTTATTGCCAGATCAGTATTGTTGCCCGTGACAGCTAATGAGGTTGGACAGGCTTCTC 12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TT-ATTGCCAGATCAGTATTGTT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TT-ATTGCCAGATCAGTATTGTTGCCCGTGACAGCTAATGAGGTTGGACAGGCTTCTC 119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TTT-ATACTCAACTCCGCATTGTTTGCGCTGACAGTTAATGAGGTTAGACATACTT--- 8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TT-ATTGCCAGCTTGGTATTGTTACTTGTGACAGCTAATGAGGTTGGACAGACTTTTA 118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TC-ATTGTCAGCTCTGTATTGTTAGTTCTGACAACTAATGAGGTCCGACAG------- 9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TC-ACTGCCAGTTTGGTATTGTTGCAACTGACAGCTAATGAGGCCAGACATGCTTTCA 11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TC-ACTGCCAGTTCGCCATTGTTACAGCTGACAGCTAATGAGGCCAGACATGCTTTCA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TC-ACTGCCAGCTCAGTATTGTTACAACTGACAGCTAATGAGGCCAGACATGCTTTCA 11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TTC-GCTGCCAGCTCAGTATTGTTACAACTGACAGCTAATGAGGCCAGACATGCTTTCA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CTT-GCTGCCAGTTCAGTATTGTTACAACTGACATCTAATGAGGCCAGACGTGCTTTCA 10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        **  *    *****      *****  ********   ** </a:t>
            </a:r>
          </a:p>
        </p:txBody>
      </p:sp>
      <p:sp>
        <p:nvSpPr>
          <p:cNvPr id="7" name="Rectangle 6"/>
          <p:cNvSpPr/>
          <p:nvPr/>
        </p:nvSpPr>
        <p:spPr>
          <a:xfrm>
            <a:off x="4838700" y="872066"/>
            <a:ext cx="952500" cy="446893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25650" y="569279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4762500" y="6007100"/>
            <a:ext cx="558800" cy="4449565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44476" y="1074876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ight Arrow 18"/>
          <p:cNvSpPr/>
          <p:nvPr/>
        </p:nvSpPr>
        <p:spPr>
          <a:xfrm>
            <a:off x="4838700" y="554928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Arrow 20"/>
          <p:cNvSpPr/>
          <p:nvPr/>
        </p:nvSpPr>
        <p:spPr>
          <a:xfrm>
            <a:off x="4762500" y="10605255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378748" y="138668"/>
            <a:ext cx="2762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ZNF703.10936</a:t>
            </a:r>
          </a:p>
        </p:txBody>
      </p:sp>
    </p:spTree>
    <p:extLst>
      <p:ext uri="{BB962C8B-B14F-4D97-AF65-F5344CB8AC3E}">
        <p14:creationId xmlns:p14="http://schemas.microsoft.com/office/powerpoint/2010/main" val="34713329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37856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orse            ATGGGGACTTGTCCATCTATCACTCCTAATTGACACTAAATGATCTGTCAGTTTATTGA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TGGGGACTTGTCCATCTATCACTCCTAATTGACACTAAATGATCTGTCAGTTTATTGAT 11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TGGGGACTTGTCC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ATGGGGACTTGTCCATCTATCACTCCTAATTGACACTAAATGATCTGTCAGTTTATTGA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CCAGGATTTGTCGATCTATCACTTCTAATTGACACTAAATGATCTGTCAGTTTATTGAT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CCAGGATTTGTCGATCTATCACTTCTAATTGACACTAAACGATCTGTCAGTTTATTGAT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CCAGGATTTGTAGATCTATCACTTGTAATTGACACTAAATGATCTGTCAGTTTATTGAT 11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CCGGGATTTGTCGATCTATCACTTCTAATTGACACTAAATGATCTGTCAGTTTATTGAT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CCGGGATTTGCAGATCTATCACTCCTAATTGACACTAAATGATCTGTCAGTTTATTGAT 12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*** ***   **********  ************** *************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2467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EDICTED: ESRRB.9004</a:t>
            </a:r>
          </a:p>
        </p:txBody>
      </p:sp>
      <p:sp>
        <p:nvSpPr>
          <p:cNvPr id="7" name="Rectangle 6"/>
          <p:cNvSpPr/>
          <p:nvPr/>
        </p:nvSpPr>
        <p:spPr>
          <a:xfrm>
            <a:off x="3117556" y="872066"/>
            <a:ext cx="952500" cy="378565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62618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Left Arrow 16"/>
          <p:cNvSpPr/>
          <p:nvPr/>
        </p:nvSpPr>
        <p:spPr>
          <a:xfrm>
            <a:off x="3117556" y="611578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6038046" y="611578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038046" y="872066"/>
            <a:ext cx="558800" cy="378565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366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55</TotalTime>
  <Words>19325</Words>
  <Application>Microsoft Macintosh PowerPoint</Application>
  <PresentationFormat>On-screen Show (4:3)</PresentationFormat>
  <Paragraphs>2699</Paragraphs>
  <Slides>81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1</vt:i4>
      </vt:variant>
    </vt:vector>
  </HeadingPairs>
  <TitlesOfParts>
    <vt:vector size="8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ationl Institute for Medical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Grice</dc:creator>
  <cp:lastModifiedBy>Joseph Grice</cp:lastModifiedBy>
  <cp:revision>197</cp:revision>
  <dcterms:created xsi:type="dcterms:W3CDTF">2013-01-11T11:22:56Z</dcterms:created>
  <dcterms:modified xsi:type="dcterms:W3CDTF">2014-10-03T11:39:59Z</dcterms:modified>
</cp:coreProperties>
</file>